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xlsx" ContentType="application/vnd.openxmlformats-officedocument.spreadsheetml.sheet"/>
  <Default Extension="wdp" ContentType="image/vnd.ms-photo"/>
  <Default Extension="tif" ContentType="image/tiff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1.xml" ContentType="application/vnd.openxmlformats-officedocument.presentationml.notesSlide+xml"/>
  <Override PartName="/ppt/charts/chart19.xml" ContentType="application/vnd.openxmlformats-officedocument.drawingml.chart+xml"/>
  <Override PartName="/ppt/drawings/drawing1.xml" ContentType="application/vnd.openxmlformats-officedocument.drawingml.chartshapes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theme/themeOverride1.xml" ContentType="application/vnd.openxmlformats-officedocument.themeOverride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3" r:id="rId2"/>
    <p:sldId id="275" r:id="rId3"/>
    <p:sldId id="267" r:id="rId4"/>
    <p:sldId id="274" r:id="rId5"/>
    <p:sldId id="276" r:id="rId6"/>
    <p:sldId id="271" r:id="rId7"/>
    <p:sldId id="272" r:id="rId8"/>
    <p:sldId id="268" r:id="rId9"/>
    <p:sldId id="277" r:id="rId10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2"/>
    <p:restoredTop sz="94660"/>
  </p:normalViewPr>
  <p:slideViewPr>
    <p:cSldViewPr>
      <p:cViewPr>
        <p:scale>
          <a:sx n="170" d="100"/>
          <a:sy n="170" d="100"/>
        </p:scale>
        <p:origin x="536" y="-2704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quantification%20for%20qRT-PCR%20akita%20het%20and%20akita%20WT%20-isle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insulin%20&amp;%20glucagon%20&amp;%20Caspase3\caspase%203%20number%20of%20cell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package" Target="../embeddings/Microsoft_Excel_Worksheet5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7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file:////C:\Users\oherleap\Desktop\Oana-results\9.%20STF-akita%20mice\IPGTT,%20IPITT%20akita%20mice%20treated%20with%204u8c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package" Target="../embeddings/Microsoft_Excel_Worksheet11.xlsx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quantification%20for%20qRT-PCR%20akita%20het%20and%20akita%20WT%20-islet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akita%20paper%20figures\Figures\3\Fig%203.%20quantification%20for%20qRT-PCR%20akita%204u8c%20and%20akita%20vehicle-islets-12.18.18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akita%20paper%20figures\Figures\3\Fig%203.%20quantification%20for%20qRT-PCR%20akita%204u8c%20and%20akita%20vehicle-islets-12.18.18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oherleap\Desktop\Oana-results\9.%20STF-akita%20mice\akita%20paper%20figures\Figures\3\Fig%203.%20quantification%20for%20qRT-PCR%20akita%204u8c%20and%20akita%20vehicle-islets-12.18.18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5.xlsx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package" Target="../embeddings/Microsoft_Excel_Worksheet16.xlsx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7.xlsx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8.xlsx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9.xlsx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package" Target="../embeddings/Microsoft_Excel_Worksheet1.xlsx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C:\Users\oherleap\Desktop\Oana-results\9.%20STF-akita%20mice\quantification%20for%20qRT-PCR%20akita%20het%20and%20akita%20WT%20-isle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package" Target="../embeddings/Microsoft_Excel_Worksheet2.xlsx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C:\Users\oherleap\Desktop\Oana-results\9.%20STF-akita%20mice\quantification%20for%20qRT-PCR%20akita%20het%20and%20akita%20WT%20-isle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17167541557305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651128592"/>
        <c:axId val="749784544"/>
      </c:barChart>
      <c:catAx>
        <c:axId val="651128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9784544"/>
        <c:crosses val="autoZero"/>
        <c:auto val="1"/>
        <c:lblAlgn val="ctr"/>
        <c:lblOffset val="100"/>
        <c:noMultiLvlLbl val="0"/>
      </c:catAx>
      <c:valAx>
        <c:axId val="749784544"/>
        <c:scaling>
          <c:orientation val="minMax"/>
          <c:max val="15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1128592"/>
        <c:crosses val="autoZero"/>
        <c:crossBetween val="between"/>
        <c:majorUnit val="5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3092738407699"/>
          <c:y val="0.0667362933799942"/>
          <c:w val="0.904403449568804"/>
          <c:h val="0.6982677165354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l 3 experim'!$T$2</c:f>
              <c:strCache>
                <c:ptCount val="1"/>
                <c:pt idx="0">
                  <c:v>caspase 3positive 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ll 3 experim'!$V$3:$V$6</c:f>
                <c:numCache>
                  <c:formatCode>General</c:formatCode>
                  <c:ptCount val="4"/>
                  <c:pt idx="0">
                    <c:v>0.0803249944086238</c:v>
                  </c:pt>
                  <c:pt idx="1">
                    <c:v>0.653500723153502</c:v>
                  </c:pt>
                  <c:pt idx="2">
                    <c:v>0.331893303346758</c:v>
                  </c:pt>
                </c:numCache>
              </c:numRef>
            </c:plus>
            <c:minus>
              <c:numRef>
                <c:f>'all 3 experim'!$V$3:$V$6</c:f>
                <c:numCache>
                  <c:formatCode>General</c:formatCode>
                  <c:ptCount val="4"/>
                  <c:pt idx="0">
                    <c:v>0.0803249944086238</c:v>
                  </c:pt>
                  <c:pt idx="1">
                    <c:v>0.653500723153502</c:v>
                  </c:pt>
                  <c:pt idx="2">
                    <c:v>0.33189330334675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all 3 experim'!$R$3:$R$5</c:f>
              <c:strCache>
                <c:ptCount val="3"/>
                <c:pt idx="0">
                  <c:v>WT</c:v>
                </c:pt>
                <c:pt idx="1">
                  <c:v>Akita-Vehicle</c:v>
                </c:pt>
                <c:pt idx="2">
                  <c:v>Akita-STF</c:v>
                </c:pt>
              </c:strCache>
            </c:strRef>
          </c:cat>
          <c:val>
            <c:numRef>
              <c:f>'all 3 experim'!$T$3:$T$5</c:f>
              <c:numCache>
                <c:formatCode>General</c:formatCode>
                <c:ptCount val="3"/>
                <c:pt idx="0">
                  <c:v>0.834326579261025</c:v>
                </c:pt>
                <c:pt idx="1">
                  <c:v>6.120651695288418</c:v>
                </c:pt>
                <c:pt idx="2">
                  <c:v>1.3193812556869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2D3-4AF1-A179-C459F76646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0229408"/>
        <c:axId val="950213104"/>
      </c:barChart>
      <c:catAx>
        <c:axId val="950229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213104"/>
        <c:crosses val="autoZero"/>
        <c:auto val="1"/>
        <c:lblAlgn val="ctr"/>
        <c:lblOffset val="100"/>
        <c:noMultiLvlLbl val="0"/>
      </c:catAx>
      <c:valAx>
        <c:axId val="950213104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229408"/>
        <c:crosses val="autoZero"/>
        <c:crossBetween val="between"/>
        <c:majorUnit val="2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3092738407699"/>
          <c:y val="0.0667362933799942"/>
          <c:w val="0.903573928258967"/>
          <c:h val="0.7347007144940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l 3 experim'!$N$2</c:f>
              <c:strCache>
                <c:ptCount val="1"/>
                <c:pt idx="0">
                  <c:v>insuli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ll 3 experim'!$O$3:$O$4</c:f>
                <c:numCache>
                  <c:formatCode>General</c:formatCode>
                  <c:ptCount val="2"/>
                  <c:pt idx="0">
                    <c:v>0.120104539581038</c:v>
                  </c:pt>
                  <c:pt idx="1">
                    <c:v>0.290465430850581</c:v>
                  </c:pt>
                </c:numCache>
              </c:numRef>
            </c:plus>
            <c:minus>
              <c:numRef>
                <c:f>'all 3 experim'!$O$3:$O$4</c:f>
                <c:numCache>
                  <c:formatCode>General</c:formatCode>
                  <c:ptCount val="2"/>
                  <c:pt idx="0">
                    <c:v>0.120104539581038</c:v>
                  </c:pt>
                  <c:pt idx="1">
                    <c:v>0.290465430850581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all 3 experim'!$L$3:$M$4</c:f>
              <c:strCache>
                <c:ptCount val="2"/>
                <c:pt idx="0">
                  <c:v>Akita-Vehicle</c:v>
                </c:pt>
                <c:pt idx="1">
                  <c:v>Akita-STF</c:v>
                </c:pt>
              </c:strCache>
            </c:strRef>
          </c:cat>
          <c:val>
            <c:numRef>
              <c:f>'all 3 experim'!$N$3:$N$4</c:f>
              <c:numCache>
                <c:formatCode>General</c:formatCode>
                <c:ptCount val="2"/>
                <c:pt idx="0">
                  <c:v>0.823045267489712</c:v>
                </c:pt>
                <c:pt idx="1">
                  <c:v>0.723764957240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F29-49EC-9821-02009967FF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950157632"/>
        <c:axId val="950159952"/>
      </c:barChart>
      <c:catAx>
        <c:axId val="950157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159952"/>
        <c:crosses val="autoZero"/>
        <c:auto val="1"/>
        <c:lblAlgn val="ctr"/>
        <c:lblOffset val="100"/>
        <c:noMultiLvlLbl val="0"/>
      </c:catAx>
      <c:valAx>
        <c:axId val="950159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157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837429250723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p21 and Kir6.2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p21 and Kir6.2'!$W$3:$W$6</c:f>
                <c:numCache>
                  <c:formatCode>General</c:formatCode>
                  <c:ptCount val="4"/>
                  <c:pt idx="0">
                    <c:v>0.0554801969178911</c:v>
                  </c:pt>
                  <c:pt idx="1">
                    <c:v>0.0554801969178911</c:v>
                  </c:pt>
                  <c:pt idx="2">
                    <c:v>0.0554801969178911</c:v>
                  </c:pt>
                </c:numCache>
              </c:numRef>
            </c:plus>
            <c:minus>
              <c:numRef>
                <c:f>'akita islet qPCR-p21 and Kir6.2'!$W$3:$W$6</c:f>
                <c:numCache>
                  <c:formatCode>General</c:formatCode>
                  <c:ptCount val="4"/>
                  <c:pt idx="0">
                    <c:v>0.0554801969178911</c:v>
                  </c:pt>
                  <c:pt idx="1">
                    <c:v>0.0554801969178911</c:v>
                  </c:pt>
                  <c:pt idx="2">
                    <c:v>0.055480196917891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p21 and Kir6.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p21 and Kir6.2'!$T$4</c:f>
              <c:numCache>
                <c:formatCode>0.0</c:formatCode>
                <c:ptCount val="1"/>
                <c:pt idx="0">
                  <c:v>1.001537843643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E00-C947-958D-50F76EFA6FE7}"/>
            </c:ext>
          </c:extLst>
        </c:ser>
        <c:ser>
          <c:idx val="1"/>
          <c:order val="1"/>
          <c:tx>
            <c:strRef>
              <c:f>'akita islet qPCR-p21 and Kir6.2'!$U$2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p21 and Kir6.2'!$X$3:$X$6</c:f>
                <c:numCache>
                  <c:formatCode>General</c:formatCode>
                  <c:ptCount val="4"/>
                  <c:pt idx="0">
                    <c:v>0.251443334297958</c:v>
                  </c:pt>
                  <c:pt idx="1">
                    <c:v>0.130155232166199</c:v>
                  </c:pt>
                  <c:pt idx="2">
                    <c:v>0.142922525118488</c:v>
                  </c:pt>
                </c:numCache>
              </c:numRef>
            </c:plus>
            <c:minus>
              <c:numRef>
                <c:f>'akita islet qPCR-p21 and Kir6.2'!$X$3:$X$6</c:f>
                <c:numCache>
                  <c:formatCode>General</c:formatCode>
                  <c:ptCount val="4"/>
                  <c:pt idx="0">
                    <c:v>0.251443334297958</c:v>
                  </c:pt>
                  <c:pt idx="1">
                    <c:v>0.130155232166199</c:v>
                  </c:pt>
                  <c:pt idx="2">
                    <c:v>0.1429225251184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p21 and Kir6.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p21 and Kir6.2'!$U$4</c:f>
              <c:numCache>
                <c:formatCode>0.0</c:formatCode>
                <c:ptCount val="1"/>
                <c:pt idx="0">
                  <c:v>2.8907899389594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E00-C947-958D-50F76EFA6FE7}"/>
            </c:ext>
          </c:extLst>
        </c:ser>
        <c:ser>
          <c:idx val="2"/>
          <c:order val="2"/>
          <c:tx>
            <c:strRef>
              <c:f>'akita islet qPCR-p21 and Kir6.2'!$V$2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p21 and Kir6.2'!$Y$3:$Y$6</c:f>
                <c:numCache>
                  <c:formatCode>General</c:formatCode>
                  <c:ptCount val="4"/>
                  <c:pt idx="0">
                    <c:v>0.135792243310522</c:v>
                  </c:pt>
                  <c:pt idx="1">
                    <c:v>0.168342689624043</c:v>
                  </c:pt>
                  <c:pt idx="2">
                    <c:v>0.140580946429118</c:v>
                  </c:pt>
                </c:numCache>
              </c:numRef>
            </c:plus>
            <c:minus>
              <c:numRef>
                <c:f>'akita islet qPCR-p21 and Kir6.2'!$Y$3:$Y$6</c:f>
                <c:numCache>
                  <c:formatCode>General</c:formatCode>
                  <c:ptCount val="4"/>
                  <c:pt idx="0">
                    <c:v>0.135792243310522</c:v>
                  </c:pt>
                  <c:pt idx="1">
                    <c:v>0.168342689624043</c:v>
                  </c:pt>
                  <c:pt idx="2">
                    <c:v>0.14058094642911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p21 and Kir6.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p21 and Kir6.2'!$V$4</c:f>
              <c:numCache>
                <c:formatCode>0.0</c:formatCode>
                <c:ptCount val="1"/>
                <c:pt idx="0">
                  <c:v>1.2856298276962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E00-C947-958D-50F76EFA6F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78936544"/>
        <c:axId val="979133648"/>
      </c:barChart>
      <c:catAx>
        <c:axId val="978936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9133648"/>
        <c:crosses val="autoZero"/>
        <c:auto val="1"/>
        <c:lblAlgn val="ctr"/>
        <c:lblOffset val="100"/>
        <c:noMultiLvlLbl val="0"/>
      </c:catAx>
      <c:valAx>
        <c:axId val="979133648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8936544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63501544756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NOXA, P53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NOXA, P53'!$W$3:$W$6</c:f>
                <c:numCache>
                  <c:formatCode>General</c:formatCode>
                  <c:ptCount val="4"/>
                  <c:pt idx="0">
                    <c:v>0.0554801969178924</c:v>
                  </c:pt>
                  <c:pt idx="1">
                    <c:v>0.0554801969178924</c:v>
                  </c:pt>
                  <c:pt idx="2">
                    <c:v>0.0554801969178924</c:v>
                  </c:pt>
                </c:numCache>
              </c:numRef>
            </c:plus>
            <c:minus>
              <c:numRef>
                <c:f>'akita islet qPCR-NOXA, P53'!$W$3:$W$6</c:f>
                <c:numCache>
                  <c:formatCode>General</c:formatCode>
                  <c:ptCount val="4"/>
                  <c:pt idx="0">
                    <c:v>0.0554801969178924</c:v>
                  </c:pt>
                  <c:pt idx="1">
                    <c:v>0.0554801969178924</c:v>
                  </c:pt>
                  <c:pt idx="2">
                    <c:v>0.055480196917892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NOXA, P53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NOXA, P53'!$T$23</c:f>
              <c:numCache>
                <c:formatCode>0.0</c:formatCode>
                <c:ptCount val="1"/>
                <c:pt idx="0">
                  <c:v>1.0017361386432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707-2E47-BFDE-E1130314AEBF}"/>
            </c:ext>
          </c:extLst>
        </c:ser>
        <c:ser>
          <c:idx val="1"/>
          <c:order val="1"/>
          <c:tx>
            <c:strRef>
              <c:f>'akita islet qPCR-NOXA, P53'!$U$2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NOXA, P53'!$X$3:$X$6</c:f>
                <c:numCache>
                  <c:formatCode>General</c:formatCode>
                  <c:ptCount val="4"/>
                  <c:pt idx="0">
                    <c:v>0.0834559372811776</c:v>
                  </c:pt>
                  <c:pt idx="1">
                    <c:v>0.0431995022767545</c:v>
                  </c:pt>
                  <c:pt idx="2">
                    <c:v>0.0474370630092816</c:v>
                  </c:pt>
                </c:numCache>
              </c:numRef>
            </c:plus>
            <c:minus>
              <c:numRef>
                <c:f>'akita islet qPCR-NOXA, P53'!$X$3:$X$6</c:f>
                <c:numCache>
                  <c:formatCode>General</c:formatCode>
                  <c:ptCount val="4"/>
                  <c:pt idx="0">
                    <c:v>0.0834559372811776</c:v>
                  </c:pt>
                  <c:pt idx="1">
                    <c:v>0.0431995022767545</c:v>
                  </c:pt>
                  <c:pt idx="2">
                    <c:v>0.047437063009281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NOXA, P53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NOXA, P53'!$U$23</c:f>
              <c:numCache>
                <c:formatCode>0.0</c:formatCode>
                <c:ptCount val="1"/>
                <c:pt idx="0">
                  <c:v>1.3155824773834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707-2E47-BFDE-E1130314AEBF}"/>
            </c:ext>
          </c:extLst>
        </c:ser>
        <c:ser>
          <c:idx val="2"/>
          <c:order val="2"/>
          <c:tx>
            <c:strRef>
              <c:f>'akita islet qPCR-NOXA, P53'!$V$2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NOXA, P53'!$Y$3:$Y$6</c:f>
                <c:numCache>
                  <c:formatCode>General</c:formatCode>
                  <c:ptCount val="4"/>
                  <c:pt idx="0">
                    <c:v>0.0385804822570017</c:v>
                  </c:pt>
                  <c:pt idx="1">
                    <c:v>0.0478285209213648</c:v>
                  </c:pt>
                  <c:pt idx="2">
                    <c:v>0.0399410200255588</c:v>
                  </c:pt>
                </c:numCache>
              </c:numRef>
            </c:plus>
            <c:minus>
              <c:numRef>
                <c:f>'akita islet qPCR-NOXA, P53'!$Y$3:$Y$6</c:f>
                <c:numCache>
                  <c:formatCode>General</c:formatCode>
                  <c:ptCount val="4"/>
                  <c:pt idx="0">
                    <c:v>0.0385804822570017</c:v>
                  </c:pt>
                  <c:pt idx="1">
                    <c:v>0.0478285209213648</c:v>
                  </c:pt>
                  <c:pt idx="2">
                    <c:v>0.039941020025558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NOXA, P53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NOXA, P53'!$V$23</c:f>
              <c:numCache>
                <c:formatCode>0.0</c:formatCode>
                <c:ptCount val="1"/>
                <c:pt idx="0">
                  <c:v>0.8617324360262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707-2E47-BFDE-E1130314AE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666769552"/>
        <c:axId val="666772112"/>
      </c:barChart>
      <c:catAx>
        <c:axId val="666769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772112"/>
        <c:crosses val="autoZero"/>
        <c:auto val="1"/>
        <c:lblAlgn val="ctr"/>
        <c:lblOffset val="100"/>
        <c:noMultiLvlLbl val="0"/>
      </c:catAx>
      <c:valAx>
        <c:axId val="666772112"/>
        <c:scaling>
          <c:orientation val="minMax"/>
          <c:max val="2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76955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701229943522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Bax and Bak1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W$3:$W$6</c:f>
                <c:numCache>
                  <c:formatCode>General</c:formatCode>
                  <c:ptCount val="4"/>
                  <c:pt idx="0">
                    <c:v>0.0624237166196752</c:v>
                  </c:pt>
                  <c:pt idx="1">
                    <c:v>0.0624237166196752</c:v>
                  </c:pt>
                  <c:pt idx="2">
                    <c:v>0.0624237166196752</c:v>
                  </c:pt>
                </c:numCache>
              </c:numRef>
            </c:plus>
            <c:minus>
              <c:numRef>
                <c:f>'akita islet qPCR-Bax and Bak1'!$W$3:$W$6</c:f>
                <c:numCache>
                  <c:formatCode>General</c:formatCode>
                  <c:ptCount val="4"/>
                  <c:pt idx="0">
                    <c:v>0.0624237166196752</c:v>
                  </c:pt>
                  <c:pt idx="1">
                    <c:v>0.0624237166196752</c:v>
                  </c:pt>
                  <c:pt idx="2">
                    <c:v>0.062423716619675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4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T$4</c:f>
              <c:numCache>
                <c:formatCode>0.00</c:formatCode>
                <c:ptCount val="1"/>
                <c:pt idx="0">
                  <c:v>1.0019464658336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6E6-4C47-8E12-645BD531B98F}"/>
            </c:ext>
          </c:extLst>
        </c:ser>
        <c:ser>
          <c:idx val="1"/>
          <c:order val="1"/>
          <c:tx>
            <c:strRef>
              <c:f>'akita islet qPCR-Bax and Bak1'!$U$2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X$3:$X$6</c:f>
                <c:numCache>
                  <c:formatCode>General</c:formatCode>
                  <c:ptCount val="4"/>
                  <c:pt idx="0">
                    <c:v>0.163476877854659</c:v>
                  </c:pt>
                  <c:pt idx="1">
                    <c:v>0.0846209387510151</c:v>
                  </c:pt>
                  <c:pt idx="2">
                    <c:v>0.0929216447384038</c:v>
                  </c:pt>
                </c:numCache>
              </c:numRef>
            </c:plus>
            <c:minus>
              <c:numRef>
                <c:f>'akita islet qPCR-Bax and Bak1'!$X$3:$X$6</c:f>
                <c:numCache>
                  <c:formatCode>General</c:formatCode>
                  <c:ptCount val="4"/>
                  <c:pt idx="0">
                    <c:v>0.163476877854659</c:v>
                  </c:pt>
                  <c:pt idx="1">
                    <c:v>0.0846209387510151</c:v>
                  </c:pt>
                  <c:pt idx="2">
                    <c:v>0.092921644738403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4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U$4</c:f>
              <c:numCache>
                <c:formatCode>0.00</c:formatCode>
                <c:ptCount val="1"/>
                <c:pt idx="0">
                  <c:v>2.2207517548467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6E6-4C47-8E12-645BD531B98F}"/>
            </c:ext>
          </c:extLst>
        </c:ser>
        <c:ser>
          <c:idx val="2"/>
          <c:order val="2"/>
          <c:tx>
            <c:strRef>
              <c:f>'akita islet qPCR-Bax and Bak1'!$V$2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Y$3:$Y$6</c:f>
                <c:numCache>
                  <c:formatCode>General</c:formatCode>
                  <c:ptCount val="4"/>
                  <c:pt idx="0">
                    <c:v>0.0265998564782753</c:v>
                  </c:pt>
                  <c:pt idx="1">
                    <c:v>0.0329760468933897</c:v>
                  </c:pt>
                  <c:pt idx="2">
                    <c:v>0.0275378983911734</c:v>
                  </c:pt>
                </c:numCache>
              </c:numRef>
            </c:plus>
            <c:minus>
              <c:numRef>
                <c:f>'akita islet qPCR-Bax and Bak1'!$Y$3:$Y$6</c:f>
                <c:numCache>
                  <c:formatCode>General</c:formatCode>
                  <c:ptCount val="4"/>
                  <c:pt idx="0">
                    <c:v>0.0265998564782753</c:v>
                  </c:pt>
                  <c:pt idx="1">
                    <c:v>0.0329760468933897</c:v>
                  </c:pt>
                  <c:pt idx="2">
                    <c:v>0.027537898391173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4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V$4</c:f>
              <c:numCache>
                <c:formatCode>0.00</c:formatCode>
                <c:ptCount val="1"/>
                <c:pt idx="0">
                  <c:v>1.1896642307986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6E6-4C47-8E12-645BD531B9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3527072"/>
        <c:axId val="1112133952"/>
      </c:barChart>
      <c:catAx>
        <c:axId val="953527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2133952"/>
        <c:crosses val="autoZero"/>
        <c:auto val="1"/>
        <c:lblAlgn val="ctr"/>
        <c:lblOffset val="100"/>
        <c:noMultiLvlLbl val="0"/>
      </c:catAx>
      <c:valAx>
        <c:axId val="111213395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3527072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215882404287"/>
          <c:y val="0.0570602420342874"/>
          <c:w val="0.881550264531568"/>
          <c:h val="0.8563677883489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Bax and Bak1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W$3:$W$6</c:f>
                <c:numCache>
                  <c:formatCode>General</c:formatCode>
                  <c:ptCount val="4"/>
                  <c:pt idx="0">
                    <c:v>0.0624237166196752</c:v>
                  </c:pt>
                  <c:pt idx="1">
                    <c:v>0.0624237166196752</c:v>
                  </c:pt>
                  <c:pt idx="2">
                    <c:v>0.0624237166196752</c:v>
                  </c:pt>
                </c:numCache>
              </c:numRef>
            </c:plus>
            <c:minus>
              <c:numRef>
                <c:f>'akita islet qPCR-Bax and Bak1'!$W$3:$W$6</c:f>
                <c:numCache>
                  <c:formatCode>General</c:formatCode>
                  <c:ptCount val="4"/>
                  <c:pt idx="0">
                    <c:v>0.0624237166196752</c:v>
                  </c:pt>
                  <c:pt idx="1">
                    <c:v>0.0624237166196752</c:v>
                  </c:pt>
                  <c:pt idx="2">
                    <c:v>0.062423716619675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T$23</c:f>
              <c:numCache>
                <c:formatCode>0.0</c:formatCode>
                <c:ptCount val="1"/>
                <c:pt idx="0">
                  <c:v>1.0019464658336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385-6B49-80E3-2A9EFB3D0FD8}"/>
            </c:ext>
          </c:extLst>
        </c:ser>
        <c:ser>
          <c:idx val="1"/>
          <c:order val="1"/>
          <c:tx>
            <c:strRef>
              <c:f>'akita islet qPCR-Bax and Bak1'!$U$2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X$3:$X$6</c:f>
                <c:numCache>
                  <c:formatCode>General</c:formatCode>
                  <c:ptCount val="4"/>
                  <c:pt idx="0">
                    <c:v>0.163476877854659</c:v>
                  </c:pt>
                  <c:pt idx="1">
                    <c:v>0.0846209387510151</c:v>
                  </c:pt>
                  <c:pt idx="2">
                    <c:v>0.0929216447384038</c:v>
                  </c:pt>
                </c:numCache>
              </c:numRef>
            </c:plus>
            <c:minus>
              <c:numRef>
                <c:f>'akita islet qPCR-Bax and Bak1'!$X$3:$X$6</c:f>
                <c:numCache>
                  <c:formatCode>General</c:formatCode>
                  <c:ptCount val="4"/>
                  <c:pt idx="0">
                    <c:v>0.163476877854659</c:v>
                  </c:pt>
                  <c:pt idx="1">
                    <c:v>0.0846209387510151</c:v>
                  </c:pt>
                  <c:pt idx="2">
                    <c:v>0.092921644738403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U$23</c:f>
              <c:numCache>
                <c:formatCode>0.0</c:formatCode>
                <c:ptCount val="1"/>
                <c:pt idx="0">
                  <c:v>1.4007964235102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385-6B49-80E3-2A9EFB3D0FD8}"/>
            </c:ext>
          </c:extLst>
        </c:ser>
        <c:ser>
          <c:idx val="2"/>
          <c:order val="2"/>
          <c:tx>
            <c:strRef>
              <c:f>'akita islet qPCR-Bax and Bak1'!$V$2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Bax and Bak1'!$Y$3:$Y$6</c:f>
                <c:numCache>
                  <c:formatCode>General</c:formatCode>
                  <c:ptCount val="4"/>
                  <c:pt idx="0">
                    <c:v>0.0265998564782753</c:v>
                  </c:pt>
                  <c:pt idx="1">
                    <c:v>0.0329760468933897</c:v>
                  </c:pt>
                  <c:pt idx="2">
                    <c:v>0.0275378983911734</c:v>
                  </c:pt>
                </c:numCache>
              </c:numRef>
            </c:plus>
            <c:minus>
              <c:numRef>
                <c:f>'akita islet qPCR-Bax and Bak1'!$Y$3:$Y$6</c:f>
                <c:numCache>
                  <c:formatCode>General</c:formatCode>
                  <c:ptCount val="4"/>
                  <c:pt idx="0">
                    <c:v>0.0265998564782753</c:v>
                  </c:pt>
                  <c:pt idx="1">
                    <c:v>0.0329760468933897</c:v>
                  </c:pt>
                  <c:pt idx="2">
                    <c:v>0.027537898391173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Bax and Bak1'!$S$23</c:f>
              <c:numCache>
                <c:formatCode>General</c:formatCode>
                <c:ptCount val="1"/>
              </c:numCache>
            </c:numRef>
          </c:cat>
          <c:val>
            <c:numRef>
              <c:f>'akita islet qPCR-Bax and Bak1'!$V$23</c:f>
              <c:numCache>
                <c:formatCode>0.0</c:formatCode>
                <c:ptCount val="1"/>
                <c:pt idx="0">
                  <c:v>0.7876910004182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385-6B49-80E3-2A9EFB3D0F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666623504"/>
        <c:axId val="666626336"/>
      </c:barChart>
      <c:catAx>
        <c:axId val="666623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626336"/>
        <c:crosses val="autoZero"/>
        <c:auto val="1"/>
        <c:lblAlgn val="ctr"/>
        <c:lblOffset val="100"/>
        <c:noMultiLvlLbl val="0"/>
      </c:catAx>
      <c:valAx>
        <c:axId val="666626336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62350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13646705776728"/>
          <c:y val="0.89100027584404"/>
          <c:w val="0.890998152640304"/>
          <c:h val="0.0238369702749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INS1 and INS2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3EB-462D-8545-813354962AB8}"/>
              </c:ext>
            </c:extLst>
          </c:dPt>
          <c:errBars>
            <c:errBarType val="plus"/>
            <c:errValType val="cust"/>
            <c:noEndCap val="0"/>
            <c:plus>
              <c:numRef>
                <c:f>'akita islet qPCR-INS1 and INS2'!$W$3:$W$6</c:f>
                <c:numCache>
                  <c:formatCode>General</c:formatCode>
                  <c:ptCount val="4"/>
                  <c:pt idx="0">
                    <c:v>0.0311966811831468</c:v>
                  </c:pt>
                  <c:pt idx="1">
                    <c:v>0.0311966811831468</c:v>
                  </c:pt>
                  <c:pt idx="2">
                    <c:v>0.0311966811831468</c:v>
                  </c:pt>
                </c:numCache>
              </c:numRef>
            </c:plus>
            <c:minus>
              <c:numRef>
                <c:f>'akita islet qPCR-INS1 and INS2'!$W$3:$W$6</c:f>
                <c:numCache>
                  <c:formatCode>General</c:formatCode>
                  <c:ptCount val="4"/>
                  <c:pt idx="0">
                    <c:v>0.0311966811831468</c:v>
                  </c:pt>
                  <c:pt idx="1">
                    <c:v>0.0311966811831468</c:v>
                  </c:pt>
                  <c:pt idx="2">
                    <c:v>0.03119668118314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T$4</c:f>
              <c:numCache>
                <c:formatCode>0.00</c:formatCode>
                <c:ptCount val="1"/>
                <c:pt idx="0">
                  <c:v>1.0004864981182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3EB-462D-8545-813354962AB8}"/>
            </c:ext>
          </c:extLst>
        </c:ser>
        <c:ser>
          <c:idx val="1"/>
          <c:order val="1"/>
          <c:tx>
            <c:strRef>
              <c:f>'akita islet qPCR-INS1 and INS2'!$U$2</c:f>
              <c:strCache>
                <c:ptCount val="1"/>
                <c:pt idx="0">
                  <c:v>Akita-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INS1 and INS2'!$X$3:$X$6</c:f>
                <c:numCache>
                  <c:formatCode>General</c:formatCode>
                  <c:ptCount val="4"/>
                  <c:pt idx="0">
                    <c:v>0.0801848214143921</c:v>
                  </c:pt>
                  <c:pt idx="1">
                    <c:v>0.0415062665174025</c:v>
                  </c:pt>
                  <c:pt idx="2">
                    <c:v>0.0455777329898896</c:v>
                  </c:pt>
                </c:numCache>
              </c:numRef>
            </c:plus>
            <c:minus>
              <c:numRef>
                <c:f>'akita islet qPCR-INS1 and INS2'!$X$3:$X$6</c:f>
                <c:numCache>
                  <c:formatCode>General</c:formatCode>
                  <c:ptCount val="4"/>
                  <c:pt idx="0">
                    <c:v>0.0801848214143921</c:v>
                  </c:pt>
                  <c:pt idx="1">
                    <c:v>0.0415062665174025</c:v>
                  </c:pt>
                  <c:pt idx="2">
                    <c:v>0.04557773298988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U$4</c:f>
              <c:numCache>
                <c:formatCode>0.00</c:formatCode>
                <c:ptCount val="1"/>
                <c:pt idx="0">
                  <c:v>0.3169825454865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3EB-462D-8545-813354962AB8}"/>
            </c:ext>
          </c:extLst>
        </c:ser>
        <c:ser>
          <c:idx val="2"/>
          <c:order val="2"/>
          <c:tx>
            <c:strRef>
              <c:f>'akita islet qPCR-INS1 and INS2'!$V$2</c:f>
              <c:strCache>
                <c:ptCount val="1"/>
                <c:pt idx="0">
                  <c:v>Akita-STF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INS1 and INS2'!$Y$3:$Y$6</c:f>
                <c:numCache>
                  <c:formatCode>General</c:formatCode>
                  <c:ptCount val="4"/>
                  <c:pt idx="0">
                    <c:v>0.0325129551459309</c:v>
                  </c:pt>
                  <c:pt idx="1">
                    <c:v>0.0403065608421814</c:v>
                  </c:pt>
                  <c:pt idx="2">
                    <c:v>0.0336595220330104</c:v>
                  </c:pt>
                </c:numCache>
              </c:numRef>
            </c:plus>
            <c:minus>
              <c:numRef>
                <c:f>'akita islet qPCR-INS1 and INS2'!$Y$3:$Y$6</c:f>
                <c:numCache>
                  <c:formatCode>General</c:formatCode>
                  <c:ptCount val="4"/>
                  <c:pt idx="0">
                    <c:v>0.0325129551459309</c:v>
                  </c:pt>
                  <c:pt idx="1">
                    <c:v>0.0403065608421814</c:v>
                  </c:pt>
                  <c:pt idx="2">
                    <c:v>0.0336595220330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V$4</c:f>
              <c:numCache>
                <c:formatCode>0.00</c:formatCode>
                <c:ptCount val="1"/>
                <c:pt idx="0">
                  <c:v>1.0577862529448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3EB-462D-8545-813354962A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30"/>
        <c:axId val="666549696"/>
        <c:axId val="666807824"/>
      </c:barChart>
      <c:catAx>
        <c:axId val="66654969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66807824"/>
        <c:crosses val="autoZero"/>
        <c:auto val="1"/>
        <c:lblAlgn val="ctr"/>
        <c:lblOffset val="100"/>
        <c:noMultiLvlLbl val="0"/>
      </c:catAx>
      <c:valAx>
        <c:axId val="666807824"/>
        <c:scaling>
          <c:orientation val="minMax"/>
        </c:scaling>
        <c:delete val="1"/>
        <c:axPos val="l"/>
        <c:numFmt formatCode="0.00" sourceLinked="1"/>
        <c:majorTickMark val="out"/>
        <c:minorTickMark val="none"/>
        <c:tickLblPos val="nextTo"/>
        <c:crossAx val="666549696"/>
        <c:crosses val="autoZero"/>
        <c:crossBetween val="between"/>
      </c:valAx>
      <c:spPr>
        <a:solidFill>
          <a:schemeClr val="bg1"/>
        </a:solidFill>
        <a:ln>
          <a:solidFill>
            <a:schemeClr val="bg1"/>
          </a:solidFill>
        </a:ln>
        <a:effectLst/>
      </c:spPr>
    </c:plotArea>
    <c:legend>
      <c:legendPos val="r"/>
      <c:layout>
        <c:manualLayout>
          <c:xMode val="edge"/>
          <c:yMode val="edge"/>
          <c:x val="0.0223572083873225"/>
          <c:y val="0.0150215077282006"/>
          <c:w val="0.927189095694427"/>
          <c:h val="0.92852755989516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1"/>
          <c:order val="0"/>
          <c:tx>
            <c:strRef>
              <c:f>'Fig1 A-B (BW, BG)'!$AH$15</c:f>
              <c:strCache>
                <c:ptCount val="1"/>
                <c:pt idx="0">
                  <c:v>Vehicl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1 A-B (BW, BG)'!$AV$21:$BA$21</c:f>
                <c:numCache>
                  <c:formatCode>General</c:formatCode>
                  <c:ptCount val="6"/>
                  <c:pt idx="0">
                    <c:v>0.532877409291605</c:v>
                  </c:pt>
                  <c:pt idx="1">
                    <c:v>0.427200187265877</c:v>
                  </c:pt>
                  <c:pt idx="2">
                    <c:v>0.576994728456566</c:v>
                  </c:pt>
                  <c:pt idx="3">
                    <c:v>0.576994728456566</c:v>
                  </c:pt>
                  <c:pt idx="4">
                    <c:v>0.466368952654441</c:v>
                  </c:pt>
                  <c:pt idx="5">
                    <c:v>0.640800280898815</c:v>
                  </c:pt>
                </c:numCache>
              </c:numRef>
            </c:plus>
            <c:minus>
              <c:numRef>
                <c:f>'Fig1 A-B (BW, BG)'!$AV$21:$BA$21</c:f>
                <c:numCache>
                  <c:formatCode>General</c:formatCode>
                  <c:ptCount val="6"/>
                  <c:pt idx="0">
                    <c:v>0.532877409291605</c:v>
                  </c:pt>
                  <c:pt idx="1">
                    <c:v>0.427200187265877</c:v>
                  </c:pt>
                  <c:pt idx="2">
                    <c:v>0.576994728456566</c:v>
                  </c:pt>
                  <c:pt idx="3">
                    <c:v>0.576994728456566</c:v>
                  </c:pt>
                  <c:pt idx="4">
                    <c:v>0.466368952654441</c:v>
                  </c:pt>
                  <c:pt idx="5">
                    <c:v>0.6408002808988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ig1 A-B (BW, BG)'!$AV$4:$BA$4</c:f>
              <c:numCache>
                <c:formatCode>General</c:formatCode>
                <c:ptCount val="6"/>
                <c:pt idx="0">
                  <c:v>1.0</c:v>
                </c:pt>
                <c:pt idx="1">
                  <c:v>7.0</c:v>
                </c:pt>
                <c:pt idx="2">
                  <c:v>14.0</c:v>
                </c:pt>
                <c:pt idx="3">
                  <c:v>21.0</c:v>
                </c:pt>
                <c:pt idx="4">
                  <c:v>29.0</c:v>
                </c:pt>
                <c:pt idx="5">
                  <c:v>35.0</c:v>
                </c:pt>
              </c:numCache>
            </c:numRef>
          </c:xVal>
          <c:yVal>
            <c:numRef>
              <c:f>'Fig1 A-B (BW, BG)'!$AV$19:$BA$19</c:f>
              <c:numCache>
                <c:formatCode>0</c:formatCode>
                <c:ptCount val="6"/>
                <c:pt idx="0">
                  <c:v>17.475</c:v>
                </c:pt>
                <c:pt idx="1">
                  <c:v>17.65</c:v>
                </c:pt>
                <c:pt idx="2">
                  <c:v>18.5725</c:v>
                </c:pt>
                <c:pt idx="3">
                  <c:v>18.5725</c:v>
                </c:pt>
                <c:pt idx="4">
                  <c:v>18.95</c:v>
                </c:pt>
                <c:pt idx="5">
                  <c:v>19.8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D85-4C0D-8132-C112708AC7C6}"/>
            </c:ext>
          </c:extLst>
        </c:ser>
        <c:ser>
          <c:idx val="0"/>
          <c:order val="1"/>
          <c:tx>
            <c:strRef>
              <c:f>'Fig1 A-B (BW, BG)'!$AH$6</c:f>
              <c:strCache>
                <c:ptCount val="1"/>
                <c:pt idx="0">
                  <c:v>4µ8c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1 A-B (BW, BG)'!$AV$12:$BA$12</c:f>
                <c:numCache>
                  <c:formatCode>General</c:formatCode>
                  <c:ptCount val="6"/>
                  <c:pt idx="0">
                    <c:v>0.651280789419331</c:v>
                  </c:pt>
                  <c:pt idx="1">
                    <c:v>0.690862986898753</c:v>
                  </c:pt>
                  <c:pt idx="2">
                    <c:v>0.692068156566486</c:v>
                  </c:pt>
                  <c:pt idx="3">
                    <c:v>0.692068156566486</c:v>
                  </c:pt>
                  <c:pt idx="4">
                    <c:v>0.673918887305192</c:v>
                  </c:pt>
                  <c:pt idx="5">
                    <c:v>0.696867993238318</c:v>
                  </c:pt>
                </c:numCache>
              </c:numRef>
            </c:plus>
            <c:minus>
              <c:numRef>
                <c:f>'Fig1 A-B (BW, BG)'!$AV$12:$BA$12</c:f>
                <c:numCache>
                  <c:formatCode>General</c:formatCode>
                  <c:ptCount val="6"/>
                  <c:pt idx="0">
                    <c:v>0.651280789419331</c:v>
                  </c:pt>
                  <c:pt idx="1">
                    <c:v>0.690862986898753</c:v>
                  </c:pt>
                  <c:pt idx="2">
                    <c:v>0.692068156566486</c:v>
                  </c:pt>
                  <c:pt idx="3">
                    <c:v>0.692068156566486</c:v>
                  </c:pt>
                  <c:pt idx="4">
                    <c:v>0.673918887305192</c:v>
                  </c:pt>
                  <c:pt idx="5">
                    <c:v>0.6968679932383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ig1 A-B (BW, BG)'!$AV$4:$BA$4</c:f>
              <c:numCache>
                <c:formatCode>General</c:formatCode>
                <c:ptCount val="6"/>
                <c:pt idx="0">
                  <c:v>1.0</c:v>
                </c:pt>
                <c:pt idx="1">
                  <c:v>7.0</c:v>
                </c:pt>
                <c:pt idx="2">
                  <c:v>14.0</c:v>
                </c:pt>
                <c:pt idx="3">
                  <c:v>21.0</c:v>
                </c:pt>
                <c:pt idx="4">
                  <c:v>29.0</c:v>
                </c:pt>
                <c:pt idx="5">
                  <c:v>35.0</c:v>
                </c:pt>
              </c:numCache>
            </c:numRef>
          </c:xVal>
          <c:yVal>
            <c:numRef>
              <c:f>'Fig1 A-B (BW, BG)'!$AW$10:$BA$10</c:f>
              <c:numCache>
                <c:formatCode>0</c:formatCode>
                <c:ptCount val="5"/>
                <c:pt idx="0">
                  <c:v>17.525</c:v>
                </c:pt>
                <c:pt idx="1">
                  <c:v>17.975</c:v>
                </c:pt>
                <c:pt idx="2">
                  <c:v>17.975</c:v>
                </c:pt>
                <c:pt idx="3">
                  <c:v>18.25</c:v>
                </c:pt>
                <c:pt idx="4">
                  <c:v>18.6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D85-4C0D-8132-C112708AC7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6804288"/>
        <c:axId val="666672144"/>
      </c:scatterChart>
      <c:valAx>
        <c:axId val="666804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672144"/>
        <c:crosses val="autoZero"/>
        <c:crossBetween val="midCat"/>
        <c:majorUnit val="10.0"/>
      </c:valAx>
      <c:valAx>
        <c:axId val="666672144"/>
        <c:scaling>
          <c:orientation val="minMax"/>
          <c:max val="25.0"/>
          <c:min val="0.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8042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2597591691451"/>
          <c:y val="0.3610583238792"/>
          <c:w val="0.388167872158106"/>
          <c:h val="0.2066657787312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26626168561"/>
          <c:y val="0.0270473680822833"/>
          <c:w val="0.77649099920901"/>
          <c:h val="0.8423850540171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pct7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6CD-4313-ABCD-7257B78A8CA6}"/>
              </c:ext>
            </c:extLst>
          </c:dPt>
          <c:errBars>
            <c:errBarType val="plus"/>
            <c:errValType val="cust"/>
            <c:noEndCap val="0"/>
            <c:plus>
              <c:numRef>
                <c:f>'pancreass ins content'!$P$28:$Q$28</c:f>
                <c:numCache>
                  <c:formatCode>General</c:formatCode>
                  <c:ptCount val="2"/>
                  <c:pt idx="0">
                    <c:v>15.66684900985685</c:v>
                  </c:pt>
                  <c:pt idx="1">
                    <c:v>31.43971342188648</c:v>
                  </c:pt>
                </c:numCache>
              </c:numRef>
            </c:plus>
            <c:minus>
              <c:numRef>
                <c:f>'pancreass ins content'!$P$28:$Q$28</c:f>
                <c:numCache>
                  <c:formatCode>General</c:formatCode>
                  <c:ptCount val="2"/>
                  <c:pt idx="0">
                    <c:v>15.66684900985685</c:v>
                  </c:pt>
                  <c:pt idx="1">
                    <c:v>31.4397134218864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ancreass ins content'!$P$20:$Q$20</c:f>
              <c:strCache>
                <c:ptCount val="2"/>
                <c:pt idx="0">
                  <c:v>Akita-Vehicle</c:v>
                </c:pt>
                <c:pt idx="1">
                  <c:v>Akita-4µ8C</c:v>
                </c:pt>
              </c:strCache>
            </c:strRef>
          </c:cat>
          <c:val>
            <c:numRef>
              <c:f>'pancreass ins content'!$P$27:$Q$27</c:f>
              <c:numCache>
                <c:formatCode>0</c:formatCode>
                <c:ptCount val="2"/>
                <c:pt idx="0">
                  <c:v>70.85721077660185</c:v>
                </c:pt>
                <c:pt idx="1">
                  <c:v>156.00061447660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6CD-4313-ABCD-7257B78A8C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112193968"/>
        <c:axId val="1112196288"/>
      </c:barChart>
      <c:catAx>
        <c:axId val="1112193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2196288"/>
        <c:crosses val="autoZero"/>
        <c:auto val="1"/>
        <c:lblAlgn val="ctr"/>
        <c:lblOffset val="100"/>
        <c:noMultiLvlLbl val="0"/>
      </c:catAx>
      <c:valAx>
        <c:axId val="1112196288"/>
        <c:scaling>
          <c:orientation val="minMax"/>
          <c:max val="200.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2193968"/>
        <c:crosses val="autoZero"/>
        <c:crossBetween val="between"/>
        <c:majorUnit val="5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517021776747"/>
          <c:y val="0.057060370327065"/>
          <c:w val="0.890998152640304"/>
          <c:h val="0.809760134149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6</c:f>
              <c:numCache>
                <c:formatCode>0.0</c:formatCode>
                <c:ptCount val="1"/>
                <c:pt idx="0">
                  <c:v>1.014702121547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5D9-134F-B9C2-09583EA5BE0A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6:$Y$6</c:f>
                <c:numCache>
                  <c:formatCode>General</c:formatCode>
                  <c:ptCount val="3"/>
                  <c:pt idx="0">
                    <c:v>0.172105768271987</c:v>
                  </c:pt>
                  <c:pt idx="1">
                    <c:v>0.0733891111071049</c:v>
                  </c:pt>
                  <c:pt idx="2">
                    <c:v>0.0733891111071049</c:v>
                  </c:pt>
                </c:numCache>
              </c:numRef>
            </c:plus>
            <c:minus>
              <c:numRef>
                <c:f>'Fig 3. akita islet qPCR-4u8C'!$W$6:$Y$6</c:f>
                <c:numCache>
                  <c:formatCode>General</c:formatCode>
                  <c:ptCount val="3"/>
                  <c:pt idx="0">
                    <c:v>0.172105768271987</c:v>
                  </c:pt>
                  <c:pt idx="1">
                    <c:v>0.0733891111071049</c:v>
                  </c:pt>
                  <c:pt idx="2">
                    <c:v>0.073389111107104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6</c:f>
              <c:numCache>
                <c:formatCode>0.0</c:formatCode>
                <c:ptCount val="1"/>
                <c:pt idx="0">
                  <c:v>0.2983742033817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5D9-134F-B9C2-09583EA5BE0A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u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6</c:f>
              <c:numCache>
                <c:formatCode>0.0</c:formatCode>
                <c:ptCount val="1"/>
                <c:pt idx="0">
                  <c:v>0.66177192313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5D9-134F-B9C2-09583EA5BE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3632896"/>
        <c:axId val="952441696"/>
      </c:barChart>
      <c:catAx>
        <c:axId val="953632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2441696"/>
        <c:crosses val="autoZero"/>
        <c:auto val="1"/>
        <c:lblAlgn val="ctr"/>
        <c:lblOffset val="100"/>
        <c:noMultiLvlLbl val="0"/>
      </c:catAx>
      <c:valAx>
        <c:axId val="952441696"/>
        <c:scaling>
          <c:orientation val="minMax"/>
          <c:max val="1.2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3632896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985708080017859"/>
          <c:w val="0.890998152640304"/>
          <c:h val="0.749672189832253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akita islet qPCR (2)'!$AI$27</c:f>
              <c:strCache>
                <c:ptCount val="1"/>
                <c:pt idx="0">
                  <c:v>Akita-He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 (2)'!$AK$28:$AK$34</c:f>
                <c:numCache>
                  <c:formatCode>General</c:formatCode>
                  <c:ptCount val="7"/>
                  <c:pt idx="0">
                    <c:v>0.0665542610827852</c:v>
                  </c:pt>
                  <c:pt idx="1">
                    <c:v>0.148585965534876</c:v>
                  </c:pt>
                  <c:pt idx="2">
                    <c:v>0.41905068586401</c:v>
                  </c:pt>
                  <c:pt idx="3">
                    <c:v>0.949471538274991</c:v>
                  </c:pt>
                  <c:pt idx="4">
                    <c:v>0.292390489935241</c:v>
                  </c:pt>
                  <c:pt idx="5">
                    <c:v>0.23296847216205</c:v>
                  </c:pt>
                  <c:pt idx="6">
                    <c:v>0.639456355418557</c:v>
                  </c:pt>
                </c:numCache>
              </c:numRef>
            </c:plus>
            <c:minus>
              <c:numRef>
                <c:f>'akita islet qPCR (2)'!$AK$28:$AK$34</c:f>
                <c:numCache>
                  <c:formatCode>General</c:formatCode>
                  <c:ptCount val="7"/>
                  <c:pt idx="0">
                    <c:v>0.0665542610827852</c:v>
                  </c:pt>
                  <c:pt idx="1">
                    <c:v>0.148585965534876</c:v>
                  </c:pt>
                  <c:pt idx="2">
                    <c:v>0.41905068586401</c:v>
                  </c:pt>
                  <c:pt idx="3">
                    <c:v>0.949471538274991</c:v>
                  </c:pt>
                  <c:pt idx="4">
                    <c:v>0.292390489935241</c:v>
                  </c:pt>
                  <c:pt idx="5">
                    <c:v>0.23296847216205</c:v>
                  </c:pt>
                  <c:pt idx="6">
                    <c:v>0.639456355418557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 (2)'!$AG$28:$AG$33</c:f>
              <c:numCache>
                <c:formatCode>General</c:formatCode>
                <c:ptCount val="6"/>
                <c:pt idx="0">
                  <c:v>2.0</c:v>
                </c:pt>
                <c:pt idx="1">
                  <c:v>3.0</c:v>
                </c:pt>
                <c:pt idx="2">
                  <c:v>5.0</c:v>
                </c:pt>
                <c:pt idx="3">
                  <c:v>8.0</c:v>
                </c:pt>
                <c:pt idx="4">
                  <c:v>10.0</c:v>
                </c:pt>
                <c:pt idx="5">
                  <c:v>12.0</c:v>
                </c:pt>
              </c:numCache>
            </c:numRef>
          </c:cat>
          <c:val>
            <c:numRef>
              <c:f>'akita islet qPCR (2)'!$AI$28:$AI$33</c:f>
              <c:numCache>
                <c:formatCode>0.0</c:formatCode>
                <c:ptCount val="6"/>
                <c:pt idx="0">
                  <c:v>1.130924443536148</c:v>
                </c:pt>
                <c:pt idx="1">
                  <c:v>1.592515161057372</c:v>
                </c:pt>
                <c:pt idx="2">
                  <c:v>3.471569103785117</c:v>
                </c:pt>
                <c:pt idx="3">
                  <c:v>7.865769388737902</c:v>
                </c:pt>
                <c:pt idx="4">
                  <c:v>12.34669010013391</c:v>
                </c:pt>
                <c:pt idx="5">
                  <c:v>3.0613955969082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5AC-B841-B489-37CCC96993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603012144"/>
        <c:axId val="603229584"/>
      </c:barChart>
      <c:catAx>
        <c:axId val="603012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3229584"/>
        <c:crosses val="autoZero"/>
        <c:auto val="1"/>
        <c:lblAlgn val="ctr"/>
        <c:lblOffset val="100"/>
        <c:noMultiLvlLbl val="0"/>
      </c:catAx>
      <c:valAx>
        <c:axId val="603229584"/>
        <c:scaling>
          <c:orientation val="minMax"/>
          <c:max val="16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3012144"/>
        <c:crosses val="autoZero"/>
        <c:crossBetween val="between"/>
        <c:majorUnit val="4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09760134149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25:$Y$25</c:f>
                <c:numCache>
                  <c:formatCode>General</c:formatCode>
                  <c:ptCount val="3"/>
                  <c:pt idx="0">
                    <c:v>0.252891594107344</c:v>
                  </c:pt>
                  <c:pt idx="1">
                    <c:v>0.187962675603818</c:v>
                  </c:pt>
                  <c:pt idx="2">
                    <c:v>0.021084502116885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25</c:f>
              <c:numCache>
                <c:formatCode>0.0</c:formatCode>
                <c:ptCount val="1"/>
                <c:pt idx="0">
                  <c:v>1.0314815356418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4A0-044E-B02B-7A9E244BAF27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X$25</c:f>
                <c:numCache>
                  <c:formatCode>General</c:formatCode>
                  <c:ptCount val="1"/>
                  <c:pt idx="0">
                    <c:v>0.187962675603818</c:v>
                  </c:pt>
                </c:numCache>
              </c:numRef>
            </c:plus>
            <c:minus>
              <c:numRef>
                <c:f>'Fig 3. akita islet qPCR-4u8C'!$X$6:$X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25</c:f>
              <c:numCache>
                <c:formatCode>0.0</c:formatCode>
                <c:ptCount val="1"/>
                <c:pt idx="0">
                  <c:v>1.417466893177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4A0-044E-B02B-7A9E244BAF27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25</c:f>
                <c:numCache>
                  <c:formatCode>General</c:formatCode>
                  <c:ptCount val="1"/>
                  <c:pt idx="0">
                    <c:v>0.0210845021168857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25</c:f>
              <c:numCache>
                <c:formatCode>0.0</c:formatCode>
                <c:ptCount val="1"/>
                <c:pt idx="0">
                  <c:v>0.880669750287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4A0-044E-B02B-7A9E244BAF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1111905248"/>
        <c:axId val="951116928"/>
      </c:barChart>
      <c:catAx>
        <c:axId val="1111905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116928"/>
        <c:crosses val="autoZero"/>
        <c:auto val="1"/>
        <c:lblAlgn val="ctr"/>
        <c:lblOffset val="100"/>
        <c:noMultiLvlLbl val="0"/>
      </c:catAx>
      <c:valAx>
        <c:axId val="951116928"/>
        <c:scaling>
          <c:orientation val="minMax"/>
          <c:max val="4.0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1905248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687567194914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69E-1C4A-98FC-BA1AD563448F}"/>
              </c:ext>
            </c:extLst>
          </c:dPt>
          <c:errBars>
            <c:errBarType val="plus"/>
            <c:errValType val="cust"/>
            <c:noEndCap val="0"/>
            <c:plus>
              <c:numRef>
                <c:f>'Fig 3. akita islet qPCR-4u8C'!$W$67</c:f>
                <c:numCache>
                  <c:formatCode>General</c:formatCode>
                  <c:ptCount val="1"/>
                  <c:pt idx="0">
                    <c:v>0.11943994417243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67</c:f>
              <c:numCache>
                <c:formatCode>0.0</c:formatCode>
                <c:ptCount val="1"/>
                <c:pt idx="0">
                  <c:v>1.0071076904998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69E-1C4A-98FC-BA1AD563448F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X$67</c:f>
                <c:numCache>
                  <c:formatCode>General</c:formatCode>
                  <c:ptCount val="1"/>
                  <c:pt idx="0">
                    <c:v>0.0623109669450401</c:v>
                  </c:pt>
                </c:numCache>
              </c:numRef>
            </c:plus>
            <c:minus>
              <c:numRef>
                <c:f>'Fig 3. akita islet qPCR-4u8C'!$X$6:$X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67</c:f>
              <c:numCache>
                <c:formatCode>0.0</c:formatCode>
                <c:ptCount val="1"/>
                <c:pt idx="0">
                  <c:v>5.5070670549906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69E-1C4A-98FC-BA1AD563448F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67</c:f>
                <c:numCache>
                  <c:formatCode>General</c:formatCode>
                  <c:ptCount val="1"/>
                  <c:pt idx="0">
                    <c:v>0.131489381474576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6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67</c:f>
              <c:numCache>
                <c:formatCode>0.0</c:formatCode>
                <c:ptCount val="1"/>
                <c:pt idx="0">
                  <c:v>2.1969752506355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69E-1C4A-98FC-BA1AD5634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80135552"/>
        <c:axId val="980138384"/>
      </c:barChart>
      <c:catAx>
        <c:axId val="980135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0138384"/>
        <c:crosses val="autoZero"/>
        <c:auto val="1"/>
        <c:lblAlgn val="ctr"/>
        <c:lblOffset val="100"/>
        <c:noMultiLvlLbl val="0"/>
      </c:catAx>
      <c:valAx>
        <c:axId val="980138384"/>
        <c:scaling>
          <c:orientation val="minMax"/>
          <c:max val="6.0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0135552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670423646818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67</c:f>
                <c:numCache>
                  <c:formatCode>General</c:formatCode>
                  <c:ptCount val="1"/>
                  <c:pt idx="0">
                    <c:v>0.11943994417243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09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109</c:f>
              <c:numCache>
                <c:formatCode>0.0</c:formatCode>
                <c:ptCount val="1"/>
                <c:pt idx="0">
                  <c:v>1.0199214427287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91E-5947-A5B2-8CF97D11C70D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E91E-5947-A5B2-8CF97D11C70D}"/>
              </c:ext>
            </c:extLst>
          </c:dPt>
          <c:errBars>
            <c:errBarType val="plus"/>
            <c:errValType val="cust"/>
            <c:noEndCap val="0"/>
            <c:plus>
              <c:numRef>
                <c:f>'Fig 3. akita islet qPCR-4u8C'!$X$109</c:f>
                <c:numCache>
                  <c:formatCode>General</c:formatCode>
                  <c:ptCount val="1"/>
                  <c:pt idx="0">
                    <c:v>0.704931353242592</c:v>
                  </c:pt>
                </c:numCache>
              </c:numRef>
            </c:plus>
            <c:minus>
              <c:numRef>
                <c:f>'Fig 3. akita islet qPCR-4u8C'!$X$109</c:f>
                <c:numCache>
                  <c:formatCode>General</c:formatCode>
                  <c:ptCount val="1"/>
                  <c:pt idx="0">
                    <c:v>0.70493135324259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09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109</c:f>
              <c:numCache>
                <c:formatCode>0.0</c:formatCode>
                <c:ptCount val="1"/>
                <c:pt idx="0">
                  <c:v>5.2825721971852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91E-5947-A5B2-8CF97D11C70D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109</c:f>
                <c:numCache>
                  <c:formatCode>General</c:formatCode>
                  <c:ptCount val="1"/>
                  <c:pt idx="0">
                    <c:v>0.326861411938713</c:v>
                  </c:pt>
                </c:numCache>
              </c:numRef>
            </c:plus>
            <c:minus>
              <c:numRef>
                <c:f>'Fig 3. akita islet qPCR-4u8C'!$Y$88</c:f>
                <c:numCache>
                  <c:formatCode>General</c:formatCode>
                  <c:ptCount val="1"/>
                  <c:pt idx="0">
                    <c:v>0.34907872909285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09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109</c:f>
              <c:numCache>
                <c:formatCode>0.0</c:formatCode>
                <c:ptCount val="1"/>
                <c:pt idx="0">
                  <c:v>3.0745956531498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91E-5947-A5B2-8CF97D11C7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666834144"/>
        <c:axId val="666836976"/>
      </c:barChart>
      <c:catAx>
        <c:axId val="666834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836976"/>
        <c:crosses val="autoZero"/>
        <c:auto val="1"/>
        <c:lblAlgn val="ctr"/>
        <c:lblOffset val="100"/>
        <c:noMultiLvlLbl val="0"/>
      </c:catAx>
      <c:valAx>
        <c:axId val="666836976"/>
        <c:scaling>
          <c:orientation val="minMax"/>
          <c:max val="6.0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834144"/>
        <c:crosses val="autoZero"/>
        <c:crossBetween val="between"/>
        <c:majorUnit val="2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723824996617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67</c:f>
                <c:numCache>
                  <c:formatCode>General</c:formatCode>
                  <c:ptCount val="1"/>
                  <c:pt idx="0">
                    <c:v>0.11943994417243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88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88</c:f>
              <c:numCache>
                <c:formatCode>0.0</c:formatCode>
                <c:ptCount val="1"/>
                <c:pt idx="0">
                  <c:v>1.020540055088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450-4E4F-9319-ECD95BAD39B9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X$88</c:f>
                <c:numCache>
                  <c:formatCode>General</c:formatCode>
                  <c:ptCount val="1"/>
                  <c:pt idx="0">
                    <c:v>0.0837492442330107</c:v>
                  </c:pt>
                </c:numCache>
              </c:numRef>
            </c:plus>
            <c:minus>
              <c:numRef>
                <c:f>'Fig 3. akita islet qPCR-4u8C'!$X$88</c:f>
                <c:numCache>
                  <c:formatCode>General</c:formatCode>
                  <c:ptCount val="1"/>
                  <c:pt idx="0">
                    <c:v>0.083749244233010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88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88</c:f>
              <c:numCache>
                <c:formatCode>0.0</c:formatCode>
                <c:ptCount val="1"/>
                <c:pt idx="0">
                  <c:v>4.1846382448478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450-4E4F-9319-ECD95BAD39B9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88</c:f>
                <c:numCache>
                  <c:formatCode>General</c:formatCode>
                  <c:ptCount val="1"/>
                  <c:pt idx="0">
                    <c:v>0.349078729092852</c:v>
                  </c:pt>
                </c:numCache>
              </c:numRef>
            </c:plus>
            <c:minus>
              <c:numRef>
                <c:f>'Fig 3. akita islet qPCR-4u8C'!$Y$88</c:f>
                <c:numCache>
                  <c:formatCode>General</c:formatCode>
                  <c:ptCount val="1"/>
                  <c:pt idx="0">
                    <c:v>0.34907872909285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88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88</c:f>
              <c:numCache>
                <c:formatCode>0.0</c:formatCode>
                <c:ptCount val="1"/>
                <c:pt idx="0">
                  <c:v>2.5901683133536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450-4E4F-9319-ECD95BAD3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3567872"/>
        <c:axId val="1111935744"/>
      </c:barChart>
      <c:catAx>
        <c:axId val="95356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1935744"/>
        <c:crosses val="autoZero"/>
        <c:auto val="1"/>
        <c:lblAlgn val="ctr"/>
        <c:lblOffset val="100"/>
        <c:noMultiLvlLbl val="0"/>
      </c:catAx>
      <c:valAx>
        <c:axId val="1111935744"/>
        <c:scaling>
          <c:orientation val="minMax"/>
          <c:max val="5.0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3567872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723824218923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31D-FB43-825F-87C970D3A9DB}"/>
              </c:ext>
            </c:extLst>
          </c:dPt>
          <c:errBars>
            <c:errBarType val="plus"/>
            <c:errValType val="cust"/>
            <c:noEndCap val="0"/>
            <c:plus>
              <c:numRef>
                <c:f>'Fig 3. akita islet qPCR-4u8C'!$W$67</c:f>
                <c:numCache>
                  <c:formatCode>General</c:formatCode>
                  <c:ptCount val="1"/>
                  <c:pt idx="0">
                    <c:v>0.11943994417243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30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130</c:f>
              <c:numCache>
                <c:formatCode>0.0</c:formatCode>
                <c:ptCount val="1"/>
                <c:pt idx="0">
                  <c:v>1.0017914372450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31D-FB43-825F-87C970D3A9DB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4-231D-FB43-825F-87C970D3A9DB}"/>
              </c:ext>
            </c:extLst>
          </c:dPt>
          <c:errBars>
            <c:errBarType val="plus"/>
            <c:errValType val="cust"/>
            <c:noEndCap val="0"/>
            <c:plus>
              <c:numRef>
                <c:f>'Fig 3. akita islet qPCR-4u8C'!$X$67</c:f>
                <c:numCache>
                  <c:formatCode>General</c:formatCode>
                  <c:ptCount val="1"/>
                  <c:pt idx="0">
                    <c:v>0.0623109669450401</c:v>
                  </c:pt>
                </c:numCache>
              </c:numRef>
            </c:plus>
            <c:minus>
              <c:numRef>
                <c:f>'Fig 3. akita islet qPCR-4u8C'!$X$6:$X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30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130</c:f>
              <c:numCache>
                <c:formatCode>0.0</c:formatCode>
                <c:ptCount val="1"/>
                <c:pt idx="0">
                  <c:v>3.1406353687723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231D-FB43-825F-87C970D3A9DB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7-231D-FB43-825F-87C970D3A9DB}"/>
              </c:ext>
            </c:extLst>
          </c:dPt>
          <c:errBars>
            <c:errBarType val="plus"/>
            <c:errValType val="cust"/>
            <c:noEndCap val="0"/>
            <c:plus>
              <c:numRef>
                <c:f>'Fig 3. akita islet qPCR-4u8C'!$Y$67</c:f>
                <c:numCache>
                  <c:formatCode>General</c:formatCode>
                  <c:ptCount val="1"/>
                  <c:pt idx="0">
                    <c:v>0.131489381474576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130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130</c:f>
              <c:numCache>
                <c:formatCode>0.0</c:formatCode>
                <c:ptCount val="1"/>
                <c:pt idx="0">
                  <c:v>1.170065940465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231D-FB43-825F-87C970D3A9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1112245696"/>
        <c:axId val="951240144"/>
      </c:barChart>
      <c:catAx>
        <c:axId val="1112245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240144"/>
        <c:crosses val="autoZero"/>
        <c:auto val="1"/>
        <c:lblAlgn val="ctr"/>
        <c:lblOffset val="100"/>
        <c:noMultiLvlLbl val="0"/>
      </c:catAx>
      <c:valAx>
        <c:axId val="951240144"/>
        <c:scaling>
          <c:orientation val="minMax"/>
          <c:max val="5.0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2245696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78208622446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rep genes- (2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W$67</c:f>
                <c:numCache>
                  <c:formatCode>General</c:formatCode>
                  <c:ptCount val="1"/>
                  <c:pt idx="0">
                    <c:v>0.107644622672377</c:v>
                  </c:pt>
                </c:numCache>
              </c:numRef>
            </c:plus>
            <c:minus>
              <c:numRef>
                <c:f>'akita islet qPCR-rep genes- (2'!$W$6:$W$9</c:f>
                <c:numCache>
                  <c:formatCode>General</c:formatCode>
                  <c:ptCount val="4"/>
                  <c:pt idx="0">
                    <c:v>0.013863387648334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09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T$109</c:f>
              <c:numCache>
                <c:formatCode>0.0</c:formatCode>
                <c:ptCount val="1"/>
                <c:pt idx="0">
                  <c:v>1.0106127076065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3F-9149-8E7B-710AC162D97C}"/>
            </c:ext>
          </c:extLst>
        </c:ser>
        <c:ser>
          <c:idx val="1"/>
          <c:order val="1"/>
          <c:tx>
            <c:strRef>
              <c:f>'akita islet qPCR-rep genes- (2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B73F-9149-8E7B-710AC162D97C}"/>
              </c:ext>
            </c:extLst>
          </c:dPt>
          <c:errBars>
            <c:errBarType val="plus"/>
            <c:errValType val="cust"/>
            <c:noEndCap val="0"/>
            <c:plus>
              <c:numRef>
                <c:f>'akita islet qPCR-rep genes- (2'!$X$88</c:f>
                <c:numCache>
                  <c:formatCode>General</c:formatCode>
                  <c:ptCount val="1"/>
                  <c:pt idx="0">
                    <c:v>0.0131229698830743</c:v>
                  </c:pt>
                </c:numCache>
              </c:numRef>
            </c:plus>
            <c:minus>
              <c:numRef>
                <c:f>'akita islet qPCR-rep genes- (2'!$X$6:$X$9</c:f>
                <c:numCache>
                  <c:formatCode>General</c:formatCode>
                  <c:ptCount val="4"/>
                  <c:pt idx="0">
                    <c:v>0.104762671466001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09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U$109</c:f>
              <c:numCache>
                <c:formatCode>0.0</c:formatCode>
                <c:ptCount val="1"/>
                <c:pt idx="0">
                  <c:v>1.5435447453675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3F-9149-8E7B-710AC162D97C}"/>
            </c:ext>
          </c:extLst>
        </c:ser>
        <c:ser>
          <c:idx val="2"/>
          <c:order val="2"/>
          <c:tx>
            <c:strRef>
              <c:f>'akita islet qPCR-rep genes- (2'!$V$5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Y$88</c:f>
                <c:numCache>
                  <c:formatCode>General</c:formatCode>
                  <c:ptCount val="1"/>
                  <c:pt idx="0">
                    <c:v>0.0229258131970251</c:v>
                  </c:pt>
                </c:numCache>
              </c:numRef>
            </c:plus>
            <c:minus>
              <c:numRef>
                <c:f>'akita islet qPCR-rep genes- (2'!$Y$109</c:f>
                <c:numCache>
                  <c:formatCode>General</c:formatCode>
                  <c:ptCount val="1"/>
                  <c:pt idx="0">
                    <c:v>0.19129160670384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09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V$109</c:f>
              <c:numCache>
                <c:formatCode>0.0</c:formatCode>
                <c:ptCount val="1"/>
                <c:pt idx="0">
                  <c:v>0.918277865363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73F-9149-8E7B-710AC162D9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1075360"/>
        <c:axId val="1111838672"/>
      </c:barChart>
      <c:catAx>
        <c:axId val="951075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1838672"/>
        <c:crosses val="autoZero"/>
        <c:auto val="1"/>
        <c:lblAlgn val="ctr"/>
        <c:lblOffset val="100"/>
        <c:noMultiLvlLbl val="0"/>
      </c:catAx>
      <c:valAx>
        <c:axId val="1111838672"/>
        <c:scaling>
          <c:orientation val="minMax"/>
          <c:max val="2.0"/>
          <c:min val="0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075360"/>
        <c:crosses val="autoZero"/>
        <c:crossBetween val="between"/>
        <c:maj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656234724704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46</c:f>
                <c:numCache>
                  <c:formatCode>General</c:formatCode>
                  <c:ptCount val="1"/>
                  <c:pt idx="0">
                    <c:v>0.431262281490973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4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47</c:f>
              <c:numCache>
                <c:formatCode>0.00</c:formatCode>
                <c:ptCount val="1"/>
                <c:pt idx="0">
                  <c:v>1.0037558879349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F3-9543-AC7E-0E5E1F7CAB58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X$46</c:f>
                <c:numCache>
                  <c:formatCode>General</c:formatCode>
                  <c:ptCount val="1"/>
                  <c:pt idx="0">
                    <c:v>0.575927102799007</c:v>
                  </c:pt>
                </c:numCache>
              </c:numRef>
            </c:plus>
            <c:minus>
              <c:numRef>
                <c:f>'Fig 3. akita islet qPCR-4u8C'!$X$6:$X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4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47</c:f>
              <c:numCache>
                <c:formatCode>0.00</c:formatCode>
                <c:ptCount val="1"/>
                <c:pt idx="0">
                  <c:v>3.119822127927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3F3-9543-AC7E-0E5E1F7CAB58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 4µ8C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46</c:f>
                <c:numCache>
                  <c:formatCode>General</c:formatCode>
                  <c:ptCount val="1"/>
                  <c:pt idx="0">
                    <c:v>0.0795161772951748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S$47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47</c:f>
              <c:numCache>
                <c:formatCode>0.00</c:formatCode>
                <c:ptCount val="1"/>
                <c:pt idx="0">
                  <c:v>1.0518059551598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3F3-9543-AC7E-0E5E1F7CAB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1111909040"/>
        <c:axId val="951425360"/>
      </c:barChart>
      <c:catAx>
        <c:axId val="1111909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1425360"/>
        <c:crosses val="autoZero"/>
        <c:auto val="1"/>
        <c:lblAlgn val="ctr"/>
        <c:lblOffset val="100"/>
        <c:noMultiLvlLbl val="0"/>
      </c:catAx>
      <c:valAx>
        <c:axId val="951425360"/>
        <c:scaling>
          <c:orientation val="minMax"/>
          <c:max val="4.0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11909040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833994820437912"/>
          <c:w val="0.881550264531568"/>
          <c:h val="0.03282571621451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3. akita islet qPCR-4u8C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W$25:$Y$25</c:f>
                <c:numCache>
                  <c:formatCode>General</c:formatCode>
                  <c:ptCount val="3"/>
                  <c:pt idx="0">
                    <c:v>0.252891594107344</c:v>
                  </c:pt>
                  <c:pt idx="1">
                    <c:v>0.187962675603818</c:v>
                  </c:pt>
                  <c:pt idx="2">
                    <c:v>0.0210845021168857</c:v>
                  </c:pt>
                </c:numCache>
              </c:numRef>
            </c:plus>
            <c:minus>
              <c:numRef>
                <c:f>'Fig 3. akita islet qPCR-4u8C'!$W$6:$W$9</c:f>
                <c:numCache>
                  <c:formatCode>General</c:formatCode>
                  <c:ptCount val="4"/>
                  <c:pt idx="0">
                    <c:v>0.17210576827198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T$25</c:f>
              <c:numCache>
                <c:formatCode>0.0</c:formatCode>
                <c:ptCount val="1"/>
                <c:pt idx="0">
                  <c:v>1.0314815356418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EC1-4646-944A-015802EF51BF}"/>
            </c:ext>
          </c:extLst>
        </c:ser>
        <c:ser>
          <c:idx val="1"/>
          <c:order val="1"/>
          <c:tx>
            <c:strRef>
              <c:f>'Fig 3. akita islet qPCR-4u8C'!$U$5</c:f>
              <c:strCache>
                <c:ptCount val="1"/>
                <c:pt idx="0">
                  <c:v>Akita-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X$25</c:f>
                <c:numCache>
                  <c:formatCode>General</c:formatCode>
                  <c:ptCount val="1"/>
                  <c:pt idx="0">
                    <c:v>0.187962675603818</c:v>
                  </c:pt>
                </c:numCache>
              </c:numRef>
            </c:plus>
            <c:minus>
              <c:numRef>
                <c:f>'Fig 3. akita islet qPCR-4u8C'!$X$6:$X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U$25</c:f>
              <c:numCache>
                <c:formatCode>0.0</c:formatCode>
                <c:ptCount val="1"/>
                <c:pt idx="0">
                  <c:v>1.417466893177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EC1-4646-944A-015802EF51BF}"/>
            </c:ext>
          </c:extLst>
        </c:ser>
        <c:ser>
          <c:idx val="2"/>
          <c:order val="2"/>
          <c:tx>
            <c:strRef>
              <c:f>'Fig 3. akita islet qPCR-4u8C'!$V$5</c:f>
              <c:strCache>
                <c:ptCount val="1"/>
                <c:pt idx="0">
                  <c:v>Akita-4µ8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 3. akita islet qPCR-4u8C'!$Y$25</c:f>
                <c:numCache>
                  <c:formatCode>General</c:formatCode>
                  <c:ptCount val="1"/>
                  <c:pt idx="0">
                    <c:v>0.0210845021168857</c:v>
                  </c:pt>
                </c:numCache>
              </c:numRef>
            </c:plus>
            <c:minus>
              <c:numRef>
                <c:f>'Fig 3. akita islet qPCR-4u8C'!$Y$6:$Y$9</c:f>
                <c:numCache>
                  <c:formatCode>General</c:formatCode>
                  <c:ptCount val="4"/>
                  <c:pt idx="0">
                    <c:v>0.0733891111071049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Fig 3. akita islet qPCR-4u8C'!$R$25</c:f>
              <c:numCache>
                <c:formatCode>General</c:formatCode>
                <c:ptCount val="1"/>
              </c:numCache>
            </c:numRef>
          </c:cat>
          <c:val>
            <c:numRef>
              <c:f>'Fig 3. akita islet qPCR-4u8C'!$V$25</c:f>
              <c:numCache>
                <c:formatCode>0.0</c:formatCode>
                <c:ptCount val="1"/>
                <c:pt idx="0">
                  <c:v>0.880669750287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EC1-4646-944A-015802EF51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30"/>
        <c:axId val="666468688"/>
        <c:axId val="666471248"/>
      </c:barChart>
      <c:catAx>
        <c:axId val="66646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471248"/>
        <c:crosses val="autoZero"/>
        <c:auto val="1"/>
        <c:lblAlgn val="ctr"/>
        <c:lblOffset val="100"/>
        <c:noMultiLvlLbl val="0"/>
      </c:catAx>
      <c:valAx>
        <c:axId val="666471248"/>
        <c:scaling>
          <c:orientation val="minMax"/>
          <c:max val="2.0"/>
          <c:min val="0.0"/>
        </c:scaling>
        <c:delete val="1"/>
        <c:axPos val="l"/>
        <c:numFmt formatCode="0.0" sourceLinked="1"/>
        <c:majorTickMark val="out"/>
        <c:minorTickMark val="none"/>
        <c:tickLblPos val="nextTo"/>
        <c:crossAx val="66646868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0260790902041871"/>
          <c:y val="0.0809226553618203"/>
          <c:w val="0.968490903165631"/>
          <c:h val="0.846440097779147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09760134149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rep genes- (2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W$67</c:f>
                <c:numCache>
                  <c:formatCode>General</c:formatCode>
                  <c:ptCount val="1"/>
                  <c:pt idx="0">
                    <c:v>0.107644622672377</c:v>
                  </c:pt>
                </c:numCache>
              </c:numRef>
            </c:plus>
            <c:minus>
              <c:numRef>
                <c:f>'akita islet qPCR-rep genes- (2'!$W$6:$W$9</c:f>
                <c:numCache>
                  <c:formatCode>General</c:formatCode>
                  <c:ptCount val="4"/>
                  <c:pt idx="0">
                    <c:v>0.013863387648334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52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T$152</c:f>
              <c:numCache>
                <c:formatCode>0.0</c:formatCode>
                <c:ptCount val="1"/>
                <c:pt idx="0">
                  <c:v>1.0011773408335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05-FD4D-985B-B25A029D43C5}"/>
            </c:ext>
          </c:extLst>
        </c:ser>
        <c:ser>
          <c:idx val="1"/>
          <c:order val="1"/>
          <c:tx>
            <c:strRef>
              <c:f>'akita islet qPCR-rep genes- (2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X$152</c:f>
                <c:numCache>
                  <c:formatCode>General</c:formatCode>
                  <c:ptCount val="1"/>
                  <c:pt idx="0">
                    <c:v>0.0299210985425104</c:v>
                  </c:pt>
                </c:numCache>
              </c:numRef>
            </c:plus>
            <c:minus>
              <c:numRef>
                <c:f>'akita islet qPCR-rep genes- (2'!$X$152</c:f>
                <c:numCache>
                  <c:formatCode>General</c:formatCode>
                  <c:ptCount val="1"/>
                  <c:pt idx="0">
                    <c:v>0.029921098542510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52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U$152</c:f>
              <c:numCache>
                <c:formatCode>0.0</c:formatCode>
                <c:ptCount val="1"/>
                <c:pt idx="0">
                  <c:v>0.1123481389277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C05-FD4D-985B-B25A029D43C5}"/>
            </c:ext>
          </c:extLst>
        </c:ser>
        <c:ser>
          <c:idx val="2"/>
          <c:order val="2"/>
          <c:tx>
            <c:strRef>
              <c:f>'akita islet qPCR-rep genes- (2'!$V$5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Y$151</c:f>
                <c:numCache>
                  <c:formatCode>General</c:formatCode>
                  <c:ptCount val="1"/>
                  <c:pt idx="0">
                    <c:v>0.0165112634671206</c:v>
                  </c:pt>
                </c:numCache>
              </c:numRef>
            </c:plus>
            <c:minus>
              <c:numRef>
                <c:f>'akita islet qPCR-rep genes- (2'!$Y$151</c:f>
                <c:numCache>
                  <c:formatCode>General</c:formatCode>
                  <c:ptCount val="1"/>
                  <c:pt idx="0">
                    <c:v>0.016511263467120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52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V$152</c:f>
              <c:numCache>
                <c:formatCode>0.0</c:formatCode>
                <c:ptCount val="1"/>
                <c:pt idx="0">
                  <c:v>0.6310675126910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C05-FD4D-985B-B25A029D43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666394048"/>
        <c:axId val="666361872"/>
      </c:barChart>
      <c:catAx>
        <c:axId val="666394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361872"/>
        <c:crosses val="autoZero"/>
        <c:auto val="1"/>
        <c:lblAlgn val="ctr"/>
        <c:lblOffset val="100"/>
        <c:noMultiLvlLbl val="0"/>
      </c:catAx>
      <c:valAx>
        <c:axId val="666361872"/>
        <c:scaling>
          <c:orientation val="minMax"/>
          <c:max val="1.5"/>
          <c:min val="0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394048"/>
        <c:crosses val="autoZero"/>
        <c:crossBetween val="between"/>
        <c:maj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09760134149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rep genes- (2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W$67</c:f>
                <c:numCache>
                  <c:formatCode>General</c:formatCode>
                  <c:ptCount val="1"/>
                  <c:pt idx="0">
                    <c:v>0.107644622672377</c:v>
                  </c:pt>
                </c:numCache>
              </c:numRef>
            </c:plus>
            <c:minus>
              <c:numRef>
                <c:f>'akita islet qPCR-rep genes- (2'!$W$6:$W$9</c:f>
                <c:numCache>
                  <c:formatCode>General</c:formatCode>
                  <c:ptCount val="4"/>
                  <c:pt idx="0">
                    <c:v>0.0138633876483347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73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T$173</c:f>
              <c:numCache>
                <c:formatCode>0.0</c:formatCode>
                <c:ptCount val="1"/>
                <c:pt idx="0">
                  <c:v>1.00654729872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D8-DD42-B0B9-9D62E062C4E7}"/>
            </c:ext>
          </c:extLst>
        </c:ser>
        <c:ser>
          <c:idx val="1"/>
          <c:order val="1"/>
          <c:tx>
            <c:strRef>
              <c:f>'akita islet qPCR-rep genes- (2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W$172</c:f>
                <c:numCache>
                  <c:formatCode>General</c:formatCode>
                  <c:ptCount val="1"/>
                  <c:pt idx="0">
                    <c:v>0.114618779304209</c:v>
                  </c:pt>
                </c:numCache>
              </c:numRef>
            </c:plus>
            <c:minus>
              <c:numRef>
                <c:f>'akita islet qPCR-rep genes- (2'!$W$172</c:f>
                <c:numCache>
                  <c:formatCode>General</c:formatCode>
                  <c:ptCount val="1"/>
                  <c:pt idx="0">
                    <c:v>0.11461877930420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73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U$173</c:f>
              <c:numCache>
                <c:formatCode>0.0</c:formatCode>
                <c:ptCount val="1"/>
                <c:pt idx="0">
                  <c:v>0.2602203017620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CD8-DD42-B0B9-9D62E062C4E7}"/>
            </c:ext>
          </c:extLst>
        </c:ser>
        <c:ser>
          <c:idx val="2"/>
          <c:order val="2"/>
          <c:tx>
            <c:strRef>
              <c:f>'akita islet qPCR-rep genes- (2'!$V$5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 (2'!$W$172</c:f>
                <c:numCache>
                  <c:formatCode>General</c:formatCode>
                  <c:ptCount val="1"/>
                  <c:pt idx="0">
                    <c:v>0.114618779304209</c:v>
                  </c:pt>
                </c:numCache>
              </c:numRef>
            </c:plus>
            <c:minus>
              <c:numRef>
                <c:f>'akita islet qPCR-rep genes- (2'!$W$172</c:f>
                <c:numCache>
                  <c:formatCode>General</c:formatCode>
                  <c:ptCount val="1"/>
                  <c:pt idx="0">
                    <c:v>0.11461877930420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 (2'!$S$173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 (2'!$V$173</c:f>
              <c:numCache>
                <c:formatCode>0.0</c:formatCode>
                <c:ptCount val="1"/>
                <c:pt idx="0">
                  <c:v>0.936727742121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CD8-DD42-B0B9-9D62E062C4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666354208"/>
        <c:axId val="666357040"/>
      </c:barChart>
      <c:catAx>
        <c:axId val="66635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357040"/>
        <c:crosses val="autoZero"/>
        <c:auto val="1"/>
        <c:lblAlgn val="ctr"/>
        <c:lblOffset val="100"/>
        <c:noMultiLvlLbl val="0"/>
      </c:catAx>
      <c:valAx>
        <c:axId val="666357040"/>
        <c:scaling>
          <c:orientation val="minMax"/>
          <c:max val="1.5"/>
          <c:min val="0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354208"/>
        <c:crosses val="autoZero"/>
        <c:crossBetween val="between"/>
        <c:maj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17167541557305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603782496"/>
        <c:axId val="950314128"/>
      </c:barChart>
      <c:catAx>
        <c:axId val="603782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314128"/>
        <c:crosses val="autoZero"/>
        <c:auto val="1"/>
        <c:lblAlgn val="ctr"/>
        <c:lblOffset val="100"/>
        <c:noMultiLvlLbl val="0"/>
      </c:catAx>
      <c:valAx>
        <c:axId val="950314128"/>
        <c:scaling>
          <c:orientation val="minMax"/>
          <c:max val="3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3782496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17167541557305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akita islet qPCR (2)'!$AI$226</c:f>
              <c:strCache>
                <c:ptCount val="1"/>
                <c:pt idx="0">
                  <c:v>Akita-He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 (2)'!$U$288:$U$294</c:f>
                <c:numCache>
                  <c:formatCode>General</c:formatCode>
                  <c:ptCount val="7"/>
                  <c:pt idx="0">
                    <c:v>0.135312756507749</c:v>
                  </c:pt>
                  <c:pt idx="1">
                    <c:v>0.0468033563637262</c:v>
                  </c:pt>
                  <c:pt idx="2">
                    <c:v>0.0950915260004399</c:v>
                  </c:pt>
                  <c:pt idx="3">
                    <c:v>0.0980932982664657</c:v>
                  </c:pt>
                  <c:pt idx="4">
                    <c:v>0.173821066414847</c:v>
                  </c:pt>
                  <c:pt idx="5">
                    <c:v>0.36499998079447</c:v>
                  </c:pt>
                  <c:pt idx="6">
                    <c:v>1.652970517892968</c:v>
                  </c:pt>
                </c:numCache>
              </c:numRef>
            </c:plus>
            <c:minus>
              <c:numRef>
                <c:f>'akita islet qPCR (2)'!$U$288:$U$294</c:f>
                <c:numCache>
                  <c:formatCode>General</c:formatCode>
                  <c:ptCount val="7"/>
                  <c:pt idx="0">
                    <c:v>0.135312756507749</c:v>
                  </c:pt>
                  <c:pt idx="1">
                    <c:v>0.0468033563637262</c:v>
                  </c:pt>
                  <c:pt idx="2">
                    <c:v>0.0950915260004399</c:v>
                  </c:pt>
                  <c:pt idx="3">
                    <c:v>0.0980932982664657</c:v>
                  </c:pt>
                  <c:pt idx="4">
                    <c:v>0.173821066414847</c:v>
                  </c:pt>
                  <c:pt idx="5">
                    <c:v>0.36499998079447</c:v>
                  </c:pt>
                  <c:pt idx="6">
                    <c:v>1.652970517892968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 (2)'!$Q$288:$Q$293</c:f>
              <c:numCache>
                <c:formatCode>General</c:formatCode>
                <c:ptCount val="6"/>
                <c:pt idx="0">
                  <c:v>2.0</c:v>
                </c:pt>
                <c:pt idx="1">
                  <c:v>3.0</c:v>
                </c:pt>
                <c:pt idx="2">
                  <c:v>5.0</c:v>
                </c:pt>
                <c:pt idx="3">
                  <c:v>8.0</c:v>
                </c:pt>
                <c:pt idx="4">
                  <c:v>10.0</c:v>
                </c:pt>
                <c:pt idx="5">
                  <c:v>12.0</c:v>
                </c:pt>
              </c:numCache>
            </c:numRef>
          </c:cat>
          <c:val>
            <c:numRef>
              <c:f>'akita islet qPCR (2)'!$S$288:$S$293</c:f>
              <c:numCache>
                <c:formatCode>0.0</c:formatCode>
                <c:ptCount val="6"/>
                <c:pt idx="0">
                  <c:v>1.45025551671282</c:v>
                </c:pt>
                <c:pt idx="1">
                  <c:v>1.126031592868153</c:v>
                </c:pt>
                <c:pt idx="2">
                  <c:v>1.374077107277871</c:v>
                </c:pt>
                <c:pt idx="3">
                  <c:v>2.023282184469964</c:v>
                </c:pt>
                <c:pt idx="4">
                  <c:v>2.95365750609951</c:v>
                </c:pt>
                <c:pt idx="5">
                  <c:v>5.0239343266682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C7A-41C6-82FF-FFCC4050FB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950265920"/>
        <c:axId val="950801408"/>
      </c:barChart>
      <c:catAx>
        <c:axId val="950265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801408"/>
        <c:crosses val="autoZero"/>
        <c:auto val="1"/>
        <c:lblAlgn val="ctr"/>
        <c:lblOffset val="100"/>
        <c:noMultiLvlLbl val="0"/>
      </c:catAx>
      <c:valAx>
        <c:axId val="950801408"/>
        <c:scaling>
          <c:orientation val="minMax"/>
          <c:max val="6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265920"/>
        <c:crosses val="autoZero"/>
        <c:crossBetween val="between"/>
        <c:majorUnit val="2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2421393764537"/>
          <c:y val="0.130839838571019"/>
          <c:w val="0.890998152640304"/>
          <c:h val="0.717167541557305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603826016"/>
        <c:axId val="603828336"/>
      </c:barChart>
      <c:catAx>
        <c:axId val="603826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3828336"/>
        <c:crosses val="autoZero"/>
        <c:auto val="1"/>
        <c:lblAlgn val="ctr"/>
        <c:lblOffset val="100"/>
        <c:noMultiLvlLbl val="0"/>
      </c:catAx>
      <c:valAx>
        <c:axId val="603828336"/>
        <c:scaling>
          <c:orientation val="minMax"/>
          <c:max val="10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3826016"/>
        <c:crosses val="autoZero"/>
        <c:crossBetween val="between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17167541557305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akita islet qPCR (2)'!$S$317</c:f>
              <c:strCache>
                <c:ptCount val="1"/>
                <c:pt idx="0">
                  <c:v>Akita-He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 (2)'!$U$318:$U$324</c:f>
                <c:numCache>
                  <c:formatCode>General</c:formatCode>
                  <c:ptCount val="7"/>
                  <c:pt idx="0">
                    <c:v>0.108424973209011</c:v>
                  </c:pt>
                  <c:pt idx="1">
                    <c:v>0.117433452383819</c:v>
                  </c:pt>
                  <c:pt idx="2">
                    <c:v>0.0492169267642574</c:v>
                  </c:pt>
                  <c:pt idx="3">
                    <c:v>0.0599664087161198</c:v>
                  </c:pt>
                  <c:pt idx="4">
                    <c:v>0.0971237740384202</c:v>
                  </c:pt>
                  <c:pt idx="5">
                    <c:v>0.470167634690413</c:v>
                  </c:pt>
                  <c:pt idx="6">
                    <c:v>0.270780670028471</c:v>
                  </c:pt>
                </c:numCache>
              </c:numRef>
            </c:plus>
            <c:minus>
              <c:numRef>
                <c:f>'akita islet qPCR (2)'!$U$318:$U$324</c:f>
                <c:numCache>
                  <c:formatCode>General</c:formatCode>
                  <c:ptCount val="7"/>
                  <c:pt idx="0">
                    <c:v>0.108424973209011</c:v>
                  </c:pt>
                  <c:pt idx="1">
                    <c:v>0.117433452383819</c:v>
                  </c:pt>
                  <c:pt idx="2">
                    <c:v>0.0492169267642574</c:v>
                  </c:pt>
                  <c:pt idx="3">
                    <c:v>0.0599664087161198</c:v>
                  </c:pt>
                  <c:pt idx="4">
                    <c:v>0.0971237740384202</c:v>
                  </c:pt>
                  <c:pt idx="5">
                    <c:v>0.470167634690413</c:v>
                  </c:pt>
                  <c:pt idx="6">
                    <c:v>0.270780670028471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 (2)'!$Q$288:$Q$294</c:f>
              <c:numCache>
                <c:formatCode>General</c:formatCode>
                <c:ptCount val="7"/>
                <c:pt idx="0">
                  <c:v>2.0</c:v>
                </c:pt>
                <c:pt idx="1">
                  <c:v>3.0</c:v>
                </c:pt>
                <c:pt idx="2">
                  <c:v>5.0</c:v>
                </c:pt>
                <c:pt idx="3">
                  <c:v>8.0</c:v>
                </c:pt>
                <c:pt idx="4">
                  <c:v>10.0</c:v>
                </c:pt>
                <c:pt idx="5">
                  <c:v>12.0</c:v>
                </c:pt>
                <c:pt idx="6">
                  <c:v>16.0</c:v>
                </c:pt>
              </c:numCache>
            </c:numRef>
          </c:cat>
          <c:val>
            <c:numRef>
              <c:f>'akita islet qPCR (2)'!$S$319:$S$324</c:f>
              <c:numCache>
                <c:formatCode>0.0</c:formatCode>
                <c:ptCount val="6"/>
                <c:pt idx="0">
                  <c:v>1.031264902613218</c:v>
                </c:pt>
                <c:pt idx="1">
                  <c:v>1.015153255689105</c:v>
                </c:pt>
                <c:pt idx="2">
                  <c:v>1.236873145934886</c:v>
                </c:pt>
                <c:pt idx="3">
                  <c:v>1.3368314739774</c:v>
                </c:pt>
                <c:pt idx="4">
                  <c:v>1.80346631178161</c:v>
                </c:pt>
                <c:pt idx="5">
                  <c:v>2.2432460790151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410-4CE3-BFD1-3C8ABAA9CA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978558368"/>
        <c:axId val="697715616"/>
      </c:barChart>
      <c:catAx>
        <c:axId val="978558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7715616"/>
        <c:crosses val="autoZero"/>
        <c:auto val="1"/>
        <c:lblAlgn val="ctr"/>
        <c:lblOffset val="100"/>
        <c:noMultiLvlLbl val="0"/>
      </c:catAx>
      <c:valAx>
        <c:axId val="697715616"/>
        <c:scaling>
          <c:orientation val="minMax"/>
          <c:max val="3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8558368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149652960046661"/>
          <c:w val="0.890998152640304"/>
          <c:h val="0.7171675415573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akita islet qPCR-CHOP and ATF4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akita islet qPCR-CHOP and ATF4'!$W$3:$W$6</c:f>
                <c:numCache>
                  <c:formatCode>General</c:formatCode>
                  <c:ptCount val="4"/>
                  <c:pt idx="0">
                    <c:v>0.00346574284081685</c:v>
                  </c:pt>
                  <c:pt idx="1">
                    <c:v>0.00346574284081685</c:v>
                  </c:pt>
                  <c:pt idx="2">
                    <c:v>0.00346574284081685</c:v>
                  </c:pt>
                </c:numCache>
              </c:numRef>
            </c:plus>
            <c:minus>
              <c:numRef>
                <c:f>'[Chart in Microsoft PowerPoint]akita islet qPCR-CHOP and ATF4'!$W$3:$W$6</c:f>
                <c:numCache>
                  <c:formatCode>General</c:formatCode>
                  <c:ptCount val="4"/>
                  <c:pt idx="0">
                    <c:v>0.00346574284081685</c:v>
                  </c:pt>
                  <c:pt idx="1">
                    <c:v>0.00346574284081685</c:v>
                  </c:pt>
                  <c:pt idx="2">
                    <c:v>0.0034657428408168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Chart in Microsoft PowerPoint]akita islet qPCR-CHOP and ATF4'!$S$3</c:f>
              <c:numCache>
                <c:formatCode>General</c:formatCode>
                <c:ptCount val="1"/>
              </c:numCache>
            </c:numRef>
          </c:cat>
          <c:val>
            <c:numRef>
              <c:f>'[Chart in Microsoft PowerPoint]akita islet qPCR-CHOP and ATF4'!$T$3</c:f>
              <c:numCache>
                <c:formatCode>0.0</c:formatCode>
                <c:ptCount val="1"/>
                <c:pt idx="0">
                  <c:v>1.0000060056686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AEA-4D1D-8F94-D839188B0B7F}"/>
            </c:ext>
          </c:extLst>
        </c:ser>
        <c:ser>
          <c:idx val="1"/>
          <c:order val="1"/>
          <c:tx>
            <c:strRef>
              <c:f>'[Chart in Microsoft PowerPoint]akita islet qPCR-CHOP and ATF4'!$U$2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akita islet qPCR-CHOP and ATF4'!$X$3:$X$6</c:f>
                <c:numCache>
                  <c:formatCode>General</c:formatCode>
                  <c:ptCount val="4"/>
                  <c:pt idx="0">
                    <c:v>0.140901199868839</c:v>
                  </c:pt>
                  <c:pt idx="1">
                    <c:v>0.0729350349756863</c:v>
                  </c:pt>
                  <c:pt idx="2">
                    <c:v>0.0800894377801088</c:v>
                  </c:pt>
                </c:numCache>
              </c:numRef>
            </c:plus>
            <c:minus>
              <c:numRef>
                <c:f>'[Chart in Microsoft PowerPoint]akita islet qPCR-CHOP and ATF4'!$X$3:$X$6</c:f>
                <c:numCache>
                  <c:formatCode>General</c:formatCode>
                  <c:ptCount val="4"/>
                  <c:pt idx="0">
                    <c:v>0.140901199868839</c:v>
                  </c:pt>
                  <c:pt idx="1">
                    <c:v>0.0729350349756863</c:v>
                  </c:pt>
                  <c:pt idx="2">
                    <c:v>0.08008943778010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Chart in Microsoft PowerPoint]akita islet qPCR-CHOP and ATF4'!$S$3</c:f>
              <c:numCache>
                <c:formatCode>General</c:formatCode>
                <c:ptCount val="1"/>
              </c:numCache>
            </c:numRef>
          </c:cat>
          <c:val>
            <c:numRef>
              <c:f>'[Chart in Microsoft PowerPoint]akita islet qPCR-CHOP and ATF4'!$U$3</c:f>
              <c:numCache>
                <c:formatCode>0.0</c:formatCode>
                <c:ptCount val="1"/>
                <c:pt idx="0">
                  <c:v>3.3899107852937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AEA-4D1D-8F94-D839188B0B7F}"/>
            </c:ext>
          </c:extLst>
        </c:ser>
        <c:ser>
          <c:idx val="2"/>
          <c:order val="2"/>
          <c:tx>
            <c:strRef>
              <c:f>'[Chart in Microsoft PowerPoint]akita islet qPCR-CHOP and ATF4'!$V$2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akita islet qPCR-CHOP and ATF4'!$Y$3:$Y$6</c:f>
                <c:numCache>
                  <c:formatCode>General</c:formatCode>
                  <c:ptCount val="4"/>
                  <c:pt idx="0">
                    <c:v>0.0606372194166162</c:v>
                  </c:pt>
                  <c:pt idx="1">
                    <c:v>0.0751724278136689</c:v>
                  </c:pt>
                  <c:pt idx="2">
                    <c:v>0.0627755863412962</c:v>
                  </c:pt>
                </c:numCache>
              </c:numRef>
            </c:plus>
            <c:minus>
              <c:numRef>
                <c:f>'[Chart in Microsoft PowerPoint]akita islet qPCR-CHOP and ATF4'!$Y$3:$Y$6</c:f>
                <c:numCache>
                  <c:formatCode>General</c:formatCode>
                  <c:ptCount val="4"/>
                  <c:pt idx="0">
                    <c:v>0.0606372194166162</c:v>
                  </c:pt>
                  <c:pt idx="1">
                    <c:v>0.0751724278136689</c:v>
                  </c:pt>
                  <c:pt idx="2">
                    <c:v>0.06277558634129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Chart in Microsoft PowerPoint]akita islet qPCR-CHOP and ATF4'!$S$3</c:f>
              <c:numCache>
                <c:formatCode>General</c:formatCode>
                <c:ptCount val="1"/>
              </c:numCache>
            </c:numRef>
          </c:cat>
          <c:val>
            <c:numRef>
              <c:f>'[Chart in Microsoft PowerPoint]akita islet qPCR-CHOP and ATF4'!$V$3</c:f>
              <c:numCache>
                <c:formatCode>0.0</c:formatCode>
                <c:ptCount val="1"/>
                <c:pt idx="0">
                  <c:v>0.9221833791286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AEA-4D1D-8F94-D839188B0B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0411344"/>
        <c:axId val="950414176"/>
      </c:barChart>
      <c:catAx>
        <c:axId val="950411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414176"/>
        <c:crosses val="autoZero"/>
        <c:auto val="1"/>
        <c:lblAlgn val="ctr"/>
        <c:lblOffset val="100"/>
        <c:noMultiLvlLbl val="0"/>
      </c:catAx>
      <c:valAx>
        <c:axId val="950414176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411344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23021471813583"/>
          <c:y val="0.0570603674540683"/>
          <c:w val="0.881550264531568"/>
          <c:h val="0.809760134149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rep genes-new '!$T$5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new '!$W$67</c:f>
                <c:numCache>
                  <c:formatCode>General</c:formatCode>
                  <c:ptCount val="1"/>
                  <c:pt idx="0">
                    <c:v>0.184718657407662</c:v>
                  </c:pt>
                </c:numCache>
              </c:numRef>
            </c:plus>
            <c:minus>
              <c:numRef>
                <c:f>'akita islet qPCR-rep genes-new '!$W$6:$W$9</c:f>
                <c:numCache>
                  <c:formatCode>General</c:formatCode>
                  <c:ptCount val="4"/>
                  <c:pt idx="0">
                    <c:v>0.04160082075793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new '!$S$214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new '!$T$214</c:f>
              <c:numCache>
                <c:formatCode>0.0</c:formatCode>
                <c:ptCount val="1"/>
                <c:pt idx="0">
                  <c:v>1.0017361386432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C64-4D22-8868-BC9C18C0ACDB}"/>
            </c:ext>
          </c:extLst>
        </c:ser>
        <c:ser>
          <c:idx val="1"/>
          <c:order val="1"/>
          <c:tx>
            <c:strRef>
              <c:f>'akita islet qPCR-rep genes-new '!$U$5</c:f>
              <c:strCache>
                <c:ptCount val="1"/>
                <c:pt idx="0">
                  <c:v>Akita 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new '!$X$193</c:f>
                <c:numCache>
                  <c:formatCode>General</c:formatCode>
                  <c:ptCount val="1"/>
                  <c:pt idx="0">
                    <c:v>0.0452100247702004</c:v>
                  </c:pt>
                </c:numCache>
              </c:numRef>
            </c:plus>
            <c:minus>
              <c:numRef>
                <c:f>'akita islet qPCR-rep genes-new '!$X$6:$X$9</c:f>
                <c:numCache>
                  <c:formatCode>General</c:formatCode>
                  <c:ptCount val="4"/>
                  <c:pt idx="0">
                    <c:v>0.0952667589609253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new '!$S$214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new '!$U$214</c:f>
              <c:numCache>
                <c:formatCode>0.0</c:formatCode>
                <c:ptCount val="1"/>
                <c:pt idx="0">
                  <c:v>2.2990663963519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C64-4D22-8868-BC9C18C0ACDB}"/>
            </c:ext>
          </c:extLst>
        </c:ser>
        <c:ser>
          <c:idx val="2"/>
          <c:order val="2"/>
          <c:tx>
            <c:strRef>
              <c:f>'akita islet qPCR-rep genes-new '!$V$5</c:f>
              <c:strCache>
                <c:ptCount val="1"/>
                <c:pt idx="0">
                  <c:v>Akita 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rep genes-new '!$Y$67</c:f>
                <c:numCache>
                  <c:formatCode>General</c:formatCode>
                  <c:ptCount val="1"/>
                  <c:pt idx="0">
                    <c:v>0.0250226385389619</c:v>
                  </c:pt>
                </c:numCache>
              </c:numRef>
            </c:plus>
            <c:minus>
              <c:numRef>
                <c:f>'akita islet qPCR-rep genes-new '!$Y$6:$Y$9</c:f>
                <c:numCache>
                  <c:formatCode>General</c:formatCode>
                  <c:ptCount val="4"/>
                  <c:pt idx="0">
                    <c:v>0.0952667589609253</c:v>
                  </c:pt>
                  <c:pt idx="1">
                    <c:v>0.0</c:v>
                  </c:pt>
                  <c:pt idx="2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kita islet qPCR-rep genes-new '!$S$214</c:f>
              <c:numCache>
                <c:formatCode>General</c:formatCode>
                <c:ptCount val="1"/>
              </c:numCache>
            </c:numRef>
          </c:cat>
          <c:val>
            <c:numRef>
              <c:f>'akita islet qPCR-rep genes-new '!$V$214</c:f>
              <c:numCache>
                <c:formatCode>0.0</c:formatCode>
                <c:ptCount val="1"/>
                <c:pt idx="0">
                  <c:v>1.6142333925615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C64-4D22-8868-BC9C18C0AC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70"/>
        <c:axId val="950320048"/>
        <c:axId val="950300112"/>
      </c:barChart>
      <c:catAx>
        <c:axId val="950320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300112"/>
        <c:crosses val="autoZero"/>
        <c:auto val="1"/>
        <c:lblAlgn val="ctr"/>
        <c:lblOffset val="100"/>
        <c:noMultiLvlLbl val="0"/>
      </c:catAx>
      <c:valAx>
        <c:axId val="950300112"/>
        <c:scaling>
          <c:orientation val="minMax"/>
          <c:max val="2.5"/>
          <c:min val="0.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0320048"/>
        <c:crosses val="autoZero"/>
        <c:crossBetween val="between"/>
        <c:maj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13646705776728"/>
          <c:y val="0.89100027584404"/>
          <c:w val="0.890998152640304"/>
          <c:h val="0.0238369702749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kita islet qPCR-INS1 and INS2'!$T$2</c:f>
              <c:strCache>
                <c:ptCount val="1"/>
                <c:pt idx="0">
                  <c:v>WT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3EB-462D-8545-813354962AB8}"/>
              </c:ext>
            </c:extLst>
          </c:dPt>
          <c:errBars>
            <c:errBarType val="plus"/>
            <c:errValType val="cust"/>
            <c:noEndCap val="0"/>
            <c:plus>
              <c:numRef>
                <c:f>'akita islet qPCR-INS1 and INS2'!$W$3:$W$6</c:f>
                <c:numCache>
                  <c:formatCode>General</c:formatCode>
                  <c:ptCount val="4"/>
                  <c:pt idx="0">
                    <c:v>0.0311966811831468</c:v>
                  </c:pt>
                  <c:pt idx="1">
                    <c:v>0.0311966811831468</c:v>
                  </c:pt>
                  <c:pt idx="2">
                    <c:v>0.0311966811831468</c:v>
                  </c:pt>
                </c:numCache>
              </c:numRef>
            </c:plus>
            <c:minus>
              <c:numRef>
                <c:f>'akita islet qPCR-INS1 and INS2'!$W$3:$W$6</c:f>
                <c:numCache>
                  <c:formatCode>General</c:formatCode>
                  <c:ptCount val="4"/>
                  <c:pt idx="0">
                    <c:v>0.0311966811831468</c:v>
                  </c:pt>
                  <c:pt idx="1">
                    <c:v>0.0311966811831468</c:v>
                  </c:pt>
                  <c:pt idx="2">
                    <c:v>0.03119668118314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T$4</c:f>
              <c:numCache>
                <c:formatCode>0.00</c:formatCode>
                <c:ptCount val="1"/>
                <c:pt idx="0">
                  <c:v>1.0004864981182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3EB-462D-8545-813354962AB8}"/>
            </c:ext>
          </c:extLst>
        </c:ser>
        <c:ser>
          <c:idx val="1"/>
          <c:order val="1"/>
          <c:tx>
            <c:strRef>
              <c:f>'akita islet qPCR-INS1 and INS2'!$U$2</c:f>
              <c:strCache>
                <c:ptCount val="1"/>
                <c:pt idx="0">
                  <c:v>Akita-Vehic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INS1 and INS2'!$X$3:$X$6</c:f>
                <c:numCache>
                  <c:formatCode>General</c:formatCode>
                  <c:ptCount val="4"/>
                  <c:pt idx="0">
                    <c:v>0.0801848214143921</c:v>
                  </c:pt>
                  <c:pt idx="1">
                    <c:v>0.0415062665174025</c:v>
                  </c:pt>
                  <c:pt idx="2">
                    <c:v>0.0455777329898896</c:v>
                  </c:pt>
                </c:numCache>
              </c:numRef>
            </c:plus>
            <c:minus>
              <c:numRef>
                <c:f>'akita islet qPCR-INS1 and INS2'!$X$3:$X$6</c:f>
                <c:numCache>
                  <c:formatCode>General</c:formatCode>
                  <c:ptCount val="4"/>
                  <c:pt idx="0">
                    <c:v>0.0801848214143921</c:v>
                  </c:pt>
                  <c:pt idx="1">
                    <c:v>0.0415062665174025</c:v>
                  </c:pt>
                  <c:pt idx="2">
                    <c:v>0.04557773298988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U$4</c:f>
              <c:numCache>
                <c:formatCode>0.00</c:formatCode>
                <c:ptCount val="1"/>
                <c:pt idx="0">
                  <c:v>0.3169825454865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3EB-462D-8545-813354962AB8}"/>
            </c:ext>
          </c:extLst>
        </c:ser>
        <c:ser>
          <c:idx val="2"/>
          <c:order val="2"/>
          <c:tx>
            <c:strRef>
              <c:f>'akita islet qPCR-INS1 and INS2'!$V$2</c:f>
              <c:strCache>
                <c:ptCount val="1"/>
                <c:pt idx="0">
                  <c:v>Akita-ST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kita islet qPCR-INS1 and INS2'!$Y$3:$Y$6</c:f>
                <c:numCache>
                  <c:formatCode>General</c:formatCode>
                  <c:ptCount val="4"/>
                  <c:pt idx="0">
                    <c:v>0.0325129551459309</c:v>
                  </c:pt>
                  <c:pt idx="1">
                    <c:v>0.0403065608421814</c:v>
                  </c:pt>
                  <c:pt idx="2">
                    <c:v>0.0336595220330104</c:v>
                  </c:pt>
                </c:numCache>
              </c:numRef>
            </c:plus>
            <c:minus>
              <c:numRef>
                <c:f>'akita islet qPCR-INS1 and INS2'!$Y$3:$Y$6</c:f>
                <c:numCache>
                  <c:formatCode>General</c:formatCode>
                  <c:ptCount val="4"/>
                  <c:pt idx="0">
                    <c:v>0.0325129551459309</c:v>
                  </c:pt>
                  <c:pt idx="1">
                    <c:v>0.0403065608421814</c:v>
                  </c:pt>
                  <c:pt idx="2">
                    <c:v>0.0336595220330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kita islet qPCR-INS1 and INS2'!$S$4</c:f>
              <c:numCache>
                <c:formatCode>General</c:formatCode>
                <c:ptCount val="1"/>
              </c:numCache>
            </c:numRef>
          </c:cat>
          <c:val>
            <c:numRef>
              <c:f>'akita islet qPCR-INS1 and INS2'!$V$4</c:f>
              <c:numCache>
                <c:formatCode>0.00</c:formatCode>
                <c:ptCount val="1"/>
                <c:pt idx="0">
                  <c:v>1.0577862529448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3EB-462D-8545-813354962A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30"/>
        <c:axId val="869188352"/>
        <c:axId val="869201024"/>
      </c:barChart>
      <c:catAx>
        <c:axId val="8691883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69201024"/>
        <c:crosses val="autoZero"/>
        <c:auto val="1"/>
        <c:lblAlgn val="ctr"/>
        <c:lblOffset val="100"/>
        <c:noMultiLvlLbl val="0"/>
      </c:catAx>
      <c:valAx>
        <c:axId val="869201024"/>
        <c:scaling>
          <c:orientation val="minMax"/>
        </c:scaling>
        <c:delete val="1"/>
        <c:axPos val="l"/>
        <c:numFmt formatCode="0.00" sourceLinked="1"/>
        <c:majorTickMark val="out"/>
        <c:minorTickMark val="none"/>
        <c:tickLblPos val="nextTo"/>
        <c:crossAx val="869188352"/>
        <c:crosses val="autoZero"/>
        <c:crossBetween val="between"/>
      </c:valAx>
      <c:spPr>
        <a:solidFill>
          <a:schemeClr val="bg1"/>
        </a:solidFill>
        <a:ln>
          <a:solidFill>
            <a:schemeClr val="bg1"/>
          </a:solidFill>
        </a:ln>
        <a:effectLst/>
      </c:spPr>
    </c:plotArea>
    <c:legend>
      <c:legendPos val="r"/>
      <c:layout>
        <c:manualLayout>
          <c:xMode val="edge"/>
          <c:yMode val="edge"/>
          <c:x val="0.0223572083873225"/>
          <c:y val="0.0150215077282006"/>
          <c:w val="0.927189095694427"/>
          <c:h val="0.92852755989516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7657</cdr:x>
      <cdr:y>0</cdr:y>
    </cdr:from>
    <cdr:to>
      <cdr:x>0.75074</cdr:x>
      <cdr:y>0.1371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07543" y="-15903"/>
          <a:ext cx="407048" cy="2205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1" dirty="0">
              <a:solidFill>
                <a:schemeClr val="tx1"/>
              </a:solidFill>
            </a:rPr>
            <a:t>INS1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5EA18B-0B5B-4029-87CB-6F4E8440EF32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FB2C7F-32FA-459D-BAAE-B9DB5C5C6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106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AD9FDF-9977-422D-B0AF-6E8F07B9C8E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7425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533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438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3"/>
            <a:ext cx="1748790" cy="858223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3"/>
            <a:ext cx="5116830" cy="858223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48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640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574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75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183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702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910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803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756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64DD7-0B11-4FB0-9CBE-7253A4A326E1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E50598-531A-4D51-ACDA-070F8DDD42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831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4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7.png"/><Relationship Id="rId12" Type="http://schemas.microsoft.com/office/2007/relationships/hdphoto" Target="../media/hdphoto4.wdp"/><Relationship Id="rId13" Type="http://schemas.openxmlformats.org/officeDocument/2006/relationships/image" Target="../media/image8.png"/><Relationship Id="rId14" Type="http://schemas.openxmlformats.org/officeDocument/2006/relationships/image" Target="../media/image9.tiff"/><Relationship Id="rId15" Type="http://schemas.openxmlformats.org/officeDocument/2006/relationships/image" Target="../media/image10.tiff"/><Relationship Id="rId16" Type="http://schemas.openxmlformats.org/officeDocument/2006/relationships/image" Target="../media/image11.tiff"/><Relationship Id="rId17" Type="http://schemas.openxmlformats.org/officeDocument/2006/relationships/image" Target="../media/image12.tiff"/><Relationship Id="rId18" Type="http://schemas.openxmlformats.org/officeDocument/2006/relationships/chart" Target="../charts/chart10.xml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3" Type="http://schemas.openxmlformats.org/officeDocument/2006/relationships/image" Target="../media/image2.png"/><Relationship Id="rId4" Type="http://schemas.microsoft.com/office/2007/relationships/hdphoto" Target="../media/hdphoto1.wdp"/><Relationship Id="rId5" Type="http://schemas.openxmlformats.org/officeDocument/2006/relationships/image" Target="../media/image3.png"/><Relationship Id="rId6" Type="http://schemas.microsoft.com/office/2007/relationships/hdphoto" Target="../media/hdphoto2.wdp"/><Relationship Id="rId7" Type="http://schemas.openxmlformats.org/officeDocument/2006/relationships/image" Target="../media/image4.png"/><Relationship Id="rId8" Type="http://schemas.microsoft.com/office/2007/relationships/hdphoto" Target="../media/hdphoto3.wdp"/><Relationship Id="rId9" Type="http://schemas.openxmlformats.org/officeDocument/2006/relationships/image" Target="../media/image5.tiff"/><Relationship Id="rId10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microsoft.com/office/2007/relationships/hdphoto" Target="../media/hdphoto5.wdp"/><Relationship Id="rId5" Type="http://schemas.openxmlformats.org/officeDocument/2006/relationships/image" Target="../media/image14.png"/><Relationship Id="rId6" Type="http://schemas.microsoft.com/office/2007/relationships/hdphoto" Target="../media/hdphoto6.wdp"/><Relationship Id="rId7" Type="http://schemas.openxmlformats.org/officeDocument/2006/relationships/image" Target="../media/image15.tif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8.tiff"/><Relationship Id="rId11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4" Type="http://schemas.openxmlformats.org/officeDocument/2006/relationships/chart" Target="../charts/chart14.xml"/><Relationship Id="rId5" Type="http://schemas.openxmlformats.org/officeDocument/2006/relationships/chart" Target="../charts/chart15.xml"/><Relationship Id="rId6" Type="http://schemas.openxmlformats.org/officeDocument/2006/relationships/chart" Target="../charts/chart16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8.xml"/></Relationships>
</file>

<file path=ppt/slides/_rels/slide8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27.xml"/><Relationship Id="rId12" Type="http://schemas.openxmlformats.org/officeDocument/2006/relationships/chart" Target="../charts/chart28.xml"/><Relationship Id="rId13" Type="http://schemas.openxmlformats.org/officeDocument/2006/relationships/chart" Target="../charts/chart29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9.xml"/><Relationship Id="rId4" Type="http://schemas.openxmlformats.org/officeDocument/2006/relationships/chart" Target="../charts/chart20.xml"/><Relationship Id="rId5" Type="http://schemas.openxmlformats.org/officeDocument/2006/relationships/chart" Target="../charts/chart21.xml"/><Relationship Id="rId6" Type="http://schemas.openxmlformats.org/officeDocument/2006/relationships/chart" Target="../charts/chart22.xml"/><Relationship Id="rId7" Type="http://schemas.openxmlformats.org/officeDocument/2006/relationships/chart" Target="../charts/chart23.xml"/><Relationship Id="rId8" Type="http://schemas.openxmlformats.org/officeDocument/2006/relationships/chart" Target="../charts/chart24.xml"/><Relationship Id="rId9" Type="http://schemas.openxmlformats.org/officeDocument/2006/relationships/chart" Target="../charts/chart25.xml"/><Relationship Id="rId10" Type="http://schemas.openxmlformats.org/officeDocument/2006/relationships/chart" Target="../charts/chart2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EEF2272A-E17E-614E-AFD4-86C9EEB5BB4D}"/>
              </a:ext>
            </a:extLst>
          </p:cNvPr>
          <p:cNvGrpSpPr/>
          <p:nvPr/>
        </p:nvGrpSpPr>
        <p:grpSpPr>
          <a:xfrm>
            <a:off x="1156219" y="5791147"/>
            <a:ext cx="2514599" cy="1976255"/>
            <a:chOff x="6657899" y="207104"/>
            <a:chExt cx="2514599" cy="197625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xmlns="" id="{A66FE253-39A5-A44C-A7DB-E598A9A8E1CC}"/>
                </a:ext>
              </a:extLst>
            </p:cNvPr>
            <p:cNvGrpSpPr/>
            <p:nvPr/>
          </p:nvGrpSpPr>
          <p:grpSpPr>
            <a:xfrm>
              <a:off x="6657899" y="207104"/>
              <a:ext cx="2514599" cy="1976255"/>
              <a:chOff x="6843254" y="46463"/>
              <a:chExt cx="2514599" cy="1976255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xmlns="" id="{227E37DD-F749-E44C-A60D-D5E47D88DAAC}"/>
                  </a:ext>
                </a:extLst>
              </p:cNvPr>
              <p:cNvSpPr txBox="1"/>
              <p:nvPr/>
            </p:nvSpPr>
            <p:spPr>
              <a:xfrm>
                <a:off x="6843254" y="103704"/>
                <a:ext cx="3064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/>
                  <a:t>C</a:t>
                </a:r>
                <a:endParaRPr lang="en-US" b="1" dirty="0"/>
              </a:p>
            </p:txBody>
          </p: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xmlns="" id="{F4CAAC24-1FFF-0740-B87A-D3DB4C2B99CB}"/>
                  </a:ext>
                </a:extLst>
              </p:cNvPr>
              <p:cNvGrpSpPr/>
              <p:nvPr/>
            </p:nvGrpSpPr>
            <p:grpSpPr>
              <a:xfrm>
                <a:off x="6943651" y="46463"/>
                <a:ext cx="2414202" cy="1976255"/>
                <a:chOff x="7369515" y="62307"/>
                <a:chExt cx="2414202" cy="1976255"/>
              </a:xfrm>
            </p:grpSpPr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xmlns="" id="{727FBC6B-0E76-7248-BA31-BE7923267D90}"/>
                    </a:ext>
                  </a:extLst>
                </p:cNvPr>
                <p:cNvSpPr txBox="1"/>
                <p:nvPr/>
              </p:nvSpPr>
              <p:spPr>
                <a:xfrm rot="16200000">
                  <a:off x="6972657" y="888456"/>
                  <a:ext cx="12490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mRNA (fold change)</a:t>
                  </a:r>
                </a:p>
              </p:txBody>
            </p:sp>
            <p:sp>
              <p:nvSpPr>
                <p:cNvPr id="15" name="TextBox 1">
                  <a:extLst>
                    <a:ext uri="{FF2B5EF4-FFF2-40B4-BE49-F238E27FC236}">
                      <a16:creationId xmlns:a16="http://schemas.microsoft.com/office/drawing/2014/main" xmlns="" id="{B213B8AE-26D6-AF47-BCBC-EC361793F893}"/>
                    </a:ext>
                  </a:extLst>
                </p:cNvPr>
                <p:cNvSpPr txBox="1"/>
                <p:nvPr/>
              </p:nvSpPr>
              <p:spPr>
                <a:xfrm>
                  <a:off x="7369515" y="1792284"/>
                  <a:ext cx="460131" cy="246278"/>
                </a:xfrm>
                <a:prstGeom prst="rect">
                  <a:avLst/>
                </a:prstGeom>
              </p:spPr>
              <p:txBody>
                <a:bodyPr wrap="non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dirty="0"/>
                    <a:t>Age (weeks)</a:t>
                  </a:r>
                </a:p>
              </p:txBody>
            </p:sp>
            <p:graphicFrame>
              <p:nvGraphicFramePr>
                <p:cNvPr id="16" name="Chart 15">
                  <a:extLst>
                    <a:ext uri="{FF2B5EF4-FFF2-40B4-BE49-F238E27FC236}">
                      <a16:creationId xmlns:a16="http://schemas.microsoft.com/office/drawing/2014/main" xmlns="" id="{B224F3B8-BBB8-024E-9B83-B22331BEA924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7800827" y="62307"/>
                <a:ext cx="1982890" cy="197185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</p:grpSp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xmlns="" id="{0180F136-C17A-0C43-A575-179C62DBE48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19427201"/>
                  </p:ext>
                </p:extLst>
              </p:nvPr>
            </p:nvGraphicFramePr>
            <p:xfrm>
              <a:off x="7362621" y="178035"/>
              <a:ext cx="1815307" cy="18362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xmlns="" id="{88944AF0-CA9E-BA4C-87BA-AA6ABE8615BB}"/>
                  </a:ext>
                </a:extLst>
              </p:cNvPr>
              <p:cNvSpPr txBox="1"/>
              <p:nvPr/>
            </p:nvSpPr>
            <p:spPr>
              <a:xfrm>
                <a:off x="7901601" y="1398259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FA6933B7-FFE6-9645-985C-F4733FCDF972}"/>
                  </a:ext>
                </a:extLst>
              </p:cNvPr>
              <p:cNvSpPr txBox="1"/>
              <p:nvPr/>
            </p:nvSpPr>
            <p:spPr>
              <a:xfrm>
                <a:off x="8159412" y="1240024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xmlns="" id="{F4C1B4FD-E2AF-BF4D-9780-8EDB41DE9B89}"/>
                  </a:ext>
                </a:extLst>
              </p:cNvPr>
              <p:cNvSpPr txBox="1"/>
              <p:nvPr/>
            </p:nvSpPr>
            <p:spPr>
              <a:xfrm>
                <a:off x="8390290" y="801290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1BBC2E76-B1F8-C248-87D7-51793EC9858A}"/>
                  </a:ext>
                </a:extLst>
              </p:cNvPr>
              <p:cNvSpPr txBox="1"/>
              <p:nvPr/>
            </p:nvSpPr>
            <p:spPr>
              <a:xfrm>
                <a:off x="8649246" y="458871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xmlns="" id="{3DD48E78-5D02-8146-BB07-D6CF7BCD66F1}"/>
                  </a:ext>
                </a:extLst>
              </p:cNvPr>
              <p:cNvSpPr txBox="1"/>
              <p:nvPr/>
            </p:nvSpPr>
            <p:spPr>
              <a:xfrm>
                <a:off x="8935554" y="1274059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</a:t>
                </a:r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xmlns="" id="{66A2CF01-EF21-E84A-BC65-BF8747CDE5E7}"/>
                  </a:ext>
                </a:extLst>
              </p:cNvPr>
              <p:cNvCxnSpPr/>
              <p:nvPr/>
            </p:nvCxnSpPr>
            <p:spPr>
              <a:xfrm>
                <a:off x="7616720" y="1656779"/>
                <a:ext cx="1531620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xmlns="" id="{5B8DDA4C-6DF8-6D4D-9EBE-8176702E1C43}"/>
                </a:ext>
              </a:extLst>
            </p:cNvPr>
            <p:cNvSpPr/>
            <p:nvPr/>
          </p:nvSpPr>
          <p:spPr>
            <a:xfrm>
              <a:off x="8000695" y="406028"/>
              <a:ext cx="4283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Bip 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9F8DF5D8-AA70-FB4E-8C0C-B0F413C125BD}"/>
              </a:ext>
            </a:extLst>
          </p:cNvPr>
          <p:cNvGrpSpPr/>
          <p:nvPr/>
        </p:nvGrpSpPr>
        <p:grpSpPr>
          <a:xfrm>
            <a:off x="3934961" y="3103073"/>
            <a:ext cx="2526519" cy="2217891"/>
            <a:chOff x="6712072" y="2055775"/>
            <a:chExt cx="2526519" cy="2217891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xmlns="" id="{F7D53A8F-31B2-6B47-9D19-DABC05CC5336}"/>
                </a:ext>
              </a:extLst>
            </p:cNvPr>
            <p:cNvGrpSpPr/>
            <p:nvPr/>
          </p:nvGrpSpPr>
          <p:grpSpPr>
            <a:xfrm>
              <a:off x="6712072" y="2055775"/>
              <a:ext cx="2526519" cy="2217891"/>
              <a:chOff x="7083289" y="1920157"/>
              <a:chExt cx="2526519" cy="2217891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7083289" y="2077293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</a:t>
                </a:r>
              </a:p>
            </p:txBody>
          </p:sp>
          <p:grpSp>
            <p:nvGrpSpPr>
              <p:cNvPr id="21" name="Group 20"/>
              <p:cNvGrpSpPr/>
              <p:nvPr/>
            </p:nvGrpSpPr>
            <p:grpSpPr>
              <a:xfrm>
                <a:off x="7208500" y="1920157"/>
                <a:ext cx="2153190" cy="2217891"/>
                <a:chOff x="7456428" y="1920157"/>
                <a:chExt cx="2153190" cy="2217891"/>
              </a:xfrm>
            </p:grpSpPr>
            <p:sp>
              <p:nvSpPr>
                <p:cNvPr id="27" name="TextBox 26"/>
                <p:cNvSpPr txBox="1"/>
                <p:nvPr/>
              </p:nvSpPr>
              <p:spPr>
                <a:xfrm rot="16200000">
                  <a:off x="6984447" y="2933423"/>
                  <a:ext cx="146309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mRNA (fold change)</a:t>
                  </a:r>
                </a:p>
              </p:txBody>
            </p:sp>
            <p:graphicFrame>
              <p:nvGraphicFramePr>
                <p:cNvPr id="28" name="Chart 27">
                  <a:extLst>
                    <a:ext uri="{FF2B5EF4-FFF2-40B4-BE49-F238E27FC236}">
                      <a16:creationId xmlns:a16="http://schemas.microsoft.com/office/drawing/2014/main" xmlns="" id="{1A01B723-6DE5-44B1-8B58-A299E5D15A8C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7740589" y="1920157"/>
                <a:ext cx="1869029" cy="215365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29" name="TextBox 1"/>
                <p:cNvSpPr txBox="1"/>
                <p:nvPr/>
              </p:nvSpPr>
              <p:spPr>
                <a:xfrm>
                  <a:off x="7456428" y="3891770"/>
                  <a:ext cx="460131" cy="246278"/>
                </a:xfrm>
                <a:prstGeom prst="rect">
                  <a:avLst/>
                </a:prstGeom>
              </p:spPr>
              <p:txBody>
                <a:bodyPr wrap="non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/>
                    <a:t>Age (weeks)</a:t>
                  </a:r>
                </a:p>
              </p:txBody>
            </p:sp>
          </p:grpSp>
          <p:graphicFrame>
            <p:nvGraphicFramePr>
              <p:cNvPr id="22" name="Chart 21">
                <a:extLst>
                  <a:ext uri="{FF2B5EF4-FFF2-40B4-BE49-F238E27FC236}">
                    <a16:creationId xmlns:a16="http://schemas.microsoft.com/office/drawing/2014/main" xmlns="" id="{6B462379-F87A-4846-9E71-A920C4EBB31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23498390"/>
                  </p:ext>
                </p:extLst>
              </p:nvPr>
            </p:nvGraphicFramePr>
            <p:xfrm>
              <a:off x="7669950" y="2116451"/>
              <a:ext cx="1896983" cy="201719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3" name="TextBox 22"/>
              <p:cNvSpPr txBox="1"/>
              <p:nvPr/>
            </p:nvSpPr>
            <p:spPr>
              <a:xfrm>
                <a:off x="9258430" y="2328941"/>
                <a:ext cx="35137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dirty="0"/>
                  <a:t>**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037592" y="2872437"/>
                <a:ext cx="26802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dirty="0"/>
                  <a:t>*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787952" y="3102250"/>
                <a:ext cx="26802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dirty="0"/>
                  <a:t>*</a:t>
                </a: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8050442" y="3641565"/>
                <a:ext cx="1389040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283FE59E-C522-8240-B74B-A1FB3C050DC6}"/>
                </a:ext>
              </a:extLst>
            </p:cNvPr>
            <p:cNvSpPr/>
            <p:nvPr/>
          </p:nvSpPr>
          <p:spPr>
            <a:xfrm>
              <a:off x="8128523" y="2343301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CHOP 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1142124" y="2896322"/>
            <a:ext cx="2495507" cy="2361462"/>
            <a:chOff x="3760344" y="2903408"/>
            <a:chExt cx="2495507" cy="2361462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xmlns="" id="{3AC4ABDE-01AA-004C-A0BC-D46B03FBB464}"/>
                </a:ext>
              </a:extLst>
            </p:cNvPr>
            <p:cNvGrpSpPr/>
            <p:nvPr/>
          </p:nvGrpSpPr>
          <p:grpSpPr>
            <a:xfrm>
              <a:off x="3871922" y="2903408"/>
              <a:ext cx="2383929" cy="2361462"/>
              <a:chOff x="9472048" y="2004714"/>
              <a:chExt cx="2383929" cy="2361462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xmlns="" id="{1FA5AF04-5182-854C-ACF9-DE02A7BB1AFA}"/>
                  </a:ext>
                </a:extLst>
              </p:cNvPr>
              <p:cNvGrpSpPr/>
              <p:nvPr/>
            </p:nvGrpSpPr>
            <p:grpSpPr>
              <a:xfrm>
                <a:off x="9472048" y="2004714"/>
                <a:ext cx="2383929" cy="2361462"/>
                <a:chOff x="9607983" y="1722051"/>
                <a:chExt cx="2383929" cy="2361462"/>
              </a:xfrm>
            </p:grpSpPr>
            <p:grpSp>
              <p:nvGrpSpPr>
                <p:cNvPr id="33" name="Group 32"/>
                <p:cNvGrpSpPr/>
                <p:nvPr/>
              </p:nvGrpSpPr>
              <p:grpSpPr>
                <a:xfrm>
                  <a:off x="9607983" y="1722051"/>
                  <a:ext cx="2184446" cy="2361462"/>
                  <a:chOff x="11813657" y="1667271"/>
                  <a:chExt cx="2184446" cy="2361462"/>
                </a:xfrm>
              </p:grpSpPr>
              <p:graphicFrame>
                <p:nvGraphicFramePr>
                  <p:cNvPr id="39" name="Chart 38">
                    <a:extLst>
                      <a:ext uri="{FF2B5EF4-FFF2-40B4-BE49-F238E27FC236}">
                        <a16:creationId xmlns:a16="http://schemas.microsoft.com/office/drawing/2014/main" xmlns="" id="{6B462379-F87A-4846-9E71-A920C4EBB31E}"/>
                      </a:ext>
                    </a:extLst>
                  </p:cNvPr>
                  <p:cNvGraphicFramePr>
                    <a:graphicFrameLocks/>
                  </p:cNvGraphicFramePr>
                  <p:nvPr>
                    <p:extLst/>
                  </p:nvPr>
                </p:nvGraphicFramePr>
                <p:xfrm>
                  <a:off x="12052265" y="1937204"/>
                  <a:ext cx="1945838" cy="2091529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sp>
                <p:nvSpPr>
                  <p:cNvPr id="40" name="TextBox 39"/>
                  <p:cNvSpPr txBox="1"/>
                  <p:nvPr/>
                </p:nvSpPr>
                <p:spPr>
                  <a:xfrm rot="16200000">
                    <a:off x="11099320" y="2500758"/>
                    <a:ext cx="194397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/>
                      <a:t>mRNA (fold change)</a:t>
                    </a:r>
                  </a:p>
                </p:txBody>
              </p:sp>
              <p:sp>
                <p:nvSpPr>
                  <p:cNvPr id="41" name="TextBox 1"/>
                  <p:cNvSpPr txBox="1"/>
                  <p:nvPr/>
                </p:nvSpPr>
                <p:spPr>
                  <a:xfrm>
                    <a:off x="11813657" y="3781233"/>
                    <a:ext cx="460131" cy="246278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200" dirty="0"/>
                      <a:t>Age (weeks)</a:t>
                    </a:r>
                  </a:p>
                </p:txBody>
              </p:sp>
            </p:grpSp>
            <p:graphicFrame>
              <p:nvGraphicFramePr>
                <p:cNvPr id="34" name="Chart 33">
                  <a:extLst>
                    <a:ext uri="{FF2B5EF4-FFF2-40B4-BE49-F238E27FC236}">
                      <a16:creationId xmlns:a16="http://schemas.microsoft.com/office/drawing/2014/main" xmlns="" id="{6B462379-F87A-4846-9E71-A920C4EBB31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89917549"/>
                    </p:ext>
                  </p:extLst>
                </p:nvPr>
              </p:nvGraphicFramePr>
              <p:xfrm>
                <a:off x="10103433" y="2063191"/>
                <a:ext cx="1877118" cy="201719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35" name="TextBox 34"/>
                <p:cNvSpPr txBox="1"/>
                <p:nvPr/>
              </p:nvSpPr>
              <p:spPr>
                <a:xfrm>
                  <a:off x="11736714" y="2298898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*</a:t>
                  </a: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11224080" y="2923713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*</a:t>
                  </a: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11470374" y="2663495"/>
                  <a:ext cx="2551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*</a:t>
                  </a:r>
                </a:p>
              </p:txBody>
            </p:sp>
            <p:cxnSp>
              <p:nvCxnSpPr>
                <p:cNvPr id="38" name="Straight Connector 37"/>
                <p:cNvCxnSpPr/>
                <p:nvPr/>
              </p:nvCxnSpPr>
              <p:spPr>
                <a:xfrm>
                  <a:off x="10451262" y="3302969"/>
                  <a:ext cx="13890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xmlns="" id="{1FFA026F-A017-3944-8BC8-5A64518F91E0}"/>
                  </a:ext>
                </a:extLst>
              </p:cNvPr>
              <p:cNvSpPr/>
              <p:nvPr/>
            </p:nvSpPr>
            <p:spPr>
              <a:xfrm>
                <a:off x="10878042" y="2515080"/>
                <a:ext cx="52687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/>
                  <a:t>ATF4 </a:t>
                </a:r>
                <a:endParaRPr lang="en-US" sz="1200" dirty="0"/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3760344" y="320018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0034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2</a:t>
            </a:r>
            <a:endParaRPr lang="en-US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8E3B94AD-602E-AC46-963B-33B6CDABA1A0}"/>
              </a:ext>
            </a:extLst>
          </p:cNvPr>
          <p:cNvGrpSpPr/>
          <p:nvPr/>
        </p:nvGrpSpPr>
        <p:grpSpPr>
          <a:xfrm>
            <a:off x="2743200" y="3048000"/>
            <a:ext cx="1635805" cy="1603270"/>
            <a:chOff x="299985" y="4173962"/>
            <a:chExt cx="1635805" cy="1603270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C181C9CC-2AC7-4955-BC03-3498271B66FE}"/>
                </a:ext>
              </a:extLst>
            </p:cNvPr>
            <p:cNvSpPr txBox="1"/>
            <p:nvPr/>
          </p:nvSpPr>
          <p:spPr>
            <a:xfrm>
              <a:off x="299985" y="4173962"/>
              <a:ext cx="1719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B</a:t>
              </a:r>
              <a:endParaRPr lang="en-US" sz="1400" b="1" dirty="0"/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xmlns="" id="{C40F676A-7F35-EB48-AC5D-75758424E3E0}"/>
                </a:ext>
              </a:extLst>
            </p:cNvPr>
            <p:cNvGrpSpPr/>
            <p:nvPr/>
          </p:nvGrpSpPr>
          <p:grpSpPr>
            <a:xfrm>
              <a:off x="436768" y="4312097"/>
              <a:ext cx="1499022" cy="1465135"/>
              <a:chOff x="2736711" y="4419083"/>
              <a:chExt cx="1499022" cy="1465135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2736711" y="4419083"/>
                <a:ext cx="1254720" cy="1351098"/>
                <a:chOff x="4285318" y="2471954"/>
                <a:chExt cx="1968186" cy="2119368"/>
              </a:xfrm>
            </p:grpSpPr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xmlns="" id="{74517186-85C7-47EF-8B46-04020054D94A}"/>
                    </a:ext>
                  </a:extLst>
                </p:cNvPr>
                <p:cNvSpPr txBox="1"/>
                <p:nvPr/>
              </p:nvSpPr>
              <p:spPr>
                <a:xfrm rot="16200000">
                  <a:off x="3501191" y="3416138"/>
                  <a:ext cx="1959311" cy="39105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mRNA (fold change)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5435785" y="2471954"/>
                  <a:ext cx="817719" cy="4103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CHOP</a:t>
                  </a:r>
                </a:p>
              </p:txBody>
            </p:sp>
          </p:grpSp>
          <p:graphicFrame>
            <p:nvGraphicFramePr>
              <p:cNvPr id="27" name="Chart 26">
                <a:extLst>
                  <a:ext uri="{FF2B5EF4-FFF2-40B4-BE49-F238E27FC236}">
                    <a16:creationId xmlns:a16="http://schemas.microsoft.com/office/drawing/2014/main" xmlns="" id="{6B462379-F87A-4846-9E71-A920C4EBB31E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2968317" y="4428234"/>
              <a:ext cx="1227358" cy="14559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8" name="TextBox 27"/>
              <p:cNvSpPr txBox="1"/>
              <p:nvPr/>
            </p:nvSpPr>
            <p:spPr>
              <a:xfrm flipH="1">
                <a:off x="3830717" y="5247386"/>
                <a:ext cx="4050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***</a:t>
                </a:r>
              </a:p>
            </p:txBody>
          </p:sp>
        </p:grp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xmlns="" id="{6AA5C337-4994-6A41-9F42-9A4FBD68FEF4}"/>
              </a:ext>
            </a:extLst>
          </p:cNvPr>
          <p:cNvGrpSpPr/>
          <p:nvPr/>
        </p:nvGrpSpPr>
        <p:grpSpPr>
          <a:xfrm>
            <a:off x="786534" y="3093831"/>
            <a:ext cx="1575666" cy="1543220"/>
            <a:chOff x="4138772" y="4329502"/>
            <a:chExt cx="1575666" cy="1543220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405E4219-D680-4AA4-AD17-3DDB143B090A}"/>
                </a:ext>
              </a:extLst>
            </p:cNvPr>
            <p:cNvSpPr txBox="1"/>
            <p:nvPr/>
          </p:nvSpPr>
          <p:spPr>
            <a:xfrm>
              <a:off x="4138772" y="4329502"/>
              <a:ext cx="1719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A</a:t>
              </a:r>
              <a:endParaRPr lang="en-US" sz="1400" b="1" dirty="0"/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xmlns="" id="{9295D01C-B376-7247-A101-71AB701DD25E}"/>
                </a:ext>
              </a:extLst>
            </p:cNvPr>
            <p:cNvGrpSpPr/>
            <p:nvPr/>
          </p:nvGrpSpPr>
          <p:grpSpPr>
            <a:xfrm>
              <a:off x="4270304" y="4407278"/>
              <a:ext cx="1444134" cy="1465444"/>
              <a:chOff x="4328398" y="4357617"/>
              <a:chExt cx="1444134" cy="1465444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xmlns="" id="{674CE659-8FF7-4833-B952-24AE0EDD31AF}"/>
                  </a:ext>
                </a:extLst>
              </p:cNvPr>
              <p:cNvGrpSpPr/>
              <p:nvPr/>
            </p:nvGrpSpPr>
            <p:grpSpPr>
              <a:xfrm>
                <a:off x="4328398" y="4357617"/>
                <a:ext cx="1195244" cy="1346702"/>
                <a:chOff x="4759601" y="2530033"/>
                <a:chExt cx="1874894" cy="2112472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5887182" y="2530033"/>
                  <a:ext cx="747313" cy="41036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ATF4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xmlns="" id="{1AB557C3-F9DE-4976-854A-E7147C5BE2AD}"/>
                    </a:ext>
                  </a:extLst>
                </p:cNvPr>
                <p:cNvSpPr txBox="1"/>
                <p:nvPr/>
              </p:nvSpPr>
              <p:spPr>
                <a:xfrm rot="16200000">
                  <a:off x="3975475" y="3467321"/>
                  <a:ext cx="1959310" cy="39105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mRNA (fold change)</a:t>
                  </a:r>
                </a:p>
              </p:txBody>
            </p:sp>
          </p:grpSp>
          <p:graphicFrame>
            <p:nvGraphicFramePr>
              <p:cNvPr id="35" name="Chart 34">
                <a:extLst>
                  <a:ext uri="{FF2B5EF4-FFF2-40B4-BE49-F238E27FC236}">
                    <a16:creationId xmlns:a16="http://schemas.microsoft.com/office/drawing/2014/main" xmlns="" id="{37FF07E7-BF83-48F2-B67B-60FF66BCD5B2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4556620" y="4478777"/>
              <a:ext cx="1179723" cy="13442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36" name="TextBox 35"/>
              <p:cNvSpPr txBox="1"/>
              <p:nvPr/>
            </p:nvSpPr>
            <p:spPr>
              <a:xfrm flipH="1">
                <a:off x="5429019" y="4745061"/>
                <a:ext cx="3435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*</a:t>
                </a:r>
              </a:p>
            </p:txBody>
          </p:sp>
        </p:grpSp>
      </p:grpSp>
      <p:graphicFrame>
        <p:nvGraphicFramePr>
          <p:cNvPr id="19" name="Chart 18"/>
          <p:cNvGraphicFramePr>
            <a:graphicFrameLocks/>
          </p:cNvGraphicFramePr>
          <p:nvPr>
            <p:extLst/>
          </p:nvPr>
        </p:nvGraphicFramePr>
        <p:xfrm>
          <a:off x="4840765" y="3247719"/>
          <a:ext cx="1140359" cy="6632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507037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305487" y="48481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00976" y="139437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04009" y="2268555"/>
            <a:ext cx="171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687732" y="582256"/>
            <a:ext cx="2828696" cy="2743193"/>
            <a:chOff x="6447627" y="72951"/>
            <a:chExt cx="4437168" cy="4303049"/>
          </a:xfrm>
        </p:grpSpPr>
        <p:sp>
          <p:nvSpPr>
            <p:cNvPr id="54" name="TextBox 53"/>
            <p:cNvSpPr txBox="1"/>
            <p:nvPr/>
          </p:nvSpPr>
          <p:spPr>
            <a:xfrm>
              <a:off x="6654532" y="82823"/>
              <a:ext cx="719655" cy="398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0070C0"/>
                  </a:solidFill>
                </a:rPr>
                <a:t>DAPI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595783" y="81625"/>
              <a:ext cx="1006309" cy="398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00B050"/>
                  </a:solidFill>
                </a:rPr>
                <a:t>INSULIN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8764790" y="72951"/>
              <a:ext cx="915786" cy="398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FF0000"/>
                  </a:solidFill>
                </a:rPr>
                <a:t>CASP-3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9902505" y="76488"/>
              <a:ext cx="933388" cy="398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MERGE</a:t>
              </a:r>
            </a:p>
          </p:txBody>
        </p:sp>
        <p:pic>
          <p:nvPicPr>
            <p:cNvPr id="59" name="Picture 58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188" b="50077"/>
            <a:stretch/>
          </p:blipFill>
          <p:spPr>
            <a:xfrm>
              <a:off x="6452427" y="1749076"/>
              <a:ext cx="1061421" cy="1276574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14000" contrast="3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899" r="54188" b="178"/>
            <a:stretch/>
          </p:blipFill>
          <p:spPr>
            <a:xfrm>
              <a:off x="7555434" y="1736604"/>
              <a:ext cx="1061421" cy="1276574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22" r="-34" b="50077"/>
            <a:stretch/>
          </p:blipFill>
          <p:spPr>
            <a:xfrm>
              <a:off x="8683207" y="1749077"/>
              <a:ext cx="1061421" cy="1276574"/>
            </a:xfrm>
            <a:prstGeom prst="rect">
              <a:avLst/>
            </a:prstGeom>
          </p:spPr>
        </p:pic>
        <p:pic>
          <p:nvPicPr>
            <p:cNvPr id="62" name="Picture 61"/>
            <p:cNvPicPr>
              <a:picLocks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949" t="49899" r="239" b="178"/>
            <a:stretch/>
          </p:blipFill>
          <p:spPr>
            <a:xfrm>
              <a:off x="9810905" y="1736604"/>
              <a:ext cx="1061421" cy="1268132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726" b="50101"/>
            <a:stretch/>
          </p:blipFill>
          <p:spPr>
            <a:xfrm>
              <a:off x="6447627" y="3086958"/>
              <a:ext cx="1061421" cy="1276574"/>
            </a:xfrm>
            <a:prstGeom prst="rect">
              <a:avLst/>
            </a:prstGeom>
          </p:spPr>
        </p:pic>
        <p:pic>
          <p:nvPicPr>
            <p:cNvPr id="64" name="Picture 63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219" r="54726" b="-118"/>
            <a:stretch/>
          </p:blipFill>
          <p:spPr>
            <a:xfrm>
              <a:off x="7552069" y="3093374"/>
              <a:ext cx="1061421" cy="1276574"/>
            </a:xfrm>
            <a:prstGeom prst="rect">
              <a:avLst/>
            </a:prstGeom>
          </p:spPr>
        </p:pic>
        <p:pic>
          <p:nvPicPr>
            <p:cNvPr id="65" name="Picture 64"/>
            <p:cNvPicPr>
              <a:picLocks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26" t="753" r="500" b="49348"/>
            <a:stretch/>
          </p:blipFill>
          <p:spPr>
            <a:xfrm>
              <a:off x="8670735" y="3099426"/>
              <a:ext cx="1061421" cy="1276574"/>
            </a:xfrm>
            <a:prstGeom prst="rect">
              <a:avLst/>
            </a:prstGeom>
          </p:spPr>
        </p:pic>
        <p:pic>
          <p:nvPicPr>
            <p:cNvPr id="66" name="Picture 65"/>
            <p:cNvPicPr>
              <a:picLocks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3000" contras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516" t="49899" r="210" b="202"/>
            <a:stretch/>
          </p:blipFill>
          <p:spPr>
            <a:xfrm>
              <a:off x="9799440" y="3087452"/>
              <a:ext cx="1061421" cy="1276575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243" b="50286"/>
            <a:stretch/>
          </p:blipFill>
          <p:spPr>
            <a:xfrm>
              <a:off x="6454117" y="401873"/>
              <a:ext cx="1061421" cy="1276574"/>
            </a:xfrm>
            <a:prstGeom prst="rect">
              <a:avLst/>
            </a:prstGeom>
          </p:spPr>
        </p:pic>
        <p:pic>
          <p:nvPicPr>
            <p:cNvPr id="71" name="Picture 70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08" t="191" r="-165" b="50095"/>
            <a:stretch/>
          </p:blipFill>
          <p:spPr>
            <a:xfrm>
              <a:off x="8697357" y="406850"/>
              <a:ext cx="1061421" cy="1276574"/>
            </a:xfrm>
            <a:prstGeom prst="rect">
              <a:avLst/>
            </a:prstGeom>
          </p:spPr>
        </p:pic>
        <p:pic>
          <p:nvPicPr>
            <p:cNvPr id="72" name="Picture 71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667" r="54243" b="-381"/>
            <a:stretch/>
          </p:blipFill>
          <p:spPr>
            <a:xfrm>
              <a:off x="7578821" y="406848"/>
              <a:ext cx="1061421" cy="1276574"/>
            </a:xfrm>
            <a:prstGeom prst="rect">
              <a:avLst/>
            </a:prstGeom>
          </p:spPr>
        </p:pic>
        <p:pic>
          <p:nvPicPr>
            <p:cNvPr id="73" name="Picture 72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19" t="50042" r="1024" b="244"/>
            <a:stretch/>
          </p:blipFill>
          <p:spPr>
            <a:xfrm>
              <a:off x="9823374" y="401873"/>
              <a:ext cx="1061421" cy="1276574"/>
            </a:xfrm>
            <a:prstGeom prst="rect">
              <a:avLst/>
            </a:prstGeom>
          </p:spPr>
        </p:pic>
        <p:grpSp>
          <p:nvGrpSpPr>
            <p:cNvPr id="27" name="Group 26"/>
            <p:cNvGrpSpPr/>
            <p:nvPr/>
          </p:nvGrpSpPr>
          <p:grpSpPr>
            <a:xfrm>
              <a:off x="9750312" y="1382583"/>
              <a:ext cx="533580" cy="267946"/>
              <a:chOff x="6568506" y="988783"/>
              <a:chExt cx="533580" cy="267946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6568506" y="988783"/>
                <a:ext cx="533580" cy="267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10" dirty="0">
                    <a:solidFill>
                      <a:schemeClr val="bg1"/>
                    </a:solidFill>
                  </a:rPr>
                  <a:t>40µm</a:t>
                </a:r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6720274" y="1169968"/>
                <a:ext cx="131453" cy="2362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 78"/>
            <p:cNvGrpSpPr/>
            <p:nvPr/>
          </p:nvGrpSpPr>
          <p:grpSpPr>
            <a:xfrm>
              <a:off x="9739955" y="2738267"/>
              <a:ext cx="533580" cy="267946"/>
              <a:chOff x="6568507" y="1101031"/>
              <a:chExt cx="533580" cy="267946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6568507" y="1101031"/>
                <a:ext cx="533580" cy="267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10" dirty="0">
                    <a:solidFill>
                      <a:schemeClr val="bg1"/>
                    </a:solidFill>
                  </a:rPr>
                  <a:t>40µm</a:t>
                </a: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6720275" y="1282218"/>
                <a:ext cx="131453" cy="2362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 81"/>
            <p:cNvGrpSpPr/>
            <p:nvPr/>
          </p:nvGrpSpPr>
          <p:grpSpPr>
            <a:xfrm>
              <a:off x="9752432" y="4050629"/>
              <a:ext cx="533580" cy="267946"/>
              <a:chOff x="6580985" y="1150933"/>
              <a:chExt cx="533580" cy="267946"/>
            </a:xfrm>
          </p:grpSpPr>
          <p:sp>
            <p:nvSpPr>
              <p:cNvPr id="83" name="TextBox 82"/>
              <p:cNvSpPr txBox="1"/>
              <p:nvPr/>
            </p:nvSpPr>
            <p:spPr>
              <a:xfrm>
                <a:off x="6580985" y="1150933"/>
                <a:ext cx="533580" cy="267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10" dirty="0">
                    <a:solidFill>
                      <a:schemeClr val="bg1"/>
                    </a:solidFill>
                  </a:rPr>
                  <a:t>40µm</a:t>
                </a:r>
              </a:p>
            </p:txBody>
          </p:sp>
          <p:cxnSp>
            <p:nvCxnSpPr>
              <p:cNvPr id="84" name="Straight Connector 83"/>
              <p:cNvCxnSpPr/>
              <p:nvPr/>
            </p:nvCxnSpPr>
            <p:spPr>
              <a:xfrm>
                <a:off x="6732753" y="1332118"/>
                <a:ext cx="131453" cy="2362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" name="Group 21"/>
          <p:cNvGrpSpPr/>
          <p:nvPr/>
        </p:nvGrpSpPr>
        <p:grpSpPr>
          <a:xfrm>
            <a:off x="300976" y="3627678"/>
            <a:ext cx="2406952" cy="2021901"/>
            <a:chOff x="3993848" y="584511"/>
            <a:chExt cx="2406952" cy="2021901"/>
          </a:xfrm>
        </p:grpSpPr>
        <p:sp>
          <p:nvSpPr>
            <p:cNvPr id="46" name="TextBox 45"/>
            <p:cNvSpPr txBox="1"/>
            <p:nvPr/>
          </p:nvSpPr>
          <p:spPr>
            <a:xfrm>
              <a:off x="3993848" y="584511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xmlns="" id="{8B26F87A-B862-8F40-AFD9-7E42D1549A5F}"/>
                </a:ext>
              </a:extLst>
            </p:cNvPr>
            <p:cNvGrpSpPr/>
            <p:nvPr/>
          </p:nvGrpSpPr>
          <p:grpSpPr>
            <a:xfrm>
              <a:off x="4172401" y="762000"/>
              <a:ext cx="2228399" cy="1844412"/>
              <a:chOff x="4115770" y="5405380"/>
              <a:chExt cx="2228399" cy="1844412"/>
            </a:xfrm>
          </p:grpSpPr>
          <p:graphicFrame>
            <p:nvGraphicFramePr>
              <p:cNvPr id="87" name="Chart 86"/>
              <p:cNvGraphicFramePr>
                <a:graphicFrameLocks/>
              </p:cNvGraphicFramePr>
              <p:nvPr>
                <p:extLst/>
              </p:nvPr>
            </p:nvGraphicFramePr>
            <p:xfrm>
              <a:off x="4532859" y="5532045"/>
              <a:ext cx="1811310" cy="171774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8"/>
              </a:graphicData>
            </a:graphic>
          </p:graphicFrame>
          <p:sp>
            <p:nvSpPr>
              <p:cNvPr id="86" name="TextBox 85"/>
              <p:cNvSpPr txBox="1"/>
              <p:nvPr/>
            </p:nvSpPr>
            <p:spPr>
              <a:xfrm>
                <a:off x="5628380" y="5435209"/>
                <a:ext cx="3577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*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3706978" y="5814172"/>
                <a:ext cx="134080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/>
                  <a:t>% of CASP-3</a:t>
                </a:r>
                <a:r>
                  <a:rPr lang="en-US" sz="1050" b="1" baseline="30000" dirty="0"/>
                  <a:t>+ </a:t>
                </a:r>
                <a:r>
                  <a:rPr lang="en-US" sz="1050" b="1" dirty="0"/>
                  <a:t>Insulin</a:t>
                </a:r>
                <a:r>
                  <a:rPr lang="en-US" sz="1050" b="1" baseline="30000" dirty="0"/>
                  <a:t>+ </a:t>
                </a:r>
                <a:r>
                  <a:rPr lang="en-US" sz="1050" b="1" dirty="0"/>
                  <a:t>/Insulin</a:t>
                </a:r>
                <a:r>
                  <a:rPr lang="en-US" sz="1050" b="1" baseline="30000" dirty="0"/>
                  <a:t> + </a:t>
                </a:r>
                <a:r>
                  <a:rPr lang="en-US" sz="1050" b="1" dirty="0"/>
                  <a:t>Cells</a:t>
                </a:r>
              </a:p>
              <a:p>
                <a:pPr algn="ctr"/>
                <a:endParaRPr lang="en-US" sz="1050" b="1" baseline="30000" dirty="0"/>
              </a:p>
            </p:txBody>
          </p:sp>
          <p:grpSp>
            <p:nvGrpSpPr>
              <p:cNvPr id="93" name="Group 92"/>
              <p:cNvGrpSpPr/>
              <p:nvPr/>
            </p:nvGrpSpPr>
            <p:grpSpPr>
              <a:xfrm>
                <a:off x="5548128" y="5618250"/>
                <a:ext cx="508276" cy="69471"/>
                <a:chOff x="5789330" y="3884304"/>
                <a:chExt cx="651183" cy="106891"/>
              </a:xfrm>
            </p:grpSpPr>
            <p:cxnSp>
              <p:nvCxnSpPr>
                <p:cNvPr id="94" name="Straight Connector 93"/>
                <p:cNvCxnSpPr/>
                <p:nvPr/>
              </p:nvCxnSpPr>
              <p:spPr>
                <a:xfrm>
                  <a:off x="5796195" y="3899765"/>
                  <a:ext cx="64431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Connector 94"/>
                <p:cNvCxnSpPr/>
                <p:nvPr/>
              </p:nvCxnSpPr>
              <p:spPr>
                <a:xfrm>
                  <a:off x="6439559" y="3884304"/>
                  <a:ext cx="0" cy="10520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Connector 95"/>
                <p:cNvCxnSpPr/>
                <p:nvPr/>
              </p:nvCxnSpPr>
              <p:spPr>
                <a:xfrm>
                  <a:off x="5789330" y="3885984"/>
                  <a:ext cx="0" cy="10521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DF4C1C33-15FF-6B44-B165-0D317E36CDE2}"/>
              </a:ext>
            </a:extLst>
          </p:cNvPr>
          <p:cNvSpPr txBox="1"/>
          <p:nvPr/>
        </p:nvSpPr>
        <p:spPr>
          <a:xfrm rot="16200000">
            <a:off x="123409" y="2708527"/>
            <a:ext cx="860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kita-STF 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1562FBB9-E654-7948-B081-4CE86510D331}"/>
              </a:ext>
            </a:extLst>
          </p:cNvPr>
          <p:cNvSpPr txBox="1"/>
          <p:nvPr/>
        </p:nvSpPr>
        <p:spPr>
          <a:xfrm rot="16200000">
            <a:off x="112497" y="1845457"/>
            <a:ext cx="8853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</a:rPr>
              <a:t>Akita</a:t>
            </a:r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-Vehicle</a:t>
            </a: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E2313393-6F45-F047-A16E-FA0FA147AD4E}"/>
              </a:ext>
            </a:extLst>
          </p:cNvPr>
          <p:cNvSpPr txBox="1"/>
          <p:nvPr/>
        </p:nvSpPr>
        <p:spPr>
          <a:xfrm rot="16200000">
            <a:off x="280773" y="880294"/>
            <a:ext cx="567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T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82462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864726" y="1640858"/>
            <a:ext cx="11385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kita-Vehicle</a:t>
            </a:r>
          </a:p>
        </p:txBody>
      </p:sp>
      <p:sp>
        <p:nvSpPr>
          <p:cNvPr id="3" name="TextBox 2"/>
          <p:cNvSpPr txBox="1"/>
          <p:nvPr/>
        </p:nvSpPr>
        <p:spPr>
          <a:xfrm rot="16200000">
            <a:off x="946001" y="3057738"/>
            <a:ext cx="862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kita-STF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81200" y="762000"/>
            <a:ext cx="518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DAPI</a:t>
            </a:r>
            <a:r>
              <a:rPr lang="en-US" dirty="0"/>
              <a:t>                </a:t>
            </a:r>
            <a:r>
              <a:rPr lang="en-US" dirty="0" smtClean="0"/>
              <a:t>  </a:t>
            </a:r>
            <a:r>
              <a:rPr lang="en-US" dirty="0" smtClean="0">
                <a:solidFill>
                  <a:srgbClr val="00B050"/>
                </a:solidFill>
              </a:rPr>
              <a:t>Insulin</a:t>
            </a:r>
            <a:r>
              <a:rPr lang="en-US" dirty="0" smtClean="0"/>
              <a:t>                  </a:t>
            </a:r>
            <a:r>
              <a:rPr lang="en-US" dirty="0" smtClean="0">
                <a:solidFill>
                  <a:srgbClr val="C00000"/>
                </a:solidFill>
              </a:rPr>
              <a:t>Ki67                  </a:t>
            </a:r>
            <a:r>
              <a:rPr lang="en-US" dirty="0" smtClean="0"/>
              <a:t>Merge</a:t>
            </a:r>
            <a:endParaRPr lang="en-US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886545"/>
              </p:ext>
            </p:extLst>
          </p:nvPr>
        </p:nvGraphicFramePr>
        <p:xfrm>
          <a:off x="2209800" y="4183384"/>
          <a:ext cx="208987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876274" y="5068573"/>
            <a:ext cx="18660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% Ki67</a:t>
            </a:r>
            <a:r>
              <a:rPr lang="en-US" sz="1400" baseline="30000" dirty="0" smtClean="0"/>
              <a:t>+</a:t>
            </a:r>
            <a:r>
              <a:rPr lang="en-US" sz="1400" dirty="0" smtClean="0"/>
              <a:t> insulin</a:t>
            </a:r>
            <a:r>
              <a:rPr lang="en-US" sz="1400" baseline="30000" dirty="0" smtClean="0"/>
              <a:t>+</a:t>
            </a:r>
            <a:r>
              <a:rPr lang="en-US" sz="1400" dirty="0" smtClean="0"/>
              <a:t>/ insulin</a:t>
            </a:r>
            <a:r>
              <a:rPr lang="en-US" sz="1400" baseline="30000" dirty="0" smtClean="0"/>
              <a:t>+</a:t>
            </a:r>
            <a:r>
              <a:rPr lang="en-US" sz="1400" dirty="0" smtClean="0"/>
              <a:t> cells</a:t>
            </a:r>
            <a:endParaRPr lang="en-US" sz="14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1662" b="51918"/>
          <a:stretch/>
        </p:blipFill>
        <p:spPr>
          <a:xfrm>
            <a:off x="1580961" y="1131333"/>
            <a:ext cx="1385724" cy="132682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1831" b="50286"/>
          <a:stretch/>
        </p:blipFill>
        <p:spPr>
          <a:xfrm>
            <a:off x="1580961" y="2543249"/>
            <a:ext cx="1390747" cy="133675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55" r="-193" b="51918"/>
          <a:stretch/>
        </p:blipFill>
        <p:spPr>
          <a:xfrm>
            <a:off x="3071306" y="1131333"/>
            <a:ext cx="1385724" cy="132682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8" t="51889" r="61940" b="29"/>
          <a:stretch/>
        </p:blipFill>
        <p:spPr>
          <a:xfrm>
            <a:off x="4561651" y="1131333"/>
            <a:ext cx="1385724" cy="132682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150000"/>
                    </a14:imgEffect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716" t="52071" r="-54" b="-153"/>
          <a:stretch/>
        </p:blipFill>
        <p:spPr>
          <a:xfrm>
            <a:off x="6051996" y="1131333"/>
            <a:ext cx="1385724" cy="132682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148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636" r="195" b="50286"/>
          <a:stretch/>
        </p:blipFill>
        <p:spPr>
          <a:xfrm>
            <a:off x="3071306" y="2543249"/>
            <a:ext cx="1390747" cy="133675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" t="50262" r="61969" b="24"/>
          <a:stretch/>
        </p:blipFill>
        <p:spPr>
          <a:xfrm>
            <a:off x="4561651" y="2543249"/>
            <a:ext cx="1390747" cy="133675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912" t="50636" r="-81" b="-350"/>
          <a:stretch/>
        </p:blipFill>
        <p:spPr>
          <a:xfrm>
            <a:off x="6051996" y="2543249"/>
            <a:ext cx="1390747" cy="133675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961367" y="8077200"/>
            <a:ext cx="2029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  <a:r>
              <a:rPr lang="en-US" dirty="0" smtClean="0"/>
              <a:t>Fig. 4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109889" y="6858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/>
              <a:t>A</a:t>
            </a:r>
            <a:endParaRPr lang="en-US" b="1"/>
          </a:p>
        </p:txBody>
      </p:sp>
      <p:sp>
        <p:nvSpPr>
          <p:cNvPr id="17" name="TextBox 16"/>
          <p:cNvSpPr txBox="1"/>
          <p:nvPr/>
        </p:nvSpPr>
        <p:spPr>
          <a:xfrm>
            <a:off x="989829" y="411851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00400" y="4257010"/>
            <a:ext cx="3113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S</a:t>
            </a:r>
            <a:endParaRPr lang="en-US" sz="900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3125506" y="4450099"/>
            <a:ext cx="5029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627679" y="4440051"/>
            <a:ext cx="0" cy="6837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120148" y="4441143"/>
            <a:ext cx="0" cy="683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839133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99C1B41E-716E-5340-A34A-7567F3A8820E}"/>
              </a:ext>
            </a:extLst>
          </p:cNvPr>
          <p:cNvGrpSpPr/>
          <p:nvPr/>
        </p:nvGrpSpPr>
        <p:grpSpPr>
          <a:xfrm>
            <a:off x="3424619" y="1310562"/>
            <a:ext cx="1601054" cy="1520881"/>
            <a:chOff x="-208709" y="6157511"/>
            <a:chExt cx="1601054" cy="1520881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48660B6D-A44B-F643-9C9D-954475326ED5}"/>
                </a:ext>
              </a:extLst>
            </p:cNvPr>
            <p:cNvSpPr txBox="1"/>
            <p:nvPr/>
          </p:nvSpPr>
          <p:spPr>
            <a:xfrm rot="16200000">
              <a:off x="-592261" y="6812178"/>
              <a:ext cx="1321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9BD77E1E-0ED7-8A48-B26A-AEB7B77D9D13}"/>
                </a:ext>
              </a:extLst>
            </p:cNvPr>
            <p:cNvGrpSpPr/>
            <p:nvPr/>
          </p:nvGrpSpPr>
          <p:grpSpPr>
            <a:xfrm>
              <a:off x="190184" y="6230827"/>
              <a:ext cx="1202161" cy="1447565"/>
              <a:chOff x="522252" y="2474273"/>
              <a:chExt cx="2438616" cy="2255890"/>
            </a:xfrm>
          </p:grpSpPr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xmlns="" id="{954E4574-D224-8F43-9E30-0C093B5330F1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522252" y="2474273"/>
              <a:ext cx="2438616" cy="22558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xmlns="" id="{554EC838-0AB4-AE41-90D9-9C9B75CDABEE}"/>
                  </a:ext>
                </a:extLst>
              </p:cNvPr>
              <p:cNvSpPr txBox="1"/>
              <p:nvPr/>
            </p:nvSpPr>
            <p:spPr>
              <a:xfrm>
                <a:off x="1591237" y="2590229"/>
                <a:ext cx="833096" cy="4191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P21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6B676CB1-A72E-2447-BC56-207F18191607}"/>
                </a:ext>
              </a:extLst>
            </p:cNvPr>
            <p:cNvSpPr txBox="1"/>
            <p:nvPr/>
          </p:nvSpPr>
          <p:spPr>
            <a:xfrm>
              <a:off x="-208709" y="6157511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105DDF83-DC97-4E42-B306-12BEA743A548}"/>
                </a:ext>
              </a:extLst>
            </p:cNvPr>
            <p:cNvSpPr txBox="1"/>
            <p:nvPr/>
          </p:nvSpPr>
          <p:spPr>
            <a:xfrm>
              <a:off x="1073746" y="6951190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C72BD014-0D1D-5043-BF42-9D7BA6E3BCB0}"/>
              </a:ext>
            </a:extLst>
          </p:cNvPr>
          <p:cNvGrpSpPr/>
          <p:nvPr/>
        </p:nvGrpSpPr>
        <p:grpSpPr>
          <a:xfrm>
            <a:off x="4897551" y="1269689"/>
            <a:ext cx="1641798" cy="1551058"/>
            <a:chOff x="4803370" y="5129929"/>
            <a:chExt cx="1641798" cy="1551058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xmlns="" id="{41C025EF-B733-7D4A-AADB-77F45EDB6989}"/>
                </a:ext>
              </a:extLst>
            </p:cNvPr>
            <p:cNvGrpSpPr/>
            <p:nvPr/>
          </p:nvGrpSpPr>
          <p:grpSpPr>
            <a:xfrm>
              <a:off x="4984652" y="5224687"/>
              <a:ext cx="1460516" cy="1456300"/>
              <a:chOff x="2880844" y="5202442"/>
              <a:chExt cx="1460516" cy="1456300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xmlns="" id="{7DD1DBD4-C075-8E46-B650-BDC825873908}"/>
                  </a:ext>
                </a:extLst>
              </p:cNvPr>
              <p:cNvGrpSpPr/>
              <p:nvPr/>
            </p:nvGrpSpPr>
            <p:grpSpPr>
              <a:xfrm>
                <a:off x="2880844" y="5202442"/>
                <a:ext cx="1460516" cy="1456300"/>
                <a:chOff x="2916505" y="5263832"/>
                <a:chExt cx="1460516" cy="1456300"/>
              </a:xfrm>
            </p:grpSpPr>
            <p:graphicFrame>
              <p:nvGraphicFramePr>
                <p:cNvPr id="14" name="Chart 13">
                  <a:extLst>
                    <a:ext uri="{FF2B5EF4-FFF2-40B4-BE49-F238E27FC236}">
                      <a16:creationId xmlns:a16="http://schemas.microsoft.com/office/drawing/2014/main" xmlns="" id="{AE4C2F1E-ED74-0B41-B084-E82EE3755D44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3166162" y="5337975"/>
                <a:ext cx="1210859" cy="138215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xmlns="" id="{6DA75DE5-AE9A-C94F-A6B4-6A65536082EE}"/>
                    </a:ext>
                  </a:extLst>
                </p:cNvPr>
                <p:cNvSpPr txBox="1"/>
                <p:nvPr/>
              </p:nvSpPr>
              <p:spPr>
                <a:xfrm rot="16200000">
                  <a:off x="2378749" y="5801588"/>
                  <a:ext cx="132173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mRNA (fold change)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xmlns="" id="{933B678A-C54F-1340-91A4-3DEE02AAD39C}"/>
                    </a:ext>
                  </a:extLst>
                </p:cNvPr>
                <p:cNvSpPr txBox="1"/>
                <p:nvPr/>
              </p:nvSpPr>
              <p:spPr>
                <a:xfrm>
                  <a:off x="4061352" y="5846059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xmlns="" id="{44EA8994-AA79-864E-83A1-F0A23FEC836E}"/>
                  </a:ext>
                </a:extLst>
              </p:cNvPr>
              <p:cNvSpPr txBox="1"/>
              <p:nvPr/>
            </p:nvSpPr>
            <p:spPr>
              <a:xfrm>
                <a:off x="3660268" y="5236830"/>
                <a:ext cx="412292" cy="2689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p53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AF2F59C6-A367-D24D-9B8C-83BDE44FC44E}"/>
                </a:ext>
              </a:extLst>
            </p:cNvPr>
            <p:cNvSpPr txBox="1"/>
            <p:nvPr/>
          </p:nvSpPr>
          <p:spPr>
            <a:xfrm>
              <a:off x="4803370" y="5129929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BDFD7A20-1139-4B41-BD86-55E65EAACC6C}"/>
              </a:ext>
            </a:extLst>
          </p:cNvPr>
          <p:cNvGrpSpPr/>
          <p:nvPr/>
        </p:nvGrpSpPr>
        <p:grpSpPr>
          <a:xfrm>
            <a:off x="385118" y="1276969"/>
            <a:ext cx="1542377" cy="1578328"/>
            <a:chOff x="430241" y="5185899"/>
            <a:chExt cx="1542377" cy="1578328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xmlns="" id="{91A774CD-08CD-DD46-9287-E743EC9DB439}"/>
                </a:ext>
              </a:extLst>
            </p:cNvPr>
            <p:cNvGrpSpPr/>
            <p:nvPr/>
          </p:nvGrpSpPr>
          <p:grpSpPr>
            <a:xfrm>
              <a:off x="530388" y="5320990"/>
              <a:ext cx="1442230" cy="1443237"/>
              <a:chOff x="3992486" y="5239355"/>
              <a:chExt cx="1442230" cy="1443237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xmlns="" id="{8A175522-2F39-A548-A69F-580E52011359}"/>
                  </a:ext>
                </a:extLst>
              </p:cNvPr>
              <p:cNvGrpSpPr/>
              <p:nvPr/>
            </p:nvGrpSpPr>
            <p:grpSpPr>
              <a:xfrm>
                <a:off x="4226517" y="5239355"/>
                <a:ext cx="1208199" cy="1443237"/>
                <a:chOff x="820592" y="4353340"/>
                <a:chExt cx="2450860" cy="1980959"/>
              </a:xfrm>
            </p:grpSpPr>
            <p:graphicFrame>
              <p:nvGraphicFramePr>
                <p:cNvPr id="23" name="Chart 22">
                  <a:extLst>
                    <a:ext uri="{FF2B5EF4-FFF2-40B4-BE49-F238E27FC236}">
                      <a16:creationId xmlns:a16="http://schemas.microsoft.com/office/drawing/2014/main" xmlns="" id="{160C7B96-7C9D-5844-9FCC-DA403046D000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820592" y="4353340"/>
                <a:ext cx="2450860" cy="198095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xmlns="" id="{C5E64357-76F4-A749-A113-8CCEC6D875B5}"/>
                    </a:ext>
                  </a:extLst>
                </p:cNvPr>
                <p:cNvSpPr txBox="1"/>
                <p:nvPr/>
              </p:nvSpPr>
              <p:spPr>
                <a:xfrm>
                  <a:off x="2004996" y="4396509"/>
                  <a:ext cx="865612" cy="3692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BAX</a:t>
                  </a:r>
                </a:p>
              </p:txBody>
            </p:sp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A9440E76-27A5-9841-A3FD-CA26EB3FEDE8}"/>
                  </a:ext>
                </a:extLst>
              </p:cNvPr>
              <p:cNvSpPr txBox="1"/>
              <p:nvPr/>
            </p:nvSpPr>
            <p:spPr>
              <a:xfrm rot="16200000">
                <a:off x="3454730" y="5781714"/>
                <a:ext cx="13217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mRNA (fold change)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xmlns="" id="{E6CB93ED-A0CB-2346-B0E5-75D63F8F70F6}"/>
                  </a:ext>
                </a:extLst>
              </p:cNvPr>
              <p:cNvSpPr txBox="1"/>
              <p:nvPr/>
            </p:nvSpPr>
            <p:spPr>
              <a:xfrm>
                <a:off x="5098784" y="5875709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0D389E85-387E-DA4C-B54B-9E9380450FB0}"/>
                </a:ext>
              </a:extLst>
            </p:cNvPr>
            <p:cNvSpPr txBox="1"/>
            <p:nvPr/>
          </p:nvSpPr>
          <p:spPr>
            <a:xfrm>
              <a:off x="430241" y="518589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xmlns="" id="{CE681C55-5BD8-C349-B0B1-C3EB55CDA808}"/>
              </a:ext>
            </a:extLst>
          </p:cNvPr>
          <p:cNvGrpSpPr/>
          <p:nvPr/>
        </p:nvGrpSpPr>
        <p:grpSpPr>
          <a:xfrm>
            <a:off x="1905000" y="1295400"/>
            <a:ext cx="1554925" cy="1560365"/>
            <a:chOff x="1767244" y="5093014"/>
            <a:chExt cx="1554925" cy="1560365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xmlns="" id="{2C332A07-4727-5147-BA2C-CCBDF2D9699B}"/>
                </a:ext>
              </a:extLst>
            </p:cNvPr>
            <p:cNvGrpSpPr/>
            <p:nvPr/>
          </p:nvGrpSpPr>
          <p:grpSpPr>
            <a:xfrm>
              <a:off x="1897877" y="5230452"/>
              <a:ext cx="1424292" cy="1422927"/>
              <a:chOff x="6003439" y="5259008"/>
              <a:chExt cx="1424292" cy="1422927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xmlns="" id="{EAFC17B6-7651-F446-B788-06CDA57198B5}"/>
                  </a:ext>
                </a:extLst>
              </p:cNvPr>
              <p:cNvGrpSpPr/>
              <p:nvPr/>
            </p:nvGrpSpPr>
            <p:grpSpPr>
              <a:xfrm>
                <a:off x="6246656" y="5286904"/>
                <a:ext cx="1181075" cy="1395031"/>
                <a:chOff x="7981374" y="2350468"/>
                <a:chExt cx="2395842" cy="2174024"/>
              </a:xfrm>
            </p:grpSpPr>
            <p:graphicFrame>
              <p:nvGraphicFramePr>
                <p:cNvPr id="31" name="Chart 30">
                  <a:extLst>
                    <a:ext uri="{FF2B5EF4-FFF2-40B4-BE49-F238E27FC236}">
                      <a16:creationId xmlns:a16="http://schemas.microsoft.com/office/drawing/2014/main" xmlns="" id="{D1488D95-A59A-A344-B7B4-B4F567A73A07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7981374" y="2483858"/>
                <a:ext cx="2395842" cy="204063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xmlns="" id="{F3648CB0-040D-A149-A25A-8872F5C6B978}"/>
                    </a:ext>
                  </a:extLst>
                </p:cNvPr>
                <p:cNvSpPr txBox="1"/>
                <p:nvPr/>
              </p:nvSpPr>
              <p:spPr>
                <a:xfrm>
                  <a:off x="9036794" y="2350468"/>
                  <a:ext cx="969668" cy="4191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Bak1</a:t>
                  </a:r>
                </a:p>
              </p:txBody>
            </p: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xmlns="" id="{8923939A-90CF-EF41-922C-016415538D00}"/>
                  </a:ext>
                </a:extLst>
              </p:cNvPr>
              <p:cNvSpPr txBox="1"/>
              <p:nvPr/>
            </p:nvSpPr>
            <p:spPr>
              <a:xfrm rot="16200000">
                <a:off x="5465683" y="5796764"/>
                <a:ext cx="13217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mRNA (fold change)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xmlns="" id="{D77B93B5-F7A7-6840-8AB9-FB34E8BD7CB5}"/>
                  </a:ext>
                </a:extLst>
              </p:cNvPr>
              <p:cNvSpPr txBox="1"/>
              <p:nvPr/>
            </p:nvSpPr>
            <p:spPr>
              <a:xfrm>
                <a:off x="7097377" y="5903981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2D9A0FE6-E339-B249-B876-07B9EEACBE3D}"/>
                </a:ext>
              </a:extLst>
            </p:cNvPr>
            <p:cNvSpPr txBox="1"/>
            <p:nvPr/>
          </p:nvSpPr>
          <p:spPr>
            <a:xfrm>
              <a:off x="1767244" y="5093014"/>
              <a:ext cx="2856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</p:grp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4869049"/>
              </p:ext>
            </p:extLst>
          </p:nvPr>
        </p:nvGraphicFramePr>
        <p:xfrm>
          <a:off x="6273023" y="1035161"/>
          <a:ext cx="1140359" cy="6632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4" name="TextBox 33"/>
          <p:cNvSpPr txBox="1"/>
          <p:nvPr/>
        </p:nvSpPr>
        <p:spPr>
          <a:xfrm>
            <a:off x="4961367" y="8077200"/>
            <a:ext cx="2029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  <a:r>
              <a:rPr lang="en-US" dirty="0" smtClean="0"/>
              <a:t>Fig.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39803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23952" y="2895600"/>
            <a:ext cx="3358884" cy="2522706"/>
            <a:chOff x="1589281" y="3774993"/>
            <a:chExt cx="2986586" cy="2743200"/>
          </a:xfrm>
        </p:grpSpPr>
        <p:grpSp>
          <p:nvGrpSpPr>
            <p:cNvPr id="3" name="Group 2"/>
            <p:cNvGrpSpPr/>
            <p:nvPr/>
          </p:nvGrpSpPr>
          <p:grpSpPr>
            <a:xfrm>
              <a:off x="1589281" y="3940713"/>
              <a:ext cx="556286" cy="2068288"/>
              <a:chOff x="6614005" y="1060803"/>
              <a:chExt cx="914400" cy="2502858"/>
            </a:xfrm>
          </p:grpSpPr>
          <p:sp>
            <p:nvSpPr>
              <p:cNvPr id="6" name="TextBox 1"/>
              <p:cNvSpPr txBox="1"/>
              <p:nvPr/>
            </p:nvSpPr>
            <p:spPr>
              <a:xfrm>
                <a:off x="6614005" y="3266743"/>
                <a:ext cx="914400" cy="296918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b="1" dirty="0"/>
                  <a:t>D</a:t>
                </a:r>
                <a:r>
                  <a:rPr lang="en-US" sz="1200" b="1" dirty="0" smtClean="0"/>
                  <a:t>ays</a:t>
                </a:r>
                <a:endParaRPr lang="en-US" sz="1200" b="1" dirty="0"/>
              </a:p>
            </p:txBody>
          </p:sp>
          <p:sp>
            <p:nvSpPr>
              <p:cNvPr id="7" name="TextBox 1"/>
              <p:cNvSpPr txBox="1"/>
              <p:nvPr/>
            </p:nvSpPr>
            <p:spPr>
              <a:xfrm rot="16200000">
                <a:off x="5832098" y="1883608"/>
                <a:ext cx="1931359" cy="285749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b="1" dirty="0"/>
                  <a:t>Body Weight (grams)</a:t>
                </a:r>
              </a:p>
            </p:txBody>
          </p:sp>
        </p:grpSp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4728445"/>
                </p:ext>
              </p:extLst>
            </p:nvPr>
          </p:nvGraphicFramePr>
          <p:xfrm>
            <a:off x="1883604" y="3774993"/>
            <a:ext cx="269226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27946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2340602" y="3514334"/>
          <a:ext cx="2130426" cy="25789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7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 rot="16200000">
            <a:off x="1105347" y="4457254"/>
            <a:ext cx="190857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smtClean="0"/>
              <a:t>Pancreatic Insulin </a:t>
            </a:r>
            <a:r>
              <a:rPr lang="en-US" sz="1200" b="1" dirty="0" smtClean="0"/>
              <a:t>Content </a:t>
            </a:r>
            <a:r>
              <a:rPr lang="en-US" sz="1200" b="1" dirty="0"/>
              <a:t>(ng/mg  pancreas tissue)</a:t>
            </a:r>
          </a:p>
        </p:txBody>
      </p:sp>
    </p:spTree>
    <p:extLst>
      <p:ext uri="{BB962C8B-B14F-4D97-AF65-F5344CB8AC3E}">
        <p14:creationId xmlns:p14="http://schemas.microsoft.com/office/powerpoint/2010/main" val="18418322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6C31FE3D-0F14-8740-B8BC-AF9755AFB141}"/>
              </a:ext>
            </a:extLst>
          </p:cNvPr>
          <p:cNvGrpSpPr/>
          <p:nvPr/>
        </p:nvGrpSpPr>
        <p:grpSpPr>
          <a:xfrm>
            <a:off x="4061234" y="4419600"/>
            <a:ext cx="1730410" cy="1607876"/>
            <a:chOff x="291566" y="853896"/>
            <a:chExt cx="1730410" cy="1607876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6CE392CF-E165-9742-BB55-AF7499C4FAF6}"/>
                </a:ext>
              </a:extLst>
            </p:cNvPr>
            <p:cNvSpPr txBox="1"/>
            <p:nvPr/>
          </p:nvSpPr>
          <p:spPr>
            <a:xfrm rot="16200000">
              <a:off x="-209853" y="1507212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xmlns="" id="{EB024547-2853-064B-A1C5-1416E6F57F5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6331845"/>
                </p:ext>
              </p:extLst>
            </p:nvPr>
          </p:nvGraphicFramePr>
          <p:xfrm>
            <a:off x="562361" y="853896"/>
            <a:ext cx="1459615" cy="16078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4CEBB43B-7C82-DE45-8AE7-0C083B3B47D9}"/>
                </a:ext>
              </a:extLst>
            </p:cNvPr>
            <p:cNvSpPr txBox="1"/>
            <p:nvPr/>
          </p:nvSpPr>
          <p:spPr>
            <a:xfrm>
              <a:off x="1640532" y="1234896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xmlns="" id="{F027B63C-A093-7142-BDAB-861278EACAA6}"/>
              </a:ext>
            </a:extLst>
          </p:cNvPr>
          <p:cNvGrpSpPr/>
          <p:nvPr/>
        </p:nvGrpSpPr>
        <p:grpSpPr>
          <a:xfrm>
            <a:off x="422419" y="705302"/>
            <a:ext cx="1672084" cy="1635441"/>
            <a:chOff x="-14369" y="2644630"/>
            <a:chExt cx="1672084" cy="1635441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63D92C17-76B3-E749-B7EB-60EB03C50B0B}"/>
                </a:ext>
              </a:extLst>
            </p:cNvPr>
            <p:cNvSpPr txBox="1"/>
            <p:nvPr/>
          </p:nvSpPr>
          <p:spPr>
            <a:xfrm rot="16200000">
              <a:off x="-515788" y="3298926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20" name="Chart 19">
              <a:extLst>
                <a:ext uri="{FF2B5EF4-FFF2-40B4-BE49-F238E27FC236}">
                  <a16:creationId xmlns:a16="http://schemas.microsoft.com/office/drawing/2014/main" xmlns="" id="{F324DF30-C1FB-0246-A654-2691557C325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4255793"/>
                </p:ext>
              </p:extLst>
            </p:nvPr>
          </p:nvGraphicFramePr>
          <p:xfrm>
            <a:off x="246269" y="2681488"/>
            <a:ext cx="1411446" cy="15985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1" name="TextBox 1">
              <a:extLst>
                <a:ext uri="{FF2B5EF4-FFF2-40B4-BE49-F238E27FC236}">
                  <a16:creationId xmlns:a16="http://schemas.microsoft.com/office/drawing/2014/main" xmlns="" id="{008A7370-B441-8A48-906D-8176E0B09578}"/>
                </a:ext>
              </a:extLst>
            </p:cNvPr>
            <p:cNvSpPr txBox="1"/>
            <p:nvPr/>
          </p:nvSpPr>
          <p:spPr>
            <a:xfrm>
              <a:off x="829585" y="2644630"/>
              <a:ext cx="407050" cy="220537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XBP1-t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xmlns="" id="{63D0AD3B-1528-7E4C-A62D-D2DB57FA297C}"/>
              </a:ext>
            </a:extLst>
          </p:cNvPr>
          <p:cNvGrpSpPr/>
          <p:nvPr/>
        </p:nvGrpSpPr>
        <p:grpSpPr>
          <a:xfrm>
            <a:off x="2162181" y="2514600"/>
            <a:ext cx="1740324" cy="1596241"/>
            <a:chOff x="3383652" y="2708240"/>
            <a:chExt cx="1740324" cy="1596241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55B37A01-E6B3-0749-A436-C9E9B45933E5}"/>
                </a:ext>
              </a:extLst>
            </p:cNvPr>
            <p:cNvSpPr txBox="1"/>
            <p:nvPr/>
          </p:nvSpPr>
          <p:spPr>
            <a:xfrm rot="16200000">
              <a:off x="2882233" y="3335874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24" name="Chart 23">
              <a:extLst>
                <a:ext uri="{FF2B5EF4-FFF2-40B4-BE49-F238E27FC236}">
                  <a16:creationId xmlns:a16="http://schemas.microsoft.com/office/drawing/2014/main" xmlns="" id="{60C4BA00-E8F1-AE40-B2C8-A4D04E353D8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3700483"/>
                </p:ext>
              </p:extLst>
            </p:nvPr>
          </p:nvGraphicFramePr>
          <p:xfrm>
            <a:off x="3636978" y="2876186"/>
            <a:ext cx="1486998" cy="14282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5" name="TextBox 1">
              <a:extLst>
                <a:ext uri="{FF2B5EF4-FFF2-40B4-BE49-F238E27FC236}">
                  <a16:creationId xmlns:a16="http://schemas.microsoft.com/office/drawing/2014/main" xmlns="" id="{6D903513-1D2B-824F-8C17-95BB72FCFBEE}"/>
                </a:ext>
              </a:extLst>
            </p:cNvPr>
            <p:cNvSpPr txBox="1"/>
            <p:nvPr/>
          </p:nvSpPr>
          <p:spPr>
            <a:xfrm>
              <a:off x="4315366" y="2708240"/>
              <a:ext cx="508930" cy="257082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Bip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2A6E8BDA-44D5-4047-88EE-E08FA0C23858}"/>
                </a:ext>
              </a:extLst>
            </p:cNvPr>
            <p:cNvSpPr txBox="1"/>
            <p:nvPr/>
          </p:nvSpPr>
          <p:spPr>
            <a:xfrm>
              <a:off x="4684635" y="3472395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**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xmlns="" id="{7F267416-8A58-354C-9EEC-1909CD6A4071}"/>
              </a:ext>
            </a:extLst>
          </p:cNvPr>
          <p:cNvGrpSpPr/>
          <p:nvPr/>
        </p:nvGrpSpPr>
        <p:grpSpPr>
          <a:xfrm>
            <a:off x="4088859" y="2514073"/>
            <a:ext cx="1699936" cy="1572027"/>
            <a:chOff x="2163772" y="5355917"/>
            <a:chExt cx="1699936" cy="1572027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D8F38E9B-663E-4F47-9067-9B158339394E}"/>
                </a:ext>
              </a:extLst>
            </p:cNvPr>
            <p:cNvSpPr txBox="1"/>
            <p:nvPr/>
          </p:nvSpPr>
          <p:spPr>
            <a:xfrm rot="16200000">
              <a:off x="1662353" y="6063803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33" name="Chart 32">
              <a:extLst>
                <a:ext uri="{FF2B5EF4-FFF2-40B4-BE49-F238E27FC236}">
                  <a16:creationId xmlns:a16="http://schemas.microsoft.com/office/drawing/2014/main" xmlns="" id="{2B6717B6-68F4-0443-98C5-BC2894AE9CE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34078012"/>
                </p:ext>
              </p:extLst>
            </p:nvPr>
          </p:nvGraphicFramePr>
          <p:xfrm>
            <a:off x="2402722" y="5626759"/>
            <a:ext cx="1460986" cy="13011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6" name="TextBox 1">
              <a:extLst>
                <a:ext uri="{FF2B5EF4-FFF2-40B4-BE49-F238E27FC236}">
                  <a16:creationId xmlns:a16="http://schemas.microsoft.com/office/drawing/2014/main" xmlns="" id="{21C1A04A-5BA0-0040-B97D-C80B46271FF6}"/>
                </a:ext>
              </a:extLst>
            </p:cNvPr>
            <p:cNvSpPr txBox="1"/>
            <p:nvPr/>
          </p:nvSpPr>
          <p:spPr>
            <a:xfrm>
              <a:off x="3092830" y="5355917"/>
              <a:ext cx="363108" cy="33978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P58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77017A5C-631A-4C45-944B-F52A28241422}"/>
                </a:ext>
              </a:extLst>
            </p:cNvPr>
            <p:cNvSpPr txBox="1"/>
            <p:nvPr/>
          </p:nvSpPr>
          <p:spPr>
            <a:xfrm>
              <a:off x="3471339" y="5984568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xmlns="" id="{00D88E7A-2B9D-D34A-BF20-415DD3ACBE16}"/>
              </a:ext>
            </a:extLst>
          </p:cNvPr>
          <p:cNvGrpSpPr/>
          <p:nvPr/>
        </p:nvGrpSpPr>
        <p:grpSpPr>
          <a:xfrm>
            <a:off x="297042" y="2630564"/>
            <a:ext cx="1707633" cy="1483784"/>
            <a:chOff x="400708" y="5464968"/>
            <a:chExt cx="1707633" cy="1483784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F7CBBAAE-1C82-A742-B6E1-1AF4422EA8E8}"/>
                </a:ext>
              </a:extLst>
            </p:cNvPr>
            <p:cNvSpPr txBox="1"/>
            <p:nvPr/>
          </p:nvSpPr>
          <p:spPr>
            <a:xfrm rot="16200000">
              <a:off x="-100711" y="6086728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32" name="Chart 31">
              <a:extLst>
                <a:ext uri="{FF2B5EF4-FFF2-40B4-BE49-F238E27FC236}">
                  <a16:creationId xmlns:a16="http://schemas.microsoft.com/office/drawing/2014/main" xmlns="" id="{7EFAA52A-F478-6E4D-9C42-5DAF8B22F7B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05190770"/>
                </p:ext>
              </p:extLst>
            </p:nvPr>
          </p:nvGraphicFramePr>
          <p:xfrm>
            <a:off x="647355" y="5536679"/>
            <a:ext cx="1460986" cy="14120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5" name="TextBox 1">
              <a:extLst>
                <a:ext uri="{FF2B5EF4-FFF2-40B4-BE49-F238E27FC236}">
                  <a16:creationId xmlns:a16="http://schemas.microsoft.com/office/drawing/2014/main" xmlns="" id="{8C2C79DE-BB2A-7446-96B5-D4C016A53DF1}"/>
                </a:ext>
              </a:extLst>
            </p:cNvPr>
            <p:cNvSpPr txBox="1"/>
            <p:nvPr/>
          </p:nvSpPr>
          <p:spPr>
            <a:xfrm>
              <a:off x="1290583" y="5464968"/>
              <a:ext cx="422231" cy="3102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GRP94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6B0AE78A-D496-C34B-AF73-8B07186AF09F}"/>
                </a:ext>
              </a:extLst>
            </p:cNvPr>
            <p:cNvSpPr txBox="1"/>
            <p:nvPr/>
          </p:nvSpPr>
          <p:spPr>
            <a:xfrm>
              <a:off x="1703866" y="5839468"/>
              <a:ext cx="1788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xmlns="" id="{8146ED32-910D-3C46-923F-6E1C66ABC275}"/>
              </a:ext>
            </a:extLst>
          </p:cNvPr>
          <p:cNvGrpSpPr/>
          <p:nvPr/>
        </p:nvGrpSpPr>
        <p:grpSpPr>
          <a:xfrm>
            <a:off x="413263" y="6526632"/>
            <a:ext cx="1721837" cy="1522630"/>
            <a:chOff x="3852320" y="5139051"/>
            <a:chExt cx="1721837" cy="1780116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0F8C00A3-2ACB-1043-98F6-D51B8000D6CE}"/>
                </a:ext>
              </a:extLst>
            </p:cNvPr>
            <p:cNvSpPr txBox="1"/>
            <p:nvPr/>
          </p:nvSpPr>
          <p:spPr>
            <a:xfrm rot="16200000">
              <a:off x="3350901" y="5950247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34" name="Chart 33">
              <a:extLst>
                <a:ext uri="{FF2B5EF4-FFF2-40B4-BE49-F238E27FC236}">
                  <a16:creationId xmlns:a16="http://schemas.microsoft.com/office/drawing/2014/main" xmlns="" id="{07569AED-D5C6-1446-B526-0F214BD6E72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25611861"/>
                </p:ext>
              </p:extLst>
            </p:nvPr>
          </p:nvGraphicFramePr>
          <p:xfrm>
            <a:off x="4113171" y="5278194"/>
            <a:ext cx="1460986" cy="16409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37" name="TextBox 1">
              <a:extLst>
                <a:ext uri="{FF2B5EF4-FFF2-40B4-BE49-F238E27FC236}">
                  <a16:creationId xmlns:a16="http://schemas.microsoft.com/office/drawing/2014/main" xmlns="" id="{8254C570-24E0-804E-99EA-3798F9097E58}"/>
                </a:ext>
              </a:extLst>
            </p:cNvPr>
            <p:cNvSpPr txBox="1"/>
            <p:nvPr/>
          </p:nvSpPr>
          <p:spPr>
            <a:xfrm>
              <a:off x="4723733" y="5139051"/>
              <a:ext cx="508930" cy="257082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ATF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7210722E-D8A0-7841-B2F2-FAEF9D52EF3D}"/>
                </a:ext>
              </a:extLst>
            </p:cNvPr>
            <p:cNvSpPr txBox="1"/>
            <p:nvPr/>
          </p:nvSpPr>
          <p:spPr>
            <a:xfrm>
              <a:off x="5165635" y="617279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*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xmlns="" id="{C43909D1-BDD6-B641-B4BF-87B7D0A00260}"/>
              </a:ext>
            </a:extLst>
          </p:cNvPr>
          <p:cNvGrpSpPr/>
          <p:nvPr/>
        </p:nvGrpSpPr>
        <p:grpSpPr>
          <a:xfrm>
            <a:off x="2194423" y="6480578"/>
            <a:ext cx="1704108" cy="1572428"/>
            <a:chOff x="5649789" y="5319506"/>
            <a:chExt cx="1704108" cy="1572428"/>
          </a:xfrm>
        </p:grpSpPr>
        <p:graphicFrame>
          <p:nvGraphicFramePr>
            <p:cNvPr id="38" name="Chart 37">
              <a:extLst>
                <a:ext uri="{FF2B5EF4-FFF2-40B4-BE49-F238E27FC236}">
                  <a16:creationId xmlns:a16="http://schemas.microsoft.com/office/drawing/2014/main" xmlns="" id="{6E6F1CA6-EA1C-7C45-B25F-6FCB9943117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82834758"/>
                </p:ext>
              </p:extLst>
            </p:nvPr>
          </p:nvGraphicFramePr>
          <p:xfrm>
            <a:off x="5889126" y="5444218"/>
            <a:ext cx="1464771" cy="1447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98FFBE3A-DB88-A242-B30A-2C0D81C8D96B}"/>
                </a:ext>
              </a:extLst>
            </p:cNvPr>
            <p:cNvSpPr txBox="1"/>
            <p:nvPr/>
          </p:nvSpPr>
          <p:spPr>
            <a:xfrm rot="16200000">
              <a:off x="5148370" y="6035611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sp>
          <p:nvSpPr>
            <p:cNvPr id="40" name="TextBox 1">
              <a:extLst>
                <a:ext uri="{FF2B5EF4-FFF2-40B4-BE49-F238E27FC236}">
                  <a16:creationId xmlns:a16="http://schemas.microsoft.com/office/drawing/2014/main" xmlns="" id="{254F7CEA-B993-FD42-BB33-E3FA99C6AE35}"/>
                </a:ext>
              </a:extLst>
            </p:cNvPr>
            <p:cNvSpPr txBox="1"/>
            <p:nvPr/>
          </p:nvSpPr>
          <p:spPr>
            <a:xfrm>
              <a:off x="6444595" y="5319506"/>
              <a:ext cx="508930" cy="257082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>
                  <a:solidFill>
                    <a:schemeClr val="tx1"/>
                  </a:solidFill>
                </a:rPr>
                <a:t>CHOP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95F6573B-C942-E440-82DC-5E5D37F32CCD}"/>
                </a:ext>
              </a:extLst>
            </p:cNvPr>
            <p:cNvSpPr txBox="1"/>
            <p:nvPr/>
          </p:nvSpPr>
          <p:spPr>
            <a:xfrm>
              <a:off x="6969427" y="5971488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xmlns="" id="{F3FBEAC7-165B-524F-91E2-ADE801820723}"/>
              </a:ext>
            </a:extLst>
          </p:cNvPr>
          <p:cNvGrpSpPr/>
          <p:nvPr/>
        </p:nvGrpSpPr>
        <p:grpSpPr>
          <a:xfrm>
            <a:off x="2314866" y="609600"/>
            <a:ext cx="1799934" cy="1634780"/>
            <a:chOff x="1669206" y="2612649"/>
            <a:chExt cx="1799934" cy="1634780"/>
          </a:xfrm>
        </p:grpSpPr>
        <p:graphicFrame>
          <p:nvGraphicFramePr>
            <p:cNvPr id="50" name="Chart 49">
              <a:extLst>
                <a:ext uri="{FF2B5EF4-FFF2-40B4-BE49-F238E27FC236}">
                  <a16:creationId xmlns:a16="http://schemas.microsoft.com/office/drawing/2014/main" xmlns="" id="{D0BDC392-BF08-E54E-A5B0-10FCDAD8831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0795357"/>
                </p:ext>
              </p:extLst>
            </p:nvPr>
          </p:nvGraphicFramePr>
          <p:xfrm>
            <a:off x="1896117" y="2749913"/>
            <a:ext cx="1573023" cy="14975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xmlns="" id="{53B220A2-2767-2540-A3E9-BD1329434515}"/>
                </a:ext>
              </a:extLst>
            </p:cNvPr>
            <p:cNvGrpSpPr/>
            <p:nvPr/>
          </p:nvGrpSpPr>
          <p:grpSpPr>
            <a:xfrm>
              <a:off x="1669206" y="2612649"/>
              <a:ext cx="1642816" cy="1451746"/>
              <a:chOff x="1687822" y="2603617"/>
              <a:chExt cx="1642816" cy="1451746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xmlns="" id="{1FB103F1-EC54-8C4E-84D9-30458CC56581}"/>
                  </a:ext>
                </a:extLst>
              </p:cNvPr>
              <p:cNvSpPr txBox="1"/>
              <p:nvPr/>
            </p:nvSpPr>
            <p:spPr>
              <a:xfrm rot="16200000">
                <a:off x="1186403" y="3307722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mRNA (fold change)</a:t>
                </a:r>
              </a:p>
            </p:txBody>
          </p:sp>
          <p:sp>
            <p:nvSpPr>
              <p:cNvPr id="54" name="TextBox 1">
                <a:extLst>
                  <a:ext uri="{FF2B5EF4-FFF2-40B4-BE49-F238E27FC236}">
                    <a16:creationId xmlns:a16="http://schemas.microsoft.com/office/drawing/2014/main" xmlns="" id="{753930A6-05C7-AA41-A4C8-A96E2D90506C}"/>
                  </a:ext>
                </a:extLst>
              </p:cNvPr>
              <p:cNvSpPr txBox="1"/>
              <p:nvPr/>
            </p:nvSpPr>
            <p:spPr>
              <a:xfrm>
                <a:off x="2609029" y="2603617"/>
                <a:ext cx="407050" cy="220537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b="1" dirty="0">
                    <a:solidFill>
                      <a:schemeClr val="tx1"/>
                    </a:solidFill>
                  </a:rPr>
                  <a:t>XBP1-s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xmlns="" id="{05273909-54A8-2944-AB22-8E3C45D6C538}"/>
                  </a:ext>
                </a:extLst>
              </p:cNvPr>
              <p:cNvSpPr txBox="1"/>
              <p:nvPr/>
            </p:nvSpPr>
            <p:spPr>
              <a:xfrm>
                <a:off x="3030556" y="3559321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</p:grpSp>
      </p:grpSp>
      <p:graphicFrame>
        <p:nvGraphicFramePr>
          <p:cNvPr id="59" name="Chart 58">
            <a:extLst>
              <a:ext uri="{FF2B5EF4-FFF2-40B4-BE49-F238E27FC236}">
                <a16:creationId xmlns:a16="http://schemas.microsoft.com/office/drawing/2014/main" xmlns="" id="{35DBDAA3-C87B-8741-8C1F-489A292222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9639941"/>
              </p:ext>
            </p:extLst>
          </p:nvPr>
        </p:nvGraphicFramePr>
        <p:xfrm>
          <a:off x="5643112" y="917441"/>
          <a:ext cx="1530988" cy="694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pSp>
        <p:nvGrpSpPr>
          <p:cNvPr id="66" name="Group 65">
            <a:extLst>
              <a:ext uri="{FF2B5EF4-FFF2-40B4-BE49-F238E27FC236}">
                <a16:creationId xmlns:a16="http://schemas.microsoft.com/office/drawing/2014/main" xmlns="" id="{0F9C63EE-2076-124D-8593-3AD18A0CA8AD}"/>
              </a:ext>
            </a:extLst>
          </p:cNvPr>
          <p:cNvGrpSpPr/>
          <p:nvPr/>
        </p:nvGrpSpPr>
        <p:grpSpPr>
          <a:xfrm>
            <a:off x="279279" y="4498824"/>
            <a:ext cx="1735370" cy="1616397"/>
            <a:chOff x="1205900" y="7250002"/>
            <a:chExt cx="1735370" cy="1616397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xmlns="" id="{ABA0C4F7-4486-E747-A563-0671625D4A5D}"/>
                </a:ext>
              </a:extLst>
            </p:cNvPr>
            <p:cNvSpPr txBox="1"/>
            <p:nvPr/>
          </p:nvSpPr>
          <p:spPr>
            <a:xfrm rot="16200000">
              <a:off x="704481" y="7929743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  <p:graphicFrame>
          <p:nvGraphicFramePr>
            <p:cNvPr id="60" name="Chart 59">
              <a:extLst>
                <a:ext uri="{FF2B5EF4-FFF2-40B4-BE49-F238E27FC236}">
                  <a16:creationId xmlns:a16="http://schemas.microsoft.com/office/drawing/2014/main" xmlns="" id="{56F66424-01D0-0244-B5DE-45B78030708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6866446"/>
                </p:ext>
              </p:extLst>
            </p:nvPr>
          </p:nvGraphicFramePr>
          <p:xfrm>
            <a:off x="1452121" y="7312701"/>
            <a:ext cx="1489149" cy="15536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62" name="TextBox 1">
              <a:extLst>
                <a:ext uri="{FF2B5EF4-FFF2-40B4-BE49-F238E27FC236}">
                  <a16:creationId xmlns:a16="http://schemas.microsoft.com/office/drawing/2014/main" xmlns="" id="{F2BA7746-9704-B34D-9362-2E2719F7EA76}"/>
                </a:ext>
              </a:extLst>
            </p:cNvPr>
            <p:cNvSpPr txBox="1"/>
            <p:nvPr/>
          </p:nvSpPr>
          <p:spPr>
            <a:xfrm>
              <a:off x="2103379" y="7250002"/>
              <a:ext cx="508928" cy="257081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/>
                <a:t>Blos1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CC9F6A55-6904-CE43-AF9A-26B36A9CBF0C}"/>
                </a:ext>
              </a:extLst>
            </p:cNvPr>
            <p:cNvSpPr txBox="1"/>
            <p:nvPr/>
          </p:nvSpPr>
          <p:spPr>
            <a:xfrm>
              <a:off x="2525478" y="7875799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**</a:t>
              </a: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xmlns="" id="{C0513C8F-8578-FD49-9A34-7E9C6E9E99D9}"/>
              </a:ext>
            </a:extLst>
          </p:cNvPr>
          <p:cNvGrpSpPr/>
          <p:nvPr/>
        </p:nvGrpSpPr>
        <p:grpSpPr>
          <a:xfrm>
            <a:off x="2194423" y="4419600"/>
            <a:ext cx="1706318" cy="1634010"/>
            <a:chOff x="3180238" y="7226322"/>
            <a:chExt cx="1706318" cy="1634010"/>
          </a:xfrm>
        </p:grpSpPr>
        <p:graphicFrame>
          <p:nvGraphicFramePr>
            <p:cNvPr id="61" name="Chart 60">
              <a:extLst>
                <a:ext uri="{FF2B5EF4-FFF2-40B4-BE49-F238E27FC236}">
                  <a16:creationId xmlns:a16="http://schemas.microsoft.com/office/drawing/2014/main" xmlns="" id="{65B9232B-4AFE-AB40-862B-F524CD8907A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1887055"/>
                </p:ext>
              </p:extLst>
            </p:nvPr>
          </p:nvGraphicFramePr>
          <p:xfrm>
            <a:off x="3392887" y="7297251"/>
            <a:ext cx="1493669" cy="15630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63" name="TextBox 1">
              <a:extLst>
                <a:ext uri="{FF2B5EF4-FFF2-40B4-BE49-F238E27FC236}">
                  <a16:creationId xmlns:a16="http://schemas.microsoft.com/office/drawing/2014/main" xmlns="" id="{3F7A2FC7-DEC4-F04B-BC76-6735FB5C9CB4}"/>
                </a:ext>
              </a:extLst>
            </p:cNvPr>
            <p:cNvSpPr txBox="1"/>
            <p:nvPr/>
          </p:nvSpPr>
          <p:spPr>
            <a:xfrm>
              <a:off x="3983391" y="7226322"/>
              <a:ext cx="508928" cy="257081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/>
                <a:t>Col6a1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EF07968-C68B-D841-A6BA-120E0FCFD25F}"/>
                </a:ext>
              </a:extLst>
            </p:cNvPr>
            <p:cNvSpPr txBox="1"/>
            <p:nvPr/>
          </p:nvSpPr>
          <p:spPr>
            <a:xfrm>
              <a:off x="4472798" y="753112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**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1A8857FA-D8F7-CE4D-9D07-52496D2034A0}"/>
                </a:ext>
              </a:extLst>
            </p:cNvPr>
            <p:cNvSpPr txBox="1"/>
            <p:nvPr/>
          </p:nvSpPr>
          <p:spPr>
            <a:xfrm rot="16200000">
              <a:off x="2678819" y="7929093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mRNA (fold change)</a:t>
              </a: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DE4629DD-420F-E045-829C-21545769359C}"/>
              </a:ext>
            </a:extLst>
          </p:cNvPr>
          <p:cNvSpPr txBox="1"/>
          <p:nvPr/>
        </p:nvSpPr>
        <p:spPr>
          <a:xfrm>
            <a:off x="5181600" y="9364493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S8</a:t>
            </a:r>
            <a:endParaRPr lang="en-US" dirty="0"/>
          </a:p>
        </p:txBody>
      </p:sp>
      <p:sp>
        <p:nvSpPr>
          <p:cNvPr id="71" name="TextBox 70"/>
          <p:cNvSpPr txBox="1"/>
          <p:nvPr/>
        </p:nvSpPr>
        <p:spPr>
          <a:xfrm>
            <a:off x="374971" y="45720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209800" y="455711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248162" y="2385328"/>
            <a:ext cx="171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2093584" y="2376190"/>
            <a:ext cx="171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4038600" y="2362200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283737" y="4300366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</a:t>
            </a:r>
            <a:endParaRPr lang="en-US" sz="14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2102482" y="4301284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038600" y="4183009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264773" y="6322585"/>
            <a:ext cx="2327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I</a:t>
            </a:r>
            <a:endParaRPr lang="en-US" sz="14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2248054" y="635674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J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15805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12775" y="1709738"/>
          <a:ext cx="6546288" cy="663891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7451"/>
                <a:gridCol w="1202852"/>
                <a:gridCol w="2367150"/>
                <a:gridCol w="2428835"/>
              </a:tblGrid>
              <a:tr h="174979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</a:tr>
              <a:tr h="20585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ene nam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orward primer (5'-3'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everse primer (5'-3"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NS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GGTGGGCATCCAGTAAC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AAAGCCTGGGTGGGTTT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NS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CAGAAGCGTGGCATTGT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GGTAGTGGTGGGTCTAGT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af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AGGAGGAGGTCATCCGA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TCCAGAATGTGCCGCT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dx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TTCCCGAATGGAACCG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CCGCTGTGTAAGCACCT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euroD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CCAGGGTTATGAGATCG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TCTGTCCAGCTTGGGGG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100" u="none" strike="noStrike">
                          <a:effectLst/>
                        </a:rPr>
                        <a:t>Nkx6.1</a:t>
                      </a:r>
                      <a:endParaRPr lang="hr-HR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AGCACGCTTGGCCTATTC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TTGGTCCTGCGGTTC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XBP1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CAGACTGCTCGAGATAG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CAAGGCCGTGAGTTTT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Xbp1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AG TCC GCA GCA GGT 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G TCA GAG TCC ATG G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i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GTGTGAGACCAGAACCG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AGTCAGGCAGGAGTCTT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p58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ATTACTCGCAGCCGGAC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CGCTGCTTTGGATTTTC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</a:rPr>
                        <a:t>Grp9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GAAACACACTAGGTCGTG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TGTCTTGCTACTCCACAC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HO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AGCGACAGAGCCAGAAT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AGGTGAAAGGCAGGGAC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F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ATAAAGGCTTGCGGCC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GGATTTCGTGAAGAGC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de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TGGAATTTGGGATTCTGAG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CTGCAGTCCAGGGAAGAA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ctr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los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AGGAGCTGCAGGAGAA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GGAGGGTGAAGTAAGA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l6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CTCAACATGAAGCAGA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GAGGGAGAAAGCTCTG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Il6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TTCACAAGTCGGAGG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GCAAGTGCATCATCGTTG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C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GTCCCTGTCATGCTTC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TCCAGCCTACTCATTGG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N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GAACTTCGGGGTGATC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ACGACGTGGGCTACA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l1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CCACCTTTTGACAGTGA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ATGTGCTGCTGCGAGA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>
                          <a:effectLst/>
                        </a:rPr>
                        <a:t>Cd68</a:t>
                      </a:r>
                      <a:endParaRPr lang="it-IT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TTCAGCTCCAAGCCCAA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ACCGTCACAACCTCCCT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CP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ACCTCAAAGCAGCCTCC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GGCCTTGAAACCAACCA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px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TGTCGCGTCTCTCTGAG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GCCATTCTGGTGTCCGA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mox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GGCGTCACTTCGTCAGA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GATCTGGGGTTTCCCT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od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GAACCATCCACTTCGAGC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CATGCTGGCCTTCAGTT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GGATTCCTGAGAGAGTG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TGGAGAATCGAACGGCA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</a:rPr>
                        <a:t>P2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AAGGACGTCCCACTTTGC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ACAACGGCACACTTTGCT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TCAGGCCCTCATCCTCC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CGACTGTGACTCCTCCAT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A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GGATCCAAGACCAGGGT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GAGGACTCCAGCCACAA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ak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TCACCAAGATCGCCTCCA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CGCTGGTAGACGTACA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XBP1-tot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ACGCTTGGGAATGGACAC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TGGGAAGATGTTCTGGG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</a:tr>
              <a:tr h="19556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Calibri" charset="0"/>
                      </a:endParaRPr>
                    </a:p>
                  </a:txBody>
                  <a:tcPr marL="5146" marR="5146" marT="514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5146" marR="5146" marT="5146" marB="0" anchor="b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953000" y="9296400"/>
            <a:ext cx="2199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Tabl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4081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434</TotalTime>
  <Words>382</Words>
  <Application>Microsoft Macintosh PowerPoint</Application>
  <PresentationFormat>Custom</PresentationFormat>
  <Paragraphs>218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m, Hui-Ying   (HSC)</dc:creator>
  <cp:lastModifiedBy>Microsoft Office User</cp:lastModifiedBy>
  <cp:revision>133</cp:revision>
  <dcterms:created xsi:type="dcterms:W3CDTF">2019-12-10T20:46:58Z</dcterms:created>
  <dcterms:modified xsi:type="dcterms:W3CDTF">2021-07-02T22:00:40Z</dcterms:modified>
</cp:coreProperties>
</file>